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53CC96F-F5CD-4CD7-9A8B-A080E07C3848}" type="doc">
      <dgm:prSet loTypeId="urn:microsoft.com/office/officeart/2005/8/layout/orgChart1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US"/>
        </a:p>
      </dgm:t>
    </dgm:pt>
    <dgm:pt modelId="{F808247F-F6E3-4E79-A5A7-DE8208B86ACD}">
      <dgm:prSet phldrT="[Text]" custT="1"/>
      <dgm:spPr>
        <a:xfrm>
          <a:off x="2804140" y="4393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&lt;33 wks</a:t>
          </a:r>
        </a:p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Apneic/bradycardic in DR</a:t>
          </a:r>
        </a:p>
      </dgm:t>
    </dgm:pt>
    <dgm:pt modelId="{252BE950-B822-4B9D-A3E9-DB486DD8DECA}" type="parTrans" cxnId="{13AB8DD5-AF23-4515-8EAA-07BDEB1D0A2B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18FF0AB-97A8-4BCA-9DE6-E3B9F68A4CED}" type="sibTrans" cxnId="{13AB8DD5-AF23-4515-8EAA-07BDEB1D0A2B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9DC9CB9-7965-4D84-91D7-7C42156429A0}">
      <dgm:prSet phldrT="[Text]" custT="1"/>
      <dgm:spPr>
        <a:xfrm>
          <a:off x="2804140" y="1002070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Resuscitate per NRP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a</a:t>
          </a:r>
        </a:p>
      </dgm:t>
    </dgm:pt>
    <dgm:pt modelId="{4119D5D0-FA31-42FF-A231-507BEE5A608E}" type="parTrans" cxnId="{C4657CEA-6FDD-4543-8793-E6A1A3557979}">
      <dgm:prSet/>
      <dgm:spPr>
        <a:xfrm>
          <a:off x="3461009" y="706982"/>
          <a:ext cx="91440" cy="29508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5F7BA69-3C02-4FB3-83E6-623BD132BD0D}" type="sibTrans" cxnId="{C4657CEA-6FDD-4543-8793-E6A1A355797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A30CB21-77AD-41A6-BF0D-312514452664}">
      <dgm:prSet phldrT="[Text]" custT="1"/>
      <dgm:spPr>
        <a:xfrm>
          <a:off x="4251161" y="1999746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f recovers, start bCPAP if &lt;30 wks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</a:t>
          </a:r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or any respiratory distress</a:t>
          </a:r>
        </a:p>
      </dgm:t>
    </dgm:pt>
    <dgm:pt modelId="{B972437C-EAD4-4207-9AAF-A33382C18D19}" type="parTrans" cxnId="{E4D35F9A-595F-43DF-8416-E5BA7CAC1C47}">
      <dgm:prSet/>
      <dgm:spPr>
        <a:xfrm>
          <a:off x="3506729" y="1704659"/>
          <a:ext cx="1447021" cy="29508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7543"/>
              </a:lnTo>
              <a:lnTo>
                <a:pt x="1447021" y="147543"/>
              </a:lnTo>
              <a:lnTo>
                <a:pt x="1447021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9EF5737-679B-470A-8D6A-255DAF4BCABE}" type="sibTrans" cxnId="{E4D35F9A-595F-43DF-8416-E5BA7CAC1C47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8F86D0B-B8C5-4F43-8FF8-341B478AF084}">
      <dgm:prSet phldrT="[Text]" custT="1"/>
      <dgm:spPr>
        <a:xfrm>
          <a:off x="1357118" y="1999746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tubate if necessary for resuscitation and give surfactant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</a:t>
          </a:r>
        </a:p>
      </dgm:t>
    </dgm:pt>
    <dgm:pt modelId="{E57B3E8B-EF92-4033-9F29-D892F5F49888}" type="parTrans" cxnId="{4ED750A1-C52E-44BC-BAED-009705379624}">
      <dgm:prSet/>
      <dgm:spPr>
        <a:xfrm>
          <a:off x="2059708" y="1704659"/>
          <a:ext cx="1447021" cy="295087"/>
        </a:xfrm>
        <a:custGeom>
          <a:avLst/>
          <a:gdLst/>
          <a:ahLst/>
          <a:cxnLst/>
          <a:rect l="0" t="0" r="0" b="0"/>
          <a:pathLst>
            <a:path>
              <a:moveTo>
                <a:pt x="1447021" y="0"/>
              </a:moveTo>
              <a:lnTo>
                <a:pt x="1447021" y="147543"/>
              </a:lnTo>
              <a:lnTo>
                <a:pt x="0" y="147543"/>
              </a:lnTo>
              <a:lnTo>
                <a:pt x="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D5CFC8C-2483-415D-835F-53953BD02E6A}" type="sibTrans" cxnId="{4ED750A1-C52E-44BC-BAED-00970537962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BC6F426-A444-4468-8FEF-E158ACD2CF19}">
      <dgm:prSet phldrT="[Text]" custT="1"/>
      <dgm:spPr>
        <a:xfrm>
          <a:off x="3057384" y="2997423"/>
          <a:ext cx="2092465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tubate if subsequently meets criteria and give surfactant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</a:t>
          </a:r>
          <a:r>
            <a:rPr lang="en-US" sz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;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 </a:t>
          </a:r>
          <a:r>
            <a:rPr lang="en-US" sz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on SIMV/VG, HFOV or Jet as needed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</a:t>
          </a:r>
        </a:p>
      </dgm:t>
    </dgm:pt>
    <dgm:pt modelId="{76A48887-9602-46C2-A0E9-ACFA3689B159}" type="parTrans" cxnId="{AC308D7A-59AD-4116-83E1-1542838C21B8}">
      <dgm:prSet/>
      <dgm:spPr>
        <a:xfrm>
          <a:off x="4103617" y="2702336"/>
          <a:ext cx="850133" cy="295087"/>
        </a:xfrm>
        <a:custGeom>
          <a:avLst/>
          <a:gdLst/>
          <a:ahLst/>
          <a:cxnLst/>
          <a:rect l="0" t="0" r="0" b="0"/>
          <a:pathLst>
            <a:path>
              <a:moveTo>
                <a:pt x="850133" y="0"/>
              </a:moveTo>
              <a:lnTo>
                <a:pt x="850133" y="147543"/>
              </a:lnTo>
              <a:lnTo>
                <a:pt x="0" y="147543"/>
              </a:lnTo>
              <a:lnTo>
                <a:pt x="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DDAB486-369B-406F-AC0D-D22840963368}" type="sibTrans" cxnId="{AC308D7A-59AD-4116-83E1-1542838C21B8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E77B31C-81E9-4872-8E76-6644BA2DEB2A}">
      <dgm:prSet phldrT="[Text]" custT="1"/>
      <dgm:spPr>
        <a:xfrm>
          <a:off x="5444937" y="2997423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ntinue bCPAP</a:t>
          </a:r>
        </a:p>
      </dgm:t>
    </dgm:pt>
    <dgm:pt modelId="{856C8DA7-FD9C-4165-9FE1-1E2DFDC07F0E}" type="parTrans" cxnId="{D26F03E6-9C2D-400A-9489-19D3E3CA35E8}">
      <dgm:prSet/>
      <dgm:spPr>
        <a:xfrm>
          <a:off x="4953750" y="2702336"/>
          <a:ext cx="1193776" cy="29508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7543"/>
              </a:lnTo>
              <a:lnTo>
                <a:pt x="1193776" y="147543"/>
              </a:lnTo>
              <a:lnTo>
                <a:pt x="1193776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9C7A915-BDED-4B49-AC31-B6679BA758FE}" type="sibTrans" cxnId="{D26F03E6-9C2D-400A-9489-19D3E3CA35E8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74D9C52-21A1-44A2-8D66-A27323094137}">
      <dgm:prSet phldrT="[Text]" custT="1"/>
      <dgm:spPr>
        <a:xfrm>
          <a:off x="3401028" y="3995100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xtubate to bCPAP when meets criteria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</a:t>
          </a:r>
        </a:p>
      </dgm:t>
    </dgm:pt>
    <dgm:pt modelId="{D59F031A-F73A-4E9D-A60D-38AF6CCF2E71}" type="parTrans" cxnId="{5ADE8425-30C2-400D-91C9-E2CEDF8AA45F}">
      <dgm:prSet/>
      <dgm:spPr>
        <a:xfrm>
          <a:off x="4057897" y="3700013"/>
          <a:ext cx="91440" cy="29508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61D46F6-8B72-4B3D-BF90-C73A23D3F0CD}" type="sibTrans" cxnId="{5ADE8425-30C2-400D-91C9-E2CEDF8AA45F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E925BB5-CB04-4666-8302-53B25619A781}">
      <dgm:prSet phldrT="[Text]" custT="1"/>
      <dgm:spPr>
        <a:xfrm>
          <a:off x="3752323" y="4992777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ysClr val="windowText" lastClr="000000">
              <a:shade val="80000"/>
              <a:hueOff val="0"/>
              <a:satOff val="0"/>
              <a:lumOff val="0"/>
            </a:sysClr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gm:t>
    </dgm:pt>
    <dgm:pt modelId="{6FAC539D-24FC-49AD-8761-6D8A674C956B}" type="parTrans" cxnId="{6FBA58E7-037E-4D5B-8726-7C8ED35C5167}">
      <dgm:prSet/>
      <dgm:spPr>
        <a:xfrm>
          <a:off x="3541546" y="4697689"/>
          <a:ext cx="210776" cy="64638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646382"/>
              </a:lnTo>
              <a:lnTo>
                <a:pt x="210776" y="646382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16F5519-476D-4B03-9BEC-DBAB88589330}" type="sibTrans" cxnId="{6FBA58E7-037E-4D5B-8726-7C8ED35C5167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58A2CE7-C7D0-409F-9A7A-65CC9CC90808}">
      <dgm:prSet phldrT="[Text]" custT="1"/>
      <dgm:spPr>
        <a:xfrm>
          <a:off x="5822663" y="4997170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gm:t>
    </dgm:pt>
    <dgm:pt modelId="{5C1DB733-9AA0-41B4-B77E-AF4C0203624A}" type="parTrans" cxnId="{9A1D35C9-2D8D-4B7E-AB36-AE24E3F487B1}">
      <dgm:prSet/>
      <dgm:spPr>
        <a:xfrm>
          <a:off x="5585455" y="3700013"/>
          <a:ext cx="237208" cy="164845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48452"/>
              </a:lnTo>
              <a:lnTo>
                <a:pt x="237208" y="1648452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AE0A713-303F-406C-A279-4E5F68A32EDE}" type="sibTrans" cxnId="{9A1D35C9-2D8D-4B7E-AB36-AE24E3F487B1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EE2C254-E67D-481E-98C7-333814D19837}">
      <dgm:prSet phldrT="[Text]" custT="1"/>
      <dgm:spPr>
        <a:xfrm>
          <a:off x="1357118" y="2997423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on SIMV/VG, HFOV or Jet as needed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</a:t>
          </a:r>
        </a:p>
      </dgm:t>
    </dgm:pt>
    <dgm:pt modelId="{9693903D-BA74-47FE-95DF-D5FB9DFD9ECE}" type="parTrans" cxnId="{AB30378D-9376-45AB-84E8-308F437DA04F}">
      <dgm:prSet/>
      <dgm:spPr>
        <a:xfrm>
          <a:off x="2013988" y="2702336"/>
          <a:ext cx="91440" cy="29508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/>
        </a:p>
      </dgm:t>
    </dgm:pt>
    <dgm:pt modelId="{A9B4FC94-FFBA-46DF-8E13-13548212010E}" type="sibTrans" cxnId="{AB30378D-9376-45AB-84E8-308F437DA04F}">
      <dgm:prSet/>
      <dgm:spPr/>
      <dgm:t>
        <a:bodyPr/>
        <a:lstStyle/>
        <a:p>
          <a:endParaRPr lang="en-US"/>
        </a:p>
      </dgm:t>
    </dgm:pt>
    <dgm:pt modelId="{5D83DFC3-B3FC-47ED-9292-7E54CEDB9AAE}">
      <dgm:prSet phldrT="[Text]" custT="1"/>
      <dgm:spPr>
        <a:xfrm>
          <a:off x="1357118" y="3995100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xtubate to bCPAP when meets criteria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</a:t>
          </a:r>
        </a:p>
      </dgm:t>
    </dgm:pt>
    <dgm:pt modelId="{96AC9455-0640-46A9-B5DE-E851E2EB7CA2}" type="parTrans" cxnId="{65ECB0C7-033F-43EB-91CD-E51414D7371C}">
      <dgm:prSet/>
      <dgm:spPr>
        <a:xfrm>
          <a:off x="2013988" y="3700013"/>
          <a:ext cx="91440" cy="29508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/>
        </a:p>
      </dgm:t>
    </dgm:pt>
    <dgm:pt modelId="{86232F44-3BF9-48D2-8B5B-B6CF6A49F939}" type="sibTrans" cxnId="{65ECB0C7-033F-43EB-91CD-E51414D7371C}">
      <dgm:prSet/>
      <dgm:spPr/>
      <dgm:t>
        <a:bodyPr/>
        <a:lstStyle/>
        <a:p>
          <a:endParaRPr lang="en-US"/>
        </a:p>
      </dgm:t>
    </dgm:pt>
    <dgm:pt modelId="{C2CBD92B-B5BA-4866-A3A6-0C4BC3E17129}">
      <dgm:prSet phldrT="[Text]" custT="1"/>
      <dgm:spPr>
        <a:xfrm>
          <a:off x="1708413" y="4992777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gm:t>
    </dgm:pt>
    <dgm:pt modelId="{C7E61FB8-0216-43C8-ABA2-5728C500D71F}" type="parTrans" cxnId="{B82FC416-5374-46B0-86E4-610D71555597}">
      <dgm:prSet/>
      <dgm:spPr>
        <a:xfrm>
          <a:off x="1497636" y="4697689"/>
          <a:ext cx="210776" cy="64638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646382"/>
              </a:lnTo>
              <a:lnTo>
                <a:pt x="210776" y="646382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/>
        </a:p>
      </dgm:t>
    </dgm:pt>
    <dgm:pt modelId="{BDBDF3A3-64C5-4119-8278-A1C3A0DFCD09}" type="sibTrans" cxnId="{B82FC416-5374-46B0-86E4-610D71555597}">
      <dgm:prSet/>
      <dgm:spPr/>
      <dgm:t>
        <a:bodyPr/>
        <a:lstStyle/>
        <a:p>
          <a:endParaRPr lang="en-US"/>
        </a:p>
      </dgm:t>
    </dgm:pt>
    <dgm:pt modelId="{04C083E7-9597-4EE9-A9C2-3443049DDD13}" type="pres">
      <dgm:prSet presAssocID="{B53CC96F-F5CD-4CD7-9A8B-A080E07C3848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0093C735-6F08-4E25-9698-674EFEE96BEA}" type="pres">
      <dgm:prSet presAssocID="{F808247F-F6E3-4E79-A5A7-DE8208B86ACD}" presName="hierRoot1" presStyleCnt="0">
        <dgm:presLayoutVars>
          <dgm:hierBranch val="init"/>
        </dgm:presLayoutVars>
      </dgm:prSet>
      <dgm:spPr/>
    </dgm:pt>
    <dgm:pt modelId="{5F1B1C9B-F7AE-4CF4-B43C-430BCF5059AA}" type="pres">
      <dgm:prSet presAssocID="{F808247F-F6E3-4E79-A5A7-DE8208B86ACD}" presName="rootComposite1" presStyleCnt="0"/>
      <dgm:spPr/>
    </dgm:pt>
    <dgm:pt modelId="{590AA2EC-F0AB-440F-A9A0-09AA76F5468A}" type="pres">
      <dgm:prSet presAssocID="{F808247F-F6E3-4E79-A5A7-DE8208B86ACD}" presName="rootText1" presStyleLbl="node0" presStyleIdx="0" presStyleCnt="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9838F99-0A43-4565-8EAF-D3629E95E813}" type="pres">
      <dgm:prSet presAssocID="{F808247F-F6E3-4E79-A5A7-DE8208B86ACD}" presName="rootConnector1" presStyleLbl="node1" presStyleIdx="0" presStyleCnt="0"/>
      <dgm:spPr/>
      <dgm:t>
        <a:bodyPr/>
        <a:lstStyle/>
        <a:p>
          <a:endParaRPr lang="en-US"/>
        </a:p>
      </dgm:t>
    </dgm:pt>
    <dgm:pt modelId="{4A29D580-A882-46D9-94D8-B49F217A8B0C}" type="pres">
      <dgm:prSet presAssocID="{F808247F-F6E3-4E79-A5A7-DE8208B86ACD}" presName="hierChild2" presStyleCnt="0"/>
      <dgm:spPr/>
    </dgm:pt>
    <dgm:pt modelId="{0DC54BB8-D923-405C-A452-A0897CF2B5BD}" type="pres">
      <dgm:prSet presAssocID="{4119D5D0-FA31-42FF-A231-507BEE5A608E}" presName="Name37" presStyleLbl="parChTrans1D2" presStyleIdx="0" presStyleCnt="1"/>
      <dgm:spPr/>
      <dgm:t>
        <a:bodyPr/>
        <a:lstStyle/>
        <a:p>
          <a:endParaRPr lang="en-US"/>
        </a:p>
      </dgm:t>
    </dgm:pt>
    <dgm:pt modelId="{2653B149-E122-44B8-9E77-B00E40D15E4B}" type="pres">
      <dgm:prSet presAssocID="{09DC9CB9-7965-4D84-91D7-7C42156429A0}" presName="hierRoot2" presStyleCnt="0">
        <dgm:presLayoutVars>
          <dgm:hierBranch val="init"/>
        </dgm:presLayoutVars>
      </dgm:prSet>
      <dgm:spPr/>
    </dgm:pt>
    <dgm:pt modelId="{CDFD48B5-CF3F-4AE4-A1F2-056434D4EA0B}" type="pres">
      <dgm:prSet presAssocID="{09DC9CB9-7965-4D84-91D7-7C42156429A0}" presName="rootComposite" presStyleCnt="0"/>
      <dgm:spPr/>
    </dgm:pt>
    <dgm:pt modelId="{C7002D31-D535-4545-AB27-DC7B00C0CF02}" type="pres">
      <dgm:prSet presAssocID="{09DC9CB9-7965-4D84-91D7-7C42156429A0}" presName="rootText" presStyleLbl="node2" presStyleIdx="0" presStyleCnt="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4CC7A13-72BD-4A92-BAAD-7CBC2169CC7B}" type="pres">
      <dgm:prSet presAssocID="{09DC9CB9-7965-4D84-91D7-7C42156429A0}" presName="rootConnector" presStyleLbl="node2" presStyleIdx="0" presStyleCnt="1"/>
      <dgm:spPr/>
      <dgm:t>
        <a:bodyPr/>
        <a:lstStyle/>
        <a:p>
          <a:endParaRPr lang="en-US"/>
        </a:p>
      </dgm:t>
    </dgm:pt>
    <dgm:pt modelId="{A8D983F0-6F90-4029-A4AD-5DC404D35E48}" type="pres">
      <dgm:prSet presAssocID="{09DC9CB9-7965-4D84-91D7-7C42156429A0}" presName="hierChild4" presStyleCnt="0"/>
      <dgm:spPr/>
    </dgm:pt>
    <dgm:pt modelId="{176CA4B5-53D5-4A19-882B-CA93D30E2B54}" type="pres">
      <dgm:prSet presAssocID="{E57B3E8B-EF92-4033-9F29-D892F5F49888}" presName="Name37" presStyleLbl="parChTrans1D3" presStyleIdx="0" presStyleCnt="2"/>
      <dgm:spPr/>
      <dgm:t>
        <a:bodyPr/>
        <a:lstStyle/>
        <a:p>
          <a:endParaRPr lang="en-US"/>
        </a:p>
      </dgm:t>
    </dgm:pt>
    <dgm:pt modelId="{118CB755-FE25-49D7-BEB7-208BDD57F82D}" type="pres">
      <dgm:prSet presAssocID="{F8F86D0B-B8C5-4F43-8FF8-341B478AF084}" presName="hierRoot2" presStyleCnt="0">
        <dgm:presLayoutVars>
          <dgm:hierBranch val="init"/>
        </dgm:presLayoutVars>
      </dgm:prSet>
      <dgm:spPr/>
    </dgm:pt>
    <dgm:pt modelId="{B4644DC4-2B7D-4DBB-950A-3FDDF83FAF23}" type="pres">
      <dgm:prSet presAssocID="{F8F86D0B-B8C5-4F43-8FF8-341B478AF084}" presName="rootComposite" presStyleCnt="0"/>
      <dgm:spPr/>
    </dgm:pt>
    <dgm:pt modelId="{B9FBD0DF-1994-4756-9C31-863763F81800}" type="pres">
      <dgm:prSet presAssocID="{F8F86D0B-B8C5-4F43-8FF8-341B478AF084}" presName="rootText" presStyleLbl="node3" presStyleIdx="0" presStyleCnt="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A24AA5B-B2AF-4C93-B25A-71752901D584}" type="pres">
      <dgm:prSet presAssocID="{F8F86D0B-B8C5-4F43-8FF8-341B478AF084}" presName="rootConnector" presStyleLbl="node3" presStyleIdx="0" presStyleCnt="2"/>
      <dgm:spPr/>
      <dgm:t>
        <a:bodyPr/>
        <a:lstStyle/>
        <a:p>
          <a:endParaRPr lang="en-US"/>
        </a:p>
      </dgm:t>
    </dgm:pt>
    <dgm:pt modelId="{BD0DDED8-D924-45AD-A6B2-30DC8C8D05CC}" type="pres">
      <dgm:prSet presAssocID="{F8F86D0B-B8C5-4F43-8FF8-341B478AF084}" presName="hierChild4" presStyleCnt="0"/>
      <dgm:spPr/>
    </dgm:pt>
    <dgm:pt modelId="{B1C87CDF-86FC-43F2-A129-62EAC6215B0C}" type="pres">
      <dgm:prSet presAssocID="{9693903D-BA74-47FE-95DF-D5FB9DFD9ECE}" presName="Name37" presStyleLbl="parChTrans1D4" presStyleIdx="0" presStyleCnt="8"/>
      <dgm:spPr/>
      <dgm:t>
        <a:bodyPr/>
        <a:lstStyle/>
        <a:p>
          <a:endParaRPr lang="en-US"/>
        </a:p>
      </dgm:t>
    </dgm:pt>
    <dgm:pt modelId="{147DA07E-414B-47C2-B858-99013B986170}" type="pres">
      <dgm:prSet presAssocID="{BEE2C254-E67D-481E-98C7-333814D19837}" presName="hierRoot2" presStyleCnt="0">
        <dgm:presLayoutVars>
          <dgm:hierBranch val="init"/>
        </dgm:presLayoutVars>
      </dgm:prSet>
      <dgm:spPr/>
    </dgm:pt>
    <dgm:pt modelId="{F32ED8C1-489F-4360-8FCB-78175DA21F0A}" type="pres">
      <dgm:prSet presAssocID="{BEE2C254-E67D-481E-98C7-333814D19837}" presName="rootComposite" presStyleCnt="0"/>
      <dgm:spPr/>
    </dgm:pt>
    <dgm:pt modelId="{EB2B9AAD-5B70-4168-B7B8-2B6B1B4EBF89}" type="pres">
      <dgm:prSet presAssocID="{BEE2C254-E67D-481E-98C7-333814D19837}" presName="rootText" presStyleLbl="node4" presStyleIdx="0" presStyleCnt="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E6D92E72-A03B-41CC-8590-98AAB73B1DD4}" type="pres">
      <dgm:prSet presAssocID="{BEE2C254-E67D-481E-98C7-333814D19837}" presName="rootConnector" presStyleLbl="node4" presStyleIdx="0" presStyleCnt="8"/>
      <dgm:spPr/>
      <dgm:t>
        <a:bodyPr/>
        <a:lstStyle/>
        <a:p>
          <a:endParaRPr lang="en-US"/>
        </a:p>
      </dgm:t>
    </dgm:pt>
    <dgm:pt modelId="{A2649C4B-4502-46FD-B33E-64AC2F23377A}" type="pres">
      <dgm:prSet presAssocID="{BEE2C254-E67D-481E-98C7-333814D19837}" presName="hierChild4" presStyleCnt="0"/>
      <dgm:spPr/>
    </dgm:pt>
    <dgm:pt modelId="{4932B976-1306-409D-A15E-523C7A699DB3}" type="pres">
      <dgm:prSet presAssocID="{96AC9455-0640-46A9-B5DE-E851E2EB7CA2}" presName="Name37" presStyleLbl="parChTrans1D4" presStyleIdx="1" presStyleCnt="8"/>
      <dgm:spPr/>
      <dgm:t>
        <a:bodyPr/>
        <a:lstStyle/>
        <a:p>
          <a:endParaRPr lang="en-US"/>
        </a:p>
      </dgm:t>
    </dgm:pt>
    <dgm:pt modelId="{C9E9A1BA-73D1-4BAB-813D-0C1391438890}" type="pres">
      <dgm:prSet presAssocID="{5D83DFC3-B3FC-47ED-9292-7E54CEDB9AAE}" presName="hierRoot2" presStyleCnt="0">
        <dgm:presLayoutVars>
          <dgm:hierBranch val="init"/>
        </dgm:presLayoutVars>
      </dgm:prSet>
      <dgm:spPr/>
    </dgm:pt>
    <dgm:pt modelId="{99F92043-F82F-41F2-9B22-C0FE3BB3E589}" type="pres">
      <dgm:prSet presAssocID="{5D83DFC3-B3FC-47ED-9292-7E54CEDB9AAE}" presName="rootComposite" presStyleCnt="0"/>
      <dgm:spPr/>
    </dgm:pt>
    <dgm:pt modelId="{982014A9-B66D-4A91-9A94-B34D021A57D6}" type="pres">
      <dgm:prSet presAssocID="{5D83DFC3-B3FC-47ED-9292-7E54CEDB9AAE}" presName="rootText" presStyleLbl="node4" presStyleIdx="1" presStyleCnt="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7BB588C-E09B-4873-9B57-CDB607CDB60E}" type="pres">
      <dgm:prSet presAssocID="{5D83DFC3-B3FC-47ED-9292-7E54CEDB9AAE}" presName="rootConnector" presStyleLbl="node4" presStyleIdx="1" presStyleCnt="8"/>
      <dgm:spPr/>
      <dgm:t>
        <a:bodyPr/>
        <a:lstStyle/>
        <a:p>
          <a:endParaRPr lang="en-US"/>
        </a:p>
      </dgm:t>
    </dgm:pt>
    <dgm:pt modelId="{26090989-52AA-4810-BC8F-142B4CAB09C5}" type="pres">
      <dgm:prSet presAssocID="{5D83DFC3-B3FC-47ED-9292-7E54CEDB9AAE}" presName="hierChild4" presStyleCnt="0"/>
      <dgm:spPr/>
    </dgm:pt>
    <dgm:pt modelId="{DBC4920F-59C1-47AA-9D1E-00F085041438}" type="pres">
      <dgm:prSet presAssocID="{C7E61FB8-0216-43C8-ABA2-5728C500D71F}" presName="Name37" presStyleLbl="parChTrans1D4" presStyleIdx="2" presStyleCnt="8"/>
      <dgm:spPr/>
      <dgm:t>
        <a:bodyPr/>
        <a:lstStyle/>
        <a:p>
          <a:endParaRPr lang="en-US"/>
        </a:p>
      </dgm:t>
    </dgm:pt>
    <dgm:pt modelId="{E3209FE3-E625-47D2-88C9-E9C272BF0E88}" type="pres">
      <dgm:prSet presAssocID="{C2CBD92B-B5BA-4866-A3A6-0C4BC3E17129}" presName="hierRoot2" presStyleCnt="0">
        <dgm:presLayoutVars>
          <dgm:hierBranch val="init"/>
        </dgm:presLayoutVars>
      </dgm:prSet>
      <dgm:spPr/>
    </dgm:pt>
    <dgm:pt modelId="{49CB69BE-3A26-41C9-8505-D85E1840BB78}" type="pres">
      <dgm:prSet presAssocID="{C2CBD92B-B5BA-4866-A3A6-0C4BC3E17129}" presName="rootComposite" presStyleCnt="0"/>
      <dgm:spPr/>
    </dgm:pt>
    <dgm:pt modelId="{B1529871-218B-4228-96AF-5E87ED27CF35}" type="pres">
      <dgm:prSet presAssocID="{C2CBD92B-B5BA-4866-A3A6-0C4BC3E17129}" presName="rootText" presStyleLbl="node4" presStyleIdx="2" presStyleCnt="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E990F38-BFCC-44AF-9B9D-3E370A3C4103}" type="pres">
      <dgm:prSet presAssocID="{C2CBD92B-B5BA-4866-A3A6-0C4BC3E17129}" presName="rootConnector" presStyleLbl="node4" presStyleIdx="2" presStyleCnt="8"/>
      <dgm:spPr/>
      <dgm:t>
        <a:bodyPr/>
        <a:lstStyle/>
        <a:p>
          <a:endParaRPr lang="en-US"/>
        </a:p>
      </dgm:t>
    </dgm:pt>
    <dgm:pt modelId="{A83DFB86-B0D5-4FBE-A355-F758FA12B86C}" type="pres">
      <dgm:prSet presAssocID="{C2CBD92B-B5BA-4866-A3A6-0C4BC3E17129}" presName="hierChild4" presStyleCnt="0"/>
      <dgm:spPr/>
    </dgm:pt>
    <dgm:pt modelId="{7F986992-5149-4761-8978-C480C570FB73}" type="pres">
      <dgm:prSet presAssocID="{C2CBD92B-B5BA-4866-A3A6-0C4BC3E17129}" presName="hierChild5" presStyleCnt="0"/>
      <dgm:spPr/>
    </dgm:pt>
    <dgm:pt modelId="{339A8D5F-1C42-4CB9-97A6-2835CA10CF51}" type="pres">
      <dgm:prSet presAssocID="{5D83DFC3-B3FC-47ED-9292-7E54CEDB9AAE}" presName="hierChild5" presStyleCnt="0"/>
      <dgm:spPr/>
    </dgm:pt>
    <dgm:pt modelId="{50572528-FE4D-4A4B-8786-941DEE7981B8}" type="pres">
      <dgm:prSet presAssocID="{BEE2C254-E67D-481E-98C7-333814D19837}" presName="hierChild5" presStyleCnt="0"/>
      <dgm:spPr/>
    </dgm:pt>
    <dgm:pt modelId="{57325153-6F63-47C8-A9BC-8B77CD6CA4CB}" type="pres">
      <dgm:prSet presAssocID="{F8F86D0B-B8C5-4F43-8FF8-341B478AF084}" presName="hierChild5" presStyleCnt="0"/>
      <dgm:spPr/>
    </dgm:pt>
    <dgm:pt modelId="{EEEB0294-43D7-4DF2-809D-7287859C4A8B}" type="pres">
      <dgm:prSet presAssocID="{B972437C-EAD4-4207-9AAF-A33382C18D19}" presName="Name37" presStyleLbl="parChTrans1D3" presStyleIdx="1" presStyleCnt="2"/>
      <dgm:spPr/>
      <dgm:t>
        <a:bodyPr/>
        <a:lstStyle/>
        <a:p>
          <a:endParaRPr lang="en-US"/>
        </a:p>
      </dgm:t>
    </dgm:pt>
    <dgm:pt modelId="{43E83F0E-DE14-4593-B072-6E4D2C6CBCE7}" type="pres">
      <dgm:prSet presAssocID="{BA30CB21-77AD-41A6-BF0D-312514452664}" presName="hierRoot2" presStyleCnt="0">
        <dgm:presLayoutVars>
          <dgm:hierBranch val="init"/>
        </dgm:presLayoutVars>
      </dgm:prSet>
      <dgm:spPr/>
    </dgm:pt>
    <dgm:pt modelId="{7779652B-39CC-401B-B419-F9A0B31F4D2E}" type="pres">
      <dgm:prSet presAssocID="{BA30CB21-77AD-41A6-BF0D-312514452664}" presName="rootComposite" presStyleCnt="0"/>
      <dgm:spPr/>
    </dgm:pt>
    <dgm:pt modelId="{F09554AF-D713-43F4-96BF-9D1E57E606EF}" type="pres">
      <dgm:prSet presAssocID="{BA30CB21-77AD-41A6-BF0D-312514452664}" presName="rootText" presStyleLbl="node3" presStyleIdx="1" presStyleCnt="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BCDC47F-573B-4AEA-B870-B5D207594BBD}" type="pres">
      <dgm:prSet presAssocID="{BA30CB21-77AD-41A6-BF0D-312514452664}" presName="rootConnector" presStyleLbl="node3" presStyleIdx="1" presStyleCnt="2"/>
      <dgm:spPr/>
      <dgm:t>
        <a:bodyPr/>
        <a:lstStyle/>
        <a:p>
          <a:endParaRPr lang="en-US"/>
        </a:p>
      </dgm:t>
    </dgm:pt>
    <dgm:pt modelId="{2AC44685-E275-4158-B3D7-39B3BB557F07}" type="pres">
      <dgm:prSet presAssocID="{BA30CB21-77AD-41A6-BF0D-312514452664}" presName="hierChild4" presStyleCnt="0"/>
      <dgm:spPr/>
    </dgm:pt>
    <dgm:pt modelId="{23A97686-2ABE-4A2B-A347-3C0B0FDC45F4}" type="pres">
      <dgm:prSet presAssocID="{76A48887-9602-46C2-A0E9-ACFA3689B159}" presName="Name37" presStyleLbl="parChTrans1D4" presStyleIdx="3" presStyleCnt="8"/>
      <dgm:spPr/>
      <dgm:t>
        <a:bodyPr/>
        <a:lstStyle/>
        <a:p>
          <a:endParaRPr lang="en-US"/>
        </a:p>
      </dgm:t>
    </dgm:pt>
    <dgm:pt modelId="{B3C66B93-4733-441A-8A53-9E1FB898DC94}" type="pres">
      <dgm:prSet presAssocID="{6BC6F426-A444-4468-8FEF-E158ACD2CF19}" presName="hierRoot2" presStyleCnt="0">
        <dgm:presLayoutVars>
          <dgm:hierBranch val="init"/>
        </dgm:presLayoutVars>
      </dgm:prSet>
      <dgm:spPr/>
    </dgm:pt>
    <dgm:pt modelId="{0956466F-D1BC-41CA-8C58-9FFFBC9B7FF8}" type="pres">
      <dgm:prSet presAssocID="{6BC6F426-A444-4468-8FEF-E158ACD2CF19}" presName="rootComposite" presStyleCnt="0"/>
      <dgm:spPr/>
    </dgm:pt>
    <dgm:pt modelId="{41D212A3-AA7A-4E51-8C61-853FFBDE9862}" type="pres">
      <dgm:prSet presAssocID="{6BC6F426-A444-4468-8FEF-E158ACD2CF19}" presName="rootText" presStyleLbl="node4" presStyleIdx="3" presStyleCnt="8" custScaleX="14891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F48155F1-1AB5-4564-9DB2-C922D29C0412}" type="pres">
      <dgm:prSet presAssocID="{6BC6F426-A444-4468-8FEF-E158ACD2CF19}" presName="rootConnector" presStyleLbl="node4" presStyleIdx="3" presStyleCnt="8"/>
      <dgm:spPr/>
      <dgm:t>
        <a:bodyPr/>
        <a:lstStyle/>
        <a:p>
          <a:endParaRPr lang="en-US"/>
        </a:p>
      </dgm:t>
    </dgm:pt>
    <dgm:pt modelId="{FE67AA03-CC98-44ED-AC2B-CD1EFE8183AF}" type="pres">
      <dgm:prSet presAssocID="{6BC6F426-A444-4468-8FEF-E158ACD2CF19}" presName="hierChild4" presStyleCnt="0"/>
      <dgm:spPr/>
    </dgm:pt>
    <dgm:pt modelId="{1B9BA3AB-EEA9-42C4-B1AC-3832A95639CA}" type="pres">
      <dgm:prSet presAssocID="{D59F031A-F73A-4E9D-A60D-38AF6CCF2E71}" presName="Name37" presStyleLbl="parChTrans1D4" presStyleIdx="4" presStyleCnt="8"/>
      <dgm:spPr/>
      <dgm:t>
        <a:bodyPr/>
        <a:lstStyle/>
        <a:p>
          <a:endParaRPr lang="en-US"/>
        </a:p>
      </dgm:t>
    </dgm:pt>
    <dgm:pt modelId="{21FCC388-6C1E-427A-A93B-230FCBB5662E}" type="pres">
      <dgm:prSet presAssocID="{D74D9C52-21A1-44A2-8D66-A27323094137}" presName="hierRoot2" presStyleCnt="0">
        <dgm:presLayoutVars>
          <dgm:hierBranch val="init"/>
        </dgm:presLayoutVars>
      </dgm:prSet>
      <dgm:spPr/>
    </dgm:pt>
    <dgm:pt modelId="{44099F3B-F123-4676-AEF9-1BF11AEE377C}" type="pres">
      <dgm:prSet presAssocID="{D74D9C52-21A1-44A2-8D66-A27323094137}" presName="rootComposite" presStyleCnt="0"/>
      <dgm:spPr/>
    </dgm:pt>
    <dgm:pt modelId="{DC03FCA1-2108-44CC-B393-29149704164B}" type="pres">
      <dgm:prSet presAssocID="{D74D9C52-21A1-44A2-8D66-A27323094137}" presName="rootText" presStyleLbl="node4" presStyleIdx="4" presStyleCnt="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0A03850-864A-482C-883B-64E910070869}" type="pres">
      <dgm:prSet presAssocID="{D74D9C52-21A1-44A2-8D66-A27323094137}" presName="rootConnector" presStyleLbl="node4" presStyleIdx="4" presStyleCnt="8"/>
      <dgm:spPr/>
      <dgm:t>
        <a:bodyPr/>
        <a:lstStyle/>
        <a:p>
          <a:endParaRPr lang="en-US"/>
        </a:p>
      </dgm:t>
    </dgm:pt>
    <dgm:pt modelId="{B0FA5201-A4E5-49E1-AF34-53175BF2C3AB}" type="pres">
      <dgm:prSet presAssocID="{D74D9C52-21A1-44A2-8D66-A27323094137}" presName="hierChild4" presStyleCnt="0"/>
      <dgm:spPr/>
    </dgm:pt>
    <dgm:pt modelId="{5E476DFA-B7F7-4B0C-AA45-60FDF6617330}" type="pres">
      <dgm:prSet presAssocID="{6FAC539D-24FC-49AD-8761-6D8A674C956B}" presName="Name37" presStyleLbl="parChTrans1D4" presStyleIdx="5" presStyleCnt="8"/>
      <dgm:spPr/>
      <dgm:t>
        <a:bodyPr/>
        <a:lstStyle/>
        <a:p>
          <a:endParaRPr lang="en-US"/>
        </a:p>
      </dgm:t>
    </dgm:pt>
    <dgm:pt modelId="{55AC38E1-9552-4F44-BA80-3F48C582D626}" type="pres">
      <dgm:prSet presAssocID="{8E925BB5-CB04-4666-8302-53B25619A781}" presName="hierRoot2" presStyleCnt="0">
        <dgm:presLayoutVars>
          <dgm:hierBranch val="init"/>
        </dgm:presLayoutVars>
      </dgm:prSet>
      <dgm:spPr/>
    </dgm:pt>
    <dgm:pt modelId="{926F0D43-AF22-4A5A-B7C8-AA4ECC111C63}" type="pres">
      <dgm:prSet presAssocID="{8E925BB5-CB04-4666-8302-53B25619A781}" presName="rootComposite" presStyleCnt="0"/>
      <dgm:spPr/>
    </dgm:pt>
    <dgm:pt modelId="{FA7B853B-736E-4B1D-B69F-0D470A71E34E}" type="pres">
      <dgm:prSet presAssocID="{8E925BB5-CB04-4666-8302-53B25619A781}" presName="rootText" presStyleLbl="node4" presStyleIdx="5" presStyleCnt="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BC947BC-DC15-429C-AAD4-B90FB95105CC}" type="pres">
      <dgm:prSet presAssocID="{8E925BB5-CB04-4666-8302-53B25619A781}" presName="rootConnector" presStyleLbl="node4" presStyleIdx="5" presStyleCnt="8"/>
      <dgm:spPr/>
      <dgm:t>
        <a:bodyPr/>
        <a:lstStyle/>
        <a:p>
          <a:endParaRPr lang="en-US"/>
        </a:p>
      </dgm:t>
    </dgm:pt>
    <dgm:pt modelId="{76B0BD3B-D873-4DE7-BD90-A8F0B5168985}" type="pres">
      <dgm:prSet presAssocID="{8E925BB5-CB04-4666-8302-53B25619A781}" presName="hierChild4" presStyleCnt="0"/>
      <dgm:spPr/>
    </dgm:pt>
    <dgm:pt modelId="{53AF8FAF-4F4E-4CD8-920F-FBB1CFA02BA1}" type="pres">
      <dgm:prSet presAssocID="{8E925BB5-CB04-4666-8302-53B25619A781}" presName="hierChild5" presStyleCnt="0"/>
      <dgm:spPr/>
    </dgm:pt>
    <dgm:pt modelId="{17C9584C-B295-4F7C-9968-F927012DB5E7}" type="pres">
      <dgm:prSet presAssocID="{D74D9C52-21A1-44A2-8D66-A27323094137}" presName="hierChild5" presStyleCnt="0"/>
      <dgm:spPr/>
    </dgm:pt>
    <dgm:pt modelId="{326A0441-8363-4B56-9C4E-70A11CD68643}" type="pres">
      <dgm:prSet presAssocID="{6BC6F426-A444-4468-8FEF-E158ACD2CF19}" presName="hierChild5" presStyleCnt="0"/>
      <dgm:spPr/>
    </dgm:pt>
    <dgm:pt modelId="{FDA89364-3858-468A-AAA2-805A72E62C8D}" type="pres">
      <dgm:prSet presAssocID="{856C8DA7-FD9C-4165-9FE1-1E2DFDC07F0E}" presName="Name37" presStyleLbl="parChTrans1D4" presStyleIdx="6" presStyleCnt="8"/>
      <dgm:spPr/>
      <dgm:t>
        <a:bodyPr/>
        <a:lstStyle/>
        <a:p>
          <a:endParaRPr lang="en-US"/>
        </a:p>
      </dgm:t>
    </dgm:pt>
    <dgm:pt modelId="{674480B6-9449-4DB2-8F58-A1EC92F6BC96}" type="pres">
      <dgm:prSet presAssocID="{7E77B31C-81E9-4872-8E76-6644BA2DEB2A}" presName="hierRoot2" presStyleCnt="0">
        <dgm:presLayoutVars>
          <dgm:hierBranch val="init"/>
        </dgm:presLayoutVars>
      </dgm:prSet>
      <dgm:spPr/>
    </dgm:pt>
    <dgm:pt modelId="{E0DF3BF3-1C58-46CC-B5EA-1D0085E5191A}" type="pres">
      <dgm:prSet presAssocID="{7E77B31C-81E9-4872-8E76-6644BA2DEB2A}" presName="rootComposite" presStyleCnt="0"/>
      <dgm:spPr/>
    </dgm:pt>
    <dgm:pt modelId="{E03A8F3E-0B6B-42A6-96D6-74098ED27472}" type="pres">
      <dgm:prSet presAssocID="{7E77B31C-81E9-4872-8E76-6644BA2DEB2A}" presName="rootText" presStyleLbl="node4" presStyleIdx="6" presStyleCnt="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CAC91B5-9D4D-4B08-9424-A84660773813}" type="pres">
      <dgm:prSet presAssocID="{7E77B31C-81E9-4872-8E76-6644BA2DEB2A}" presName="rootConnector" presStyleLbl="node4" presStyleIdx="6" presStyleCnt="8"/>
      <dgm:spPr/>
      <dgm:t>
        <a:bodyPr/>
        <a:lstStyle/>
        <a:p>
          <a:endParaRPr lang="en-US"/>
        </a:p>
      </dgm:t>
    </dgm:pt>
    <dgm:pt modelId="{3A75446C-C465-44AC-894B-A12600176C5B}" type="pres">
      <dgm:prSet presAssocID="{7E77B31C-81E9-4872-8E76-6644BA2DEB2A}" presName="hierChild4" presStyleCnt="0"/>
      <dgm:spPr/>
    </dgm:pt>
    <dgm:pt modelId="{FBF831EA-AFE1-4409-9A43-97513AC38993}" type="pres">
      <dgm:prSet presAssocID="{5C1DB733-9AA0-41B4-B77E-AF4C0203624A}" presName="Name37" presStyleLbl="parChTrans1D4" presStyleIdx="7" presStyleCnt="8"/>
      <dgm:spPr/>
      <dgm:t>
        <a:bodyPr/>
        <a:lstStyle/>
        <a:p>
          <a:endParaRPr lang="en-US"/>
        </a:p>
      </dgm:t>
    </dgm:pt>
    <dgm:pt modelId="{725C4396-222F-40D0-AEC0-9B0FD802BCE3}" type="pres">
      <dgm:prSet presAssocID="{E58A2CE7-C7D0-409F-9A7A-65CC9CC90808}" presName="hierRoot2" presStyleCnt="0">
        <dgm:presLayoutVars>
          <dgm:hierBranch val="init"/>
        </dgm:presLayoutVars>
      </dgm:prSet>
      <dgm:spPr/>
    </dgm:pt>
    <dgm:pt modelId="{8116EC53-7597-432F-A4B3-0AB3ACED5ADC}" type="pres">
      <dgm:prSet presAssocID="{E58A2CE7-C7D0-409F-9A7A-65CC9CC90808}" presName="rootComposite" presStyleCnt="0"/>
      <dgm:spPr/>
    </dgm:pt>
    <dgm:pt modelId="{52617DA3-E456-449C-B04D-8FC6AF54F07C}" type="pres">
      <dgm:prSet presAssocID="{E58A2CE7-C7D0-409F-9A7A-65CC9CC90808}" presName="rootText" presStyleLbl="node4" presStyleIdx="7" presStyleCnt="8" custLinFactY="42747" custLinFactNeighborX="1881" custLinFactNeighborY="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EFEF9B43-01BE-4302-91F7-0416C0A0E2D2}" type="pres">
      <dgm:prSet presAssocID="{E58A2CE7-C7D0-409F-9A7A-65CC9CC90808}" presName="rootConnector" presStyleLbl="node4" presStyleIdx="7" presStyleCnt="8"/>
      <dgm:spPr/>
      <dgm:t>
        <a:bodyPr/>
        <a:lstStyle/>
        <a:p>
          <a:endParaRPr lang="en-US"/>
        </a:p>
      </dgm:t>
    </dgm:pt>
    <dgm:pt modelId="{390CEB9C-53F2-4120-9EDE-74CE37EB1ED0}" type="pres">
      <dgm:prSet presAssocID="{E58A2CE7-C7D0-409F-9A7A-65CC9CC90808}" presName="hierChild4" presStyleCnt="0"/>
      <dgm:spPr/>
    </dgm:pt>
    <dgm:pt modelId="{7D6E6A17-17CB-46ED-8E3B-D7FF40E9EF91}" type="pres">
      <dgm:prSet presAssocID="{E58A2CE7-C7D0-409F-9A7A-65CC9CC90808}" presName="hierChild5" presStyleCnt="0"/>
      <dgm:spPr/>
    </dgm:pt>
    <dgm:pt modelId="{A5053507-E841-4391-9783-90FC865819EE}" type="pres">
      <dgm:prSet presAssocID="{7E77B31C-81E9-4872-8E76-6644BA2DEB2A}" presName="hierChild5" presStyleCnt="0"/>
      <dgm:spPr/>
    </dgm:pt>
    <dgm:pt modelId="{C396340B-E962-4EC9-BC98-48776F6C5407}" type="pres">
      <dgm:prSet presAssocID="{BA30CB21-77AD-41A6-BF0D-312514452664}" presName="hierChild5" presStyleCnt="0"/>
      <dgm:spPr/>
    </dgm:pt>
    <dgm:pt modelId="{86ED8E28-5DF1-467A-8E9F-0254FB5D444E}" type="pres">
      <dgm:prSet presAssocID="{09DC9CB9-7965-4D84-91D7-7C42156429A0}" presName="hierChild5" presStyleCnt="0"/>
      <dgm:spPr/>
    </dgm:pt>
    <dgm:pt modelId="{F223EC6E-243A-4E43-8E99-4052815252FF}" type="pres">
      <dgm:prSet presAssocID="{F808247F-F6E3-4E79-A5A7-DE8208B86ACD}" presName="hierChild3" presStyleCnt="0"/>
      <dgm:spPr/>
    </dgm:pt>
  </dgm:ptLst>
  <dgm:cxnLst>
    <dgm:cxn modelId="{3B538372-5C92-4FE3-8E44-636FC9434DE5}" type="presOf" srcId="{5C1DB733-9AA0-41B4-B77E-AF4C0203624A}" destId="{FBF831EA-AFE1-4409-9A43-97513AC38993}" srcOrd="0" destOrd="0" presId="urn:microsoft.com/office/officeart/2005/8/layout/orgChart1"/>
    <dgm:cxn modelId="{E4C4A7B5-9F55-4582-80B0-BB73E5886E9B}" type="presOf" srcId="{5D83DFC3-B3FC-47ED-9292-7E54CEDB9AAE}" destId="{57BB588C-E09B-4873-9B57-CDB607CDB60E}" srcOrd="1" destOrd="0" presId="urn:microsoft.com/office/officeart/2005/8/layout/orgChart1"/>
    <dgm:cxn modelId="{3C6A2F48-B93E-4F9D-976E-A3FD0638885D}" type="presOf" srcId="{B972437C-EAD4-4207-9AAF-A33382C18D19}" destId="{EEEB0294-43D7-4DF2-809D-7287859C4A8B}" srcOrd="0" destOrd="0" presId="urn:microsoft.com/office/officeart/2005/8/layout/orgChart1"/>
    <dgm:cxn modelId="{4ED750A1-C52E-44BC-BAED-009705379624}" srcId="{09DC9CB9-7965-4D84-91D7-7C42156429A0}" destId="{F8F86D0B-B8C5-4F43-8FF8-341B478AF084}" srcOrd="0" destOrd="0" parTransId="{E57B3E8B-EF92-4033-9F29-D892F5F49888}" sibTransId="{7D5CFC8C-2483-415D-835F-53953BD02E6A}"/>
    <dgm:cxn modelId="{6F72786C-8594-43C1-9DFD-AB1397729523}" type="presOf" srcId="{09DC9CB9-7965-4D84-91D7-7C42156429A0}" destId="{94CC7A13-72BD-4A92-BAAD-7CBC2169CC7B}" srcOrd="1" destOrd="0" presId="urn:microsoft.com/office/officeart/2005/8/layout/orgChart1"/>
    <dgm:cxn modelId="{946C3F96-B1D3-40C0-A9E7-556E60F9BC82}" type="presOf" srcId="{C2CBD92B-B5BA-4866-A3A6-0C4BC3E17129}" destId="{2E990F38-BFCC-44AF-9B9D-3E370A3C4103}" srcOrd="1" destOrd="0" presId="urn:microsoft.com/office/officeart/2005/8/layout/orgChart1"/>
    <dgm:cxn modelId="{7C2F6316-EA68-4813-B94C-5DD1B5EF59C2}" type="presOf" srcId="{96AC9455-0640-46A9-B5DE-E851E2EB7CA2}" destId="{4932B976-1306-409D-A15E-523C7A699DB3}" srcOrd="0" destOrd="0" presId="urn:microsoft.com/office/officeart/2005/8/layout/orgChart1"/>
    <dgm:cxn modelId="{CF4E5CB4-9620-4BB5-8AC9-43AEAFA4D8D0}" type="presOf" srcId="{C2CBD92B-B5BA-4866-A3A6-0C4BC3E17129}" destId="{B1529871-218B-4228-96AF-5E87ED27CF35}" srcOrd="0" destOrd="0" presId="urn:microsoft.com/office/officeart/2005/8/layout/orgChart1"/>
    <dgm:cxn modelId="{19A9727B-E3BE-47A3-81EA-5417F4EA192E}" type="presOf" srcId="{09DC9CB9-7965-4D84-91D7-7C42156429A0}" destId="{C7002D31-D535-4545-AB27-DC7B00C0CF02}" srcOrd="0" destOrd="0" presId="urn:microsoft.com/office/officeart/2005/8/layout/orgChart1"/>
    <dgm:cxn modelId="{6135ABF5-ECDF-4AC2-9F07-2B2F261C0C6F}" type="presOf" srcId="{5D83DFC3-B3FC-47ED-9292-7E54CEDB9AAE}" destId="{982014A9-B66D-4A91-9A94-B34D021A57D6}" srcOrd="0" destOrd="0" presId="urn:microsoft.com/office/officeart/2005/8/layout/orgChart1"/>
    <dgm:cxn modelId="{D26F03E6-9C2D-400A-9489-19D3E3CA35E8}" srcId="{BA30CB21-77AD-41A6-BF0D-312514452664}" destId="{7E77B31C-81E9-4872-8E76-6644BA2DEB2A}" srcOrd="1" destOrd="0" parTransId="{856C8DA7-FD9C-4165-9FE1-1E2DFDC07F0E}" sibTransId="{19C7A915-BDED-4B49-AC31-B6679BA758FE}"/>
    <dgm:cxn modelId="{5ADE8425-30C2-400D-91C9-E2CEDF8AA45F}" srcId="{6BC6F426-A444-4468-8FEF-E158ACD2CF19}" destId="{D74D9C52-21A1-44A2-8D66-A27323094137}" srcOrd="0" destOrd="0" parTransId="{D59F031A-F73A-4E9D-A60D-38AF6CCF2E71}" sibTransId="{261D46F6-8B72-4B3D-BF90-C73A23D3F0CD}"/>
    <dgm:cxn modelId="{13AB8DD5-AF23-4515-8EAA-07BDEB1D0A2B}" srcId="{B53CC96F-F5CD-4CD7-9A8B-A080E07C3848}" destId="{F808247F-F6E3-4E79-A5A7-DE8208B86ACD}" srcOrd="0" destOrd="0" parTransId="{252BE950-B822-4B9D-A3E9-DB486DD8DECA}" sibTransId="{F18FF0AB-97A8-4BCA-9DE6-E3B9F68A4CED}"/>
    <dgm:cxn modelId="{CBB9960E-8947-41C6-8B14-C13A89D17810}" type="presOf" srcId="{B53CC96F-F5CD-4CD7-9A8B-A080E07C3848}" destId="{04C083E7-9597-4EE9-A9C2-3443049DDD13}" srcOrd="0" destOrd="0" presId="urn:microsoft.com/office/officeart/2005/8/layout/orgChart1"/>
    <dgm:cxn modelId="{C2368CC5-D379-487C-85B1-1106EAAF0972}" type="presOf" srcId="{6BC6F426-A444-4468-8FEF-E158ACD2CF19}" destId="{F48155F1-1AB5-4564-9DB2-C922D29C0412}" srcOrd="1" destOrd="0" presId="urn:microsoft.com/office/officeart/2005/8/layout/orgChart1"/>
    <dgm:cxn modelId="{2ED3F63F-DCCB-4557-AD32-383C63024E42}" type="presOf" srcId="{F808247F-F6E3-4E79-A5A7-DE8208B86ACD}" destId="{590AA2EC-F0AB-440F-A9A0-09AA76F5468A}" srcOrd="0" destOrd="0" presId="urn:microsoft.com/office/officeart/2005/8/layout/orgChart1"/>
    <dgm:cxn modelId="{65ECB0C7-033F-43EB-91CD-E51414D7371C}" srcId="{BEE2C254-E67D-481E-98C7-333814D19837}" destId="{5D83DFC3-B3FC-47ED-9292-7E54CEDB9AAE}" srcOrd="0" destOrd="0" parTransId="{96AC9455-0640-46A9-B5DE-E851E2EB7CA2}" sibTransId="{86232F44-3BF9-48D2-8B5B-B6CF6A49F939}"/>
    <dgm:cxn modelId="{9E1B3534-E40F-4D03-929A-F8243ED7ED42}" type="presOf" srcId="{F8F86D0B-B8C5-4F43-8FF8-341B478AF084}" destId="{0A24AA5B-B2AF-4C93-B25A-71752901D584}" srcOrd="1" destOrd="0" presId="urn:microsoft.com/office/officeart/2005/8/layout/orgChart1"/>
    <dgm:cxn modelId="{EAED4573-2A8E-4D38-A55D-F053C5627A19}" type="presOf" srcId="{BEE2C254-E67D-481E-98C7-333814D19837}" destId="{EB2B9AAD-5B70-4168-B7B8-2B6B1B4EBF89}" srcOrd="0" destOrd="0" presId="urn:microsoft.com/office/officeart/2005/8/layout/orgChart1"/>
    <dgm:cxn modelId="{3C0BDBDB-0B6E-4566-8A17-B0D914109787}" type="presOf" srcId="{9693903D-BA74-47FE-95DF-D5FB9DFD9ECE}" destId="{B1C87CDF-86FC-43F2-A129-62EAC6215B0C}" srcOrd="0" destOrd="0" presId="urn:microsoft.com/office/officeart/2005/8/layout/orgChart1"/>
    <dgm:cxn modelId="{C1E4008E-459F-4536-8224-601591769FBF}" type="presOf" srcId="{E58A2CE7-C7D0-409F-9A7A-65CC9CC90808}" destId="{EFEF9B43-01BE-4302-91F7-0416C0A0E2D2}" srcOrd="1" destOrd="0" presId="urn:microsoft.com/office/officeart/2005/8/layout/orgChart1"/>
    <dgm:cxn modelId="{11B81569-A056-4672-9232-395E1C56DA5E}" type="presOf" srcId="{7E77B31C-81E9-4872-8E76-6644BA2DEB2A}" destId="{E03A8F3E-0B6B-42A6-96D6-74098ED27472}" srcOrd="0" destOrd="0" presId="urn:microsoft.com/office/officeart/2005/8/layout/orgChart1"/>
    <dgm:cxn modelId="{1EE2D1CB-BBFC-455B-B8B4-64AA99DCFA29}" type="presOf" srcId="{76A48887-9602-46C2-A0E9-ACFA3689B159}" destId="{23A97686-2ABE-4A2B-A347-3C0B0FDC45F4}" srcOrd="0" destOrd="0" presId="urn:microsoft.com/office/officeart/2005/8/layout/orgChart1"/>
    <dgm:cxn modelId="{E55C3031-BE63-4DA4-8F0A-9785F29AD9D2}" type="presOf" srcId="{8E925BB5-CB04-4666-8302-53B25619A781}" destId="{5BC947BC-DC15-429C-AAD4-B90FB95105CC}" srcOrd="1" destOrd="0" presId="urn:microsoft.com/office/officeart/2005/8/layout/orgChart1"/>
    <dgm:cxn modelId="{44AC0218-D0F1-49AE-9D3F-0DF6AF491177}" type="presOf" srcId="{F8F86D0B-B8C5-4F43-8FF8-341B478AF084}" destId="{B9FBD0DF-1994-4756-9C31-863763F81800}" srcOrd="0" destOrd="0" presId="urn:microsoft.com/office/officeart/2005/8/layout/orgChart1"/>
    <dgm:cxn modelId="{65A8976F-9A33-4A79-8597-EA0F5002AA75}" type="presOf" srcId="{C7E61FB8-0216-43C8-ABA2-5728C500D71F}" destId="{DBC4920F-59C1-47AA-9D1E-00F085041438}" srcOrd="0" destOrd="0" presId="urn:microsoft.com/office/officeart/2005/8/layout/orgChart1"/>
    <dgm:cxn modelId="{45ADB794-72C0-4B63-B172-97825DD3FBE7}" type="presOf" srcId="{D74D9C52-21A1-44A2-8D66-A27323094137}" destId="{DC03FCA1-2108-44CC-B393-29149704164B}" srcOrd="0" destOrd="0" presId="urn:microsoft.com/office/officeart/2005/8/layout/orgChart1"/>
    <dgm:cxn modelId="{8081BB71-1C08-4013-99F9-C8701B5F1E64}" type="presOf" srcId="{BA30CB21-77AD-41A6-BF0D-312514452664}" destId="{2BCDC47F-573B-4AEA-B870-B5D207594BBD}" srcOrd="1" destOrd="0" presId="urn:microsoft.com/office/officeart/2005/8/layout/orgChart1"/>
    <dgm:cxn modelId="{6FBA58E7-037E-4D5B-8726-7C8ED35C5167}" srcId="{D74D9C52-21A1-44A2-8D66-A27323094137}" destId="{8E925BB5-CB04-4666-8302-53B25619A781}" srcOrd="0" destOrd="0" parTransId="{6FAC539D-24FC-49AD-8761-6D8A674C956B}" sibTransId="{316F5519-476D-4B03-9BEC-DBAB88589330}"/>
    <dgm:cxn modelId="{35FF5FDD-9507-4DBF-9126-010D617CB059}" type="presOf" srcId="{E57B3E8B-EF92-4033-9F29-D892F5F49888}" destId="{176CA4B5-53D5-4A19-882B-CA93D30E2B54}" srcOrd="0" destOrd="0" presId="urn:microsoft.com/office/officeart/2005/8/layout/orgChart1"/>
    <dgm:cxn modelId="{AB30378D-9376-45AB-84E8-308F437DA04F}" srcId="{F8F86D0B-B8C5-4F43-8FF8-341B478AF084}" destId="{BEE2C254-E67D-481E-98C7-333814D19837}" srcOrd="0" destOrd="0" parTransId="{9693903D-BA74-47FE-95DF-D5FB9DFD9ECE}" sibTransId="{A9B4FC94-FFBA-46DF-8E13-13548212010E}"/>
    <dgm:cxn modelId="{AC308D7A-59AD-4116-83E1-1542838C21B8}" srcId="{BA30CB21-77AD-41A6-BF0D-312514452664}" destId="{6BC6F426-A444-4468-8FEF-E158ACD2CF19}" srcOrd="0" destOrd="0" parTransId="{76A48887-9602-46C2-A0E9-ACFA3689B159}" sibTransId="{8DDAB486-369B-406F-AC0D-D22840963368}"/>
    <dgm:cxn modelId="{C4657CEA-6FDD-4543-8793-E6A1A3557979}" srcId="{F808247F-F6E3-4E79-A5A7-DE8208B86ACD}" destId="{09DC9CB9-7965-4D84-91D7-7C42156429A0}" srcOrd="0" destOrd="0" parTransId="{4119D5D0-FA31-42FF-A231-507BEE5A608E}" sibTransId="{C5F7BA69-3C02-4FB3-83E6-623BD132BD0D}"/>
    <dgm:cxn modelId="{97503AC9-67B2-4A8B-8FCA-C97C9B6490EF}" type="presOf" srcId="{4119D5D0-FA31-42FF-A231-507BEE5A608E}" destId="{0DC54BB8-D923-405C-A452-A0897CF2B5BD}" srcOrd="0" destOrd="0" presId="urn:microsoft.com/office/officeart/2005/8/layout/orgChart1"/>
    <dgm:cxn modelId="{9A1D35C9-2D8D-4B7E-AB36-AE24E3F487B1}" srcId="{7E77B31C-81E9-4872-8E76-6644BA2DEB2A}" destId="{E58A2CE7-C7D0-409F-9A7A-65CC9CC90808}" srcOrd="0" destOrd="0" parTransId="{5C1DB733-9AA0-41B4-B77E-AF4C0203624A}" sibTransId="{6AE0A713-303F-406C-A279-4E5F68A32EDE}"/>
    <dgm:cxn modelId="{2ACAB0C5-B882-4259-90F8-1704E00B3C49}" type="presOf" srcId="{6FAC539D-24FC-49AD-8761-6D8A674C956B}" destId="{5E476DFA-B7F7-4B0C-AA45-60FDF6617330}" srcOrd="0" destOrd="0" presId="urn:microsoft.com/office/officeart/2005/8/layout/orgChart1"/>
    <dgm:cxn modelId="{C22B4FE0-33E8-4B7B-8D84-CE8E11A06EAE}" type="presOf" srcId="{BEE2C254-E67D-481E-98C7-333814D19837}" destId="{E6D92E72-A03B-41CC-8590-98AAB73B1DD4}" srcOrd="1" destOrd="0" presId="urn:microsoft.com/office/officeart/2005/8/layout/orgChart1"/>
    <dgm:cxn modelId="{05AF6C43-F226-4A25-9146-382E9FCD3633}" type="presOf" srcId="{E58A2CE7-C7D0-409F-9A7A-65CC9CC90808}" destId="{52617DA3-E456-449C-B04D-8FC6AF54F07C}" srcOrd="0" destOrd="0" presId="urn:microsoft.com/office/officeart/2005/8/layout/orgChart1"/>
    <dgm:cxn modelId="{C112CC2F-D96C-48FD-9C87-19BE44EDF176}" type="presOf" srcId="{6BC6F426-A444-4468-8FEF-E158ACD2CF19}" destId="{41D212A3-AA7A-4E51-8C61-853FFBDE9862}" srcOrd="0" destOrd="0" presId="urn:microsoft.com/office/officeart/2005/8/layout/orgChart1"/>
    <dgm:cxn modelId="{F93836BD-F0D8-44DB-AC00-A92DAB2A229B}" type="presOf" srcId="{D74D9C52-21A1-44A2-8D66-A27323094137}" destId="{A0A03850-864A-482C-883B-64E910070869}" srcOrd="1" destOrd="0" presId="urn:microsoft.com/office/officeart/2005/8/layout/orgChart1"/>
    <dgm:cxn modelId="{37056DE3-D0E6-4AD9-B260-03948D95D4F4}" type="presOf" srcId="{D59F031A-F73A-4E9D-A60D-38AF6CCF2E71}" destId="{1B9BA3AB-EEA9-42C4-B1AC-3832A95639CA}" srcOrd="0" destOrd="0" presId="urn:microsoft.com/office/officeart/2005/8/layout/orgChart1"/>
    <dgm:cxn modelId="{96B2CC0B-D121-45C3-B6ED-37F169426EAC}" type="presOf" srcId="{BA30CB21-77AD-41A6-BF0D-312514452664}" destId="{F09554AF-D713-43F4-96BF-9D1E57E606EF}" srcOrd="0" destOrd="0" presId="urn:microsoft.com/office/officeart/2005/8/layout/orgChart1"/>
    <dgm:cxn modelId="{AB510423-9C97-4C63-890F-51CA2E8E249E}" type="presOf" srcId="{F808247F-F6E3-4E79-A5A7-DE8208B86ACD}" destId="{99838F99-0A43-4565-8EAF-D3629E95E813}" srcOrd="1" destOrd="0" presId="urn:microsoft.com/office/officeart/2005/8/layout/orgChart1"/>
    <dgm:cxn modelId="{78CD650D-FB6F-4DCA-96E6-298D8848F809}" type="presOf" srcId="{8E925BB5-CB04-4666-8302-53B25619A781}" destId="{FA7B853B-736E-4B1D-B69F-0D470A71E34E}" srcOrd="0" destOrd="0" presId="urn:microsoft.com/office/officeart/2005/8/layout/orgChart1"/>
    <dgm:cxn modelId="{1D28EACC-E54F-4F10-A0BF-BA60A9342A69}" type="presOf" srcId="{856C8DA7-FD9C-4165-9FE1-1E2DFDC07F0E}" destId="{FDA89364-3858-468A-AAA2-805A72E62C8D}" srcOrd="0" destOrd="0" presId="urn:microsoft.com/office/officeart/2005/8/layout/orgChart1"/>
    <dgm:cxn modelId="{8FC83E2D-5E1D-4717-9C08-887DD8A21D67}" type="presOf" srcId="{7E77B31C-81E9-4872-8E76-6644BA2DEB2A}" destId="{9CAC91B5-9D4D-4B08-9424-A84660773813}" srcOrd="1" destOrd="0" presId="urn:microsoft.com/office/officeart/2005/8/layout/orgChart1"/>
    <dgm:cxn modelId="{B82FC416-5374-46B0-86E4-610D71555597}" srcId="{5D83DFC3-B3FC-47ED-9292-7E54CEDB9AAE}" destId="{C2CBD92B-B5BA-4866-A3A6-0C4BC3E17129}" srcOrd="0" destOrd="0" parTransId="{C7E61FB8-0216-43C8-ABA2-5728C500D71F}" sibTransId="{BDBDF3A3-64C5-4119-8278-A1C3A0DFCD09}"/>
    <dgm:cxn modelId="{E4D35F9A-595F-43DF-8416-E5BA7CAC1C47}" srcId="{09DC9CB9-7965-4D84-91D7-7C42156429A0}" destId="{BA30CB21-77AD-41A6-BF0D-312514452664}" srcOrd="1" destOrd="0" parTransId="{B972437C-EAD4-4207-9AAF-A33382C18D19}" sibTransId="{F9EF5737-679B-470A-8D6A-255DAF4BCABE}"/>
    <dgm:cxn modelId="{FC2CE058-A9E3-4ABA-A383-52D68CA518B7}" type="presParOf" srcId="{04C083E7-9597-4EE9-A9C2-3443049DDD13}" destId="{0093C735-6F08-4E25-9698-674EFEE96BEA}" srcOrd="0" destOrd="0" presId="urn:microsoft.com/office/officeart/2005/8/layout/orgChart1"/>
    <dgm:cxn modelId="{6EE01094-1730-4E62-B342-CEC9CE74F03E}" type="presParOf" srcId="{0093C735-6F08-4E25-9698-674EFEE96BEA}" destId="{5F1B1C9B-F7AE-4CF4-B43C-430BCF5059AA}" srcOrd="0" destOrd="0" presId="urn:microsoft.com/office/officeart/2005/8/layout/orgChart1"/>
    <dgm:cxn modelId="{AAE0DDC9-8D8C-48C3-BBCA-89E2551DE58D}" type="presParOf" srcId="{5F1B1C9B-F7AE-4CF4-B43C-430BCF5059AA}" destId="{590AA2EC-F0AB-440F-A9A0-09AA76F5468A}" srcOrd="0" destOrd="0" presId="urn:microsoft.com/office/officeart/2005/8/layout/orgChart1"/>
    <dgm:cxn modelId="{7A8C1D6F-655B-4243-9C18-EA8B569CE343}" type="presParOf" srcId="{5F1B1C9B-F7AE-4CF4-B43C-430BCF5059AA}" destId="{99838F99-0A43-4565-8EAF-D3629E95E813}" srcOrd="1" destOrd="0" presId="urn:microsoft.com/office/officeart/2005/8/layout/orgChart1"/>
    <dgm:cxn modelId="{68EECB2B-6757-437C-91A5-E9CD491FB0F8}" type="presParOf" srcId="{0093C735-6F08-4E25-9698-674EFEE96BEA}" destId="{4A29D580-A882-46D9-94D8-B49F217A8B0C}" srcOrd="1" destOrd="0" presId="urn:microsoft.com/office/officeart/2005/8/layout/orgChart1"/>
    <dgm:cxn modelId="{7F91D3BA-B014-40E8-A277-3DB4ACE73E11}" type="presParOf" srcId="{4A29D580-A882-46D9-94D8-B49F217A8B0C}" destId="{0DC54BB8-D923-405C-A452-A0897CF2B5BD}" srcOrd="0" destOrd="0" presId="urn:microsoft.com/office/officeart/2005/8/layout/orgChart1"/>
    <dgm:cxn modelId="{84DA09F4-1C4D-4E4A-90CF-FF4013A5336C}" type="presParOf" srcId="{4A29D580-A882-46D9-94D8-B49F217A8B0C}" destId="{2653B149-E122-44B8-9E77-B00E40D15E4B}" srcOrd="1" destOrd="0" presId="urn:microsoft.com/office/officeart/2005/8/layout/orgChart1"/>
    <dgm:cxn modelId="{67971D36-588D-417B-B9E4-E38BC84B0C23}" type="presParOf" srcId="{2653B149-E122-44B8-9E77-B00E40D15E4B}" destId="{CDFD48B5-CF3F-4AE4-A1F2-056434D4EA0B}" srcOrd="0" destOrd="0" presId="urn:microsoft.com/office/officeart/2005/8/layout/orgChart1"/>
    <dgm:cxn modelId="{CDE29F4A-3A2A-4373-AA7C-783893B9FA5F}" type="presParOf" srcId="{CDFD48B5-CF3F-4AE4-A1F2-056434D4EA0B}" destId="{C7002D31-D535-4545-AB27-DC7B00C0CF02}" srcOrd="0" destOrd="0" presId="urn:microsoft.com/office/officeart/2005/8/layout/orgChart1"/>
    <dgm:cxn modelId="{A0256B94-AE5A-43A1-B52C-84BBBD771629}" type="presParOf" srcId="{CDFD48B5-CF3F-4AE4-A1F2-056434D4EA0B}" destId="{94CC7A13-72BD-4A92-BAAD-7CBC2169CC7B}" srcOrd="1" destOrd="0" presId="urn:microsoft.com/office/officeart/2005/8/layout/orgChart1"/>
    <dgm:cxn modelId="{FB8EBC41-4ADE-4114-B9F5-5576B06315C0}" type="presParOf" srcId="{2653B149-E122-44B8-9E77-B00E40D15E4B}" destId="{A8D983F0-6F90-4029-A4AD-5DC404D35E48}" srcOrd="1" destOrd="0" presId="urn:microsoft.com/office/officeart/2005/8/layout/orgChart1"/>
    <dgm:cxn modelId="{AEDECC7A-65A1-4911-B2BE-5EFEE5B557B8}" type="presParOf" srcId="{A8D983F0-6F90-4029-A4AD-5DC404D35E48}" destId="{176CA4B5-53D5-4A19-882B-CA93D30E2B54}" srcOrd="0" destOrd="0" presId="urn:microsoft.com/office/officeart/2005/8/layout/orgChart1"/>
    <dgm:cxn modelId="{E50F9289-E4C0-4B00-A52A-B7B2D00E257F}" type="presParOf" srcId="{A8D983F0-6F90-4029-A4AD-5DC404D35E48}" destId="{118CB755-FE25-49D7-BEB7-208BDD57F82D}" srcOrd="1" destOrd="0" presId="urn:microsoft.com/office/officeart/2005/8/layout/orgChart1"/>
    <dgm:cxn modelId="{C0D8F01A-37EF-4B91-9AF1-21B30423950A}" type="presParOf" srcId="{118CB755-FE25-49D7-BEB7-208BDD57F82D}" destId="{B4644DC4-2B7D-4DBB-950A-3FDDF83FAF23}" srcOrd="0" destOrd="0" presId="urn:microsoft.com/office/officeart/2005/8/layout/orgChart1"/>
    <dgm:cxn modelId="{2C45B43D-254C-48F3-B383-3ABE42512F20}" type="presParOf" srcId="{B4644DC4-2B7D-4DBB-950A-3FDDF83FAF23}" destId="{B9FBD0DF-1994-4756-9C31-863763F81800}" srcOrd="0" destOrd="0" presId="urn:microsoft.com/office/officeart/2005/8/layout/orgChart1"/>
    <dgm:cxn modelId="{01AC0229-F8AD-4853-8555-E34266F912B3}" type="presParOf" srcId="{B4644DC4-2B7D-4DBB-950A-3FDDF83FAF23}" destId="{0A24AA5B-B2AF-4C93-B25A-71752901D584}" srcOrd="1" destOrd="0" presId="urn:microsoft.com/office/officeart/2005/8/layout/orgChart1"/>
    <dgm:cxn modelId="{BE97B17B-93C1-47F0-8186-A05AF20E0230}" type="presParOf" srcId="{118CB755-FE25-49D7-BEB7-208BDD57F82D}" destId="{BD0DDED8-D924-45AD-A6B2-30DC8C8D05CC}" srcOrd="1" destOrd="0" presId="urn:microsoft.com/office/officeart/2005/8/layout/orgChart1"/>
    <dgm:cxn modelId="{1DCD8C42-C2E8-48F1-82E7-AE745AD0D1EF}" type="presParOf" srcId="{BD0DDED8-D924-45AD-A6B2-30DC8C8D05CC}" destId="{B1C87CDF-86FC-43F2-A129-62EAC6215B0C}" srcOrd="0" destOrd="0" presId="urn:microsoft.com/office/officeart/2005/8/layout/orgChart1"/>
    <dgm:cxn modelId="{AD9F99D3-0751-42B5-8B00-B8D22012994B}" type="presParOf" srcId="{BD0DDED8-D924-45AD-A6B2-30DC8C8D05CC}" destId="{147DA07E-414B-47C2-B858-99013B986170}" srcOrd="1" destOrd="0" presId="urn:microsoft.com/office/officeart/2005/8/layout/orgChart1"/>
    <dgm:cxn modelId="{61706ADB-FC32-4FE6-8B55-02B793826A14}" type="presParOf" srcId="{147DA07E-414B-47C2-B858-99013B986170}" destId="{F32ED8C1-489F-4360-8FCB-78175DA21F0A}" srcOrd="0" destOrd="0" presId="urn:microsoft.com/office/officeart/2005/8/layout/orgChart1"/>
    <dgm:cxn modelId="{BB1F9CEC-FD76-4803-AE98-1B49FD9D3FCD}" type="presParOf" srcId="{F32ED8C1-489F-4360-8FCB-78175DA21F0A}" destId="{EB2B9AAD-5B70-4168-B7B8-2B6B1B4EBF89}" srcOrd="0" destOrd="0" presId="urn:microsoft.com/office/officeart/2005/8/layout/orgChart1"/>
    <dgm:cxn modelId="{1C5E962E-6788-40D0-B75F-1EAA495EF60B}" type="presParOf" srcId="{F32ED8C1-489F-4360-8FCB-78175DA21F0A}" destId="{E6D92E72-A03B-41CC-8590-98AAB73B1DD4}" srcOrd="1" destOrd="0" presId="urn:microsoft.com/office/officeart/2005/8/layout/orgChart1"/>
    <dgm:cxn modelId="{BA43DED8-3F22-4B4A-AF08-44E303DDB93F}" type="presParOf" srcId="{147DA07E-414B-47C2-B858-99013B986170}" destId="{A2649C4B-4502-46FD-B33E-64AC2F23377A}" srcOrd="1" destOrd="0" presId="urn:microsoft.com/office/officeart/2005/8/layout/orgChart1"/>
    <dgm:cxn modelId="{4A7755F1-376C-40D9-BC8E-E89FCA3572F8}" type="presParOf" srcId="{A2649C4B-4502-46FD-B33E-64AC2F23377A}" destId="{4932B976-1306-409D-A15E-523C7A699DB3}" srcOrd="0" destOrd="0" presId="urn:microsoft.com/office/officeart/2005/8/layout/orgChart1"/>
    <dgm:cxn modelId="{D8741593-A342-4096-BE2C-0ED32C0E367A}" type="presParOf" srcId="{A2649C4B-4502-46FD-B33E-64AC2F23377A}" destId="{C9E9A1BA-73D1-4BAB-813D-0C1391438890}" srcOrd="1" destOrd="0" presId="urn:microsoft.com/office/officeart/2005/8/layout/orgChart1"/>
    <dgm:cxn modelId="{BEC80E50-E939-41E9-A370-39348832791E}" type="presParOf" srcId="{C9E9A1BA-73D1-4BAB-813D-0C1391438890}" destId="{99F92043-F82F-41F2-9B22-C0FE3BB3E589}" srcOrd="0" destOrd="0" presId="urn:microsoft.com/office/officeart/2005/8/layout/orgChart1"/>
    <dgm:cxn modelId="{571B01FC-F4BE-4D8F-BC11-08852B6040AD}" type="presParOf" srcId="{99F92043-F82F-41F2-9B22-C0FE3BB3E589}" destId="{982014A9-B66D-4A91-9A94-B34D021A57D6}" srcOrd="0" destOrd="0" presId="urn:microsoft.com/office/officeart/2005/8/layout/orgChart1"/>
    <dgm:cxn modelId="{C89D3DC9-8DFC-4808-B92A-E2AA25CB9D35}" type="presParOf" srcId="{99F92043-F82F-41F2-9B22-C0FE3BB3E589}" destId="{57BB588C-E09B-4873-9B57-CDB607CDB60E}" srcOrd="1" destOrd="0" presId="urn:microsoft.com/office/officeart/2005/8/layout/orgChart1"/>
    <dgm:cxn modelId="{73A3FDBC-A3CF-4AE5-8A25-2BB0CFAC8F4D}" type="presParOf" srcId="{C9E9A1BA-73D1-4BAB-813D-0C1391438890}" destId="{26090989-52AA-4810-BC8F-142B4CAB09C5}" srcOrd="1" destOrd="0" presId="urn:microsoft.com/office/officeart/2005/8/layout/orgChart1"/>
    <dgm:cxn modelId="{F88F41E6-ABFC-462F-B9AD-2795D9009BE6}" type="presParOf" srcId="{26090989-52AA-4810-BC8F-142B4CAB09C5}" destId="{DBC4920F-59C1-47AA-9D1E-00F085041438}" srcOrd="0" destOrd="0" presId="urn:microsoft.com/office/officeart/2005/8/layout/orgChart1"/>
    <dgm:cxn modelId="{C5F2D599-2F6E-42CE-BD01-E8B12228B9C7}" type="presParOf" srcId="{26090989-52AA-4810-BC8F-142B4CAB09C5}" destId="{E3209FE3-E625-47D2-88C9-E9C272BF0E88}" srcOrd="1" destOrd="0" presId="urn:microsoft.com/office/officeart/2005/8/layout/orgChart1"/>
    <dgm:cxn modelId="{F7A11881-0AAD-441C-A74B-06C22C0C2262}" type="presParOf" srcId="{E3209FE3-E625-47D2-88C9-E9C272BF0E88}" destId="{49CB69BE-3A26-41C9-8505-D85E1840BB78}" srcOrd="0" destOrd="0" presId="urn:microsoft.com/office/officeart/2005/8/layout/orgChart1"/>
    <dgm:cxn modelId="{1AD7CC71-804B-4A45-9B4D-45DFBD5C8350}" type="presParOf" srcId="{49CB69BE-3A26-41C9-8505-D85E1840BB78}" destId="{B1529871-218B-4228-96AF-5E87ED27CF35}" srcOrd="0" destOrd="0" presId="urn:microsoft.com/office/officeart/2005/8/layout/orgChart1"/>
    <dgm:cxn modelId="{DC610419-B569-4BF3-AA96-0FECD0C64098}" type="presParOf" srcId="{49CB69BE-3A26-41C9-8505-D85E1840BB78}" destId="{2E990F38-BFCC-44AF-9B9D-3E370A3C4103}" srcOrd="1" destOrd="0" presId="urn:microsoft.com/office/officeart/2005/8/layout/orgChart1"/>
    <dgm:cxn modelId="{BC76397D-2424-4B24-B153-4A2AB79B0F93}" type="presParOf" srcId="{E3209FE3-E625-47D2-88C9-E9C272BF0E88}" destId="{A83DFB86-B0D5-4FBE-A355-F758FA12B86C}" srcOrd="1" destOrd="0" presId="urn:microsoft.com/office/officeart/2005/8/layout/orgChart1"/>
    <dgm:cxn modelId="{BDB62EF0-9035-405F-8A86-439E969A2C17}" type="presParOf" srcId="{E3209FE3-E625-47D2-88C9-E9C272BF0E88}" destId="{7F986992-5149-4761-8978-C480C570FB73}" srcOrd="2" destOrd="0" presId="urn:microsoft.com/office/officeart/2005/8/layout/orgChart1"/>
    <dgm:cxn modelId="{BC4256BE-E24E-4075-8E43-BA6E891089FA}" type="presParOf" srcId="{C9E9A1BA-73D1-4BAB-813D-0C1391438890}" destId="{339A8D5F-1C42-4CB9-97A6-2835CA10CF51}" srcOrd="2" destOrd="0" presId="urn:microsoft.com/office/officeart/2005/8/layout/orgChart1"/>
    <dgm:cxn modelId="{CB7345A9-25B1-469E-A9D9-46BEFCE0D6B3}" type="presParOf" srcId="{147DA07E-414B-47C2-B858-99013B986170}" destId="{50572528-FE4D-4A4B-8786-941DEE7981B8}" srcOrd="2" destOrd="0" presId="urn:microsoft.com/office/officeart/2005/8/layout/orgChart1"/>
    <dgm:cxn modelId="{3018537D-D4A7-419A-ABB1-3A89FBE4FCB2}" type="presParOf" srcId="{118CB755-FE25-49D7-BEB7-208BDD57F82D}" destId="{57325153-6F63-47C8-A9BC-8B77CD6CA4CB}" srcOrd="2" destOrd="0" presId="urn:microsoft.com/office/officeart/2005/8/layout/orgChart1"/>
    <dgm:cxn modelId="{C2ACF914-77FD-4BCE-958F-AB67662B3E91}" type="presParOf" srcId="{A8D983F0-6F90-4029-A4AD-5DC404D35E48}" destId="{EEEB0294-43D7-4DF2-809D-7287859C4A8B}" srcOrd="2" destOrd="0" presId="urn:microsoft.com/office/officeart/2005/8/layout/orgChart1"/>
    <dgm:cxn modelId="{CE3E3803-BC1A-4E71-B226-283B10901D2A}" type="presParOf" srcId="{A8D983F0-6F90-4029-A4AD-5DC404D35E48}" destId="{43E83F0E-DE14-4593-B072-6E4D2C6CBCE7}" srcOrd="3" destOrd="0" presId="urn:microsoft.com/office/officeart/2005/8/layout/orgChart1"/>
    <dgm:cxn modelId="{55C10FCB-B5B7-46EE-8C10-A0AC17AFB07D}" type="presParOf" srcId="{43E83F0E-DE14-4593-B072-6E4D2C6CBCE7}" destId="{7779652B-39CC-401B-B419-F9A0B31F4D2E}" srcOrd="0" destOrd="0" presId="urn:microsoft.com/office/officeart/2005/8/layout/orgChart1"/>
    <dgm:cxn modelId="{4B9C1DD9-5F6E-4022-956E-55CF135682A1}" type="presParOf" srcId="{7779652B-39CC-401B-B419-F9A0B31F4D2E}" destId="{F09554AF-D713-43F4-96BF-9D1E57E606EF}" srcOrd="0" destOrd="0" presId="urn:microsoft.com/office/officeart/2005/8/layout/orgChart1"/>
    <dgm:cxn modelId="{CA6BE827-490C-4933-91B3-46DEAD200003}" type="presParOf" srcId="{7779652B-39CC-401B-B419-F9A0B31F4D2E}" destId="{2BCDC47F-573B-4AEA-B870-B5D207594BBD}" srcOrd="1" destOrd="0" presId="urn:microsoft.com/office/officeart/2005/8/layout/orgChart1"/>
    <dgm:cxn modelId="{8CACA322-C005-4F23-BA31-5BC96FA5606C}" type="presParOf" srcId="{43E83F0E-DE14-4593-B072-6E4D2C6CBCE7}" destId="{2AC44685-E275-4158-B3D7-39B3BB557F07}" srcOrd="1" destOrd="0" presId="urn:microsoft.com/office/officeart/2005/8/layout/orgChart1"/>
    <dgm:cxn modelId="{9F10132A-570E-4C2D-919D-1AA0227F0643}" type="presParOf" srcId="{2AC44685-E275-4158-B3D7-39B3BB557F07}" destId="{23A97686-2ABE-4A2B-A347-3C0B0FDC45F4}" srcOrd="0" destOrd="0" presId="urn:microsoft.com/office/officeart/2005/8/layout/orgChart1"/>
    <dgm:cxn modelId="{03E8EAAF-5882-4D34-BAE9-6BF71F101C4C}" type="presParOf" srcId="{2AC44685-E275-4158-B3D7-39B3BB557F07}" destId="{B3C66B93-4733-441A-8A53-9E1FB898DC94}" srcOrd="1" destOrd="0" presId="urn:microsoft.com/office/officeart/2005/8/layout/orgChart1"/>
    <dgm:cxn modelId="{263B448F-DC23-4E11-8139-229138C4256F}" type="presParOf" srcId="{B3C66B93-4733-441A-8A53-9E1FB898DC94}" destId="{0956466F-D1BC-41CA-8C58-9FFFBC9B7FF8}" srcOrd="0" destOrd="0" presId="urn:microsoft.com/office/officeart/2005/8/layout/orgChart1"/>
    <dgm:cxn modelId="{DB81F5C2-5B15-42C7-BCB2-2B444D664620}" type="presParOf" srcId="{0956466F-D1BC-41CA-8C58-9FFFBC9B7FF8}" destId="{41D212A3-AA7A-4E51-8C61-853FFBDE9862}" srcOrd="0" destOrd="0" presId="urn:microsoft.com/office/officeart/2005/8/layout/orgChart1"/>
    <dgm:cxn modelId="{ED548240-224F-45E9-90D1-01B32600E6FE}" type="presParOf" srcId="{0956466F-D1BC-41CA-8C58-9FFFBC9B7FF8}" destId="{F48155F1-1AB5-4564-9DB2-C922D29C0412}" srcOrd="1" destOrd="0" presId="urn:microsoft.com/office/officeart/2005/8/layout/orgChart1"/>
    <dgm:cxn modelId="{5AA80534-0389-4B64-A629-4971F0E456C5}" type="presParOf" srcId="{B3C66B93-4733-441A-8A53-9E1FB898DC94}" destId="{FE67AA03-CC98-44ED-AC2B-CD1EFE8183AF}" srcOrd="1" destOrd="0" presId="urn:microsoft.com/office/officeart/2005/8/layout/orgChart1"/>
    <dgm:cxn modelId="{AA4FAA37-8BBE-4D04-AE41-F3453D748A8F}" type="presParOf" srcId="{FE67AA03-CC98-44ED-AC2B-CD1EFE8183AF}" destId="{1B9BA3AB-EEA9-42C4-B1AC-3832A95639CA}" srcOrd="0" destOrd="0" presId="urn:microsoft.com/office/officeart/2005/8/layout/orgChart1"/>
    <dgm:cxn modelId="{FAC2F6F5-0C72-4010-8EAF-A4D2A902B7F7}" type="presParOf" srcId="{FE67AA03-CC98-44ED-AC2B-CD1EFE8183AF}" destId="{21FCC388-6C1E-427A-A93B-230FCBB5662E}" srcOrd="1" destOrd="0" presId="urn:microsoft.com/office/officeart/2005/8/layout/orgChart1"/>
    <dgm:cxn modelId="{A5EB6E50-87DA-4A7D-8810-A6E68E8DCEBB}" type="presParOf" srcId="{21FCC388-6C1E-427A-A93B-230FCBB5662E}" destId="{44099F3B-F123-4676-AEF9-1BF11AEE377C}" srcOrd="0" destOrd="0" presId="urn:microsoft.com/office/officeart/2005/8/layout/orgChart1"/>
    <dgm:cxn modelId="{AE5745BD-D093-4606-B758-ACB496027E51}" type="presParOf" srcId="{44099F3B-F123-4676-AEF9-1BF11AEE377C}" destId="{DC03FCA1-2108-44CC-B393-29149704164B}" srcOrd="0" destOrd="0" presId="urn:microsoft.com/office/officeart/2005/8/layout/orgChart1"/>
    <dgm:cxn modelId="{555759B6-21A6-4125-9930-9314682885A1}" type="presParOf" srcId="{44099F3B-F123-4676-AEF9-1BF11AEE377C}" destId="{A0A03850-864A-482C-883B-64E910070869}" srcOrd="1" destOrd="0" presId="urn:microsoft.com/office/officeart/2005/8/layout/orgChart1"/>
    <dgm:cxn modelId="{7DB8C253-9819-4C3F-9DAA-4EA1022B7201}" type="presParOf" srcId="{21FCC388-6C1E-427A-A93B-230FCBB5662E}" destId="{B0FA5201-A4E5-49E1-AF34-53175BF2C3AB}" srcOrd="1" destOrd="0" presId="urn:microsoft.com/office/officeart/2005/8/layout/orgChart1"/>
    <dgm:cxn modelId="{FB0AA83E-B4F0-4D83-9286-93D38F02F460}" type="presParOf" srcId="{B0FA5201-A4E5-49E1-AF34-53175BF2C3AB}" destId="{5E476DFA-B7F7-4B0C-AA45-60FDF6617330}" srcOrd="0" destOrd="0" presId="urn:microsoft.com/office/officeart/2005/8/layout/orgChart1"/>
    <dgm:cxn modelId="{757F979C-6A1E-44A6-BB9A-169BBC1B3663}" type="presParOf" srcId="{B0FA5201-A4E5-49E1-AF34-53175BF2C3AB}" destId="{55AC38E1-9552-4F44-BA80-3F48C582D626}" srcOrd="1" destOrd="0" presId="urn:microsoft.com/office/officeart/2005/8/layout/orgChart1"/>
    <dgm:cxn modelId="{CEEE994A-81AA-449C-A735-6530863A22D3}" type="presParOf" srcId="{55AC38E1-9552-4F44-BA80-3F48C582D626}" destId="{926F0D43-AF22-4A5A-B7C8-AA4ECC111C63}" srcOrd="0" destOrd="0" presId="urn:microsoft.com/office/officeart/2005/8/layout/orgChart1"/>
    <dgm:cxn modelId="{35966F43-F4D2-4AF8-BC95-4D8F627C21A1}" type="presParOf" srcId="{926F0D43-AF22-4A5A-B7C8-AA4ECC111C63}" destId="{FA7B853B-736E-4B1D-B69F-0D470A71E34E}" srcOrd="0" destOrd="0" presId="urn:microsoft.com/office/officeart/2005/8/layout/orgChart1"/>
    <dgm:cxn modelId="{A5EFCC1E-D0FA-4132-A132-B3572B66394C}" type="presParOf" srcId="{926F0D43-AF22-4A5A-B7C8-AA4ECC111C63}" destId="{5BC947BC-DC15-429C-AAD4-B90FB95105CC}" srcOrd="1" destOrd="0" presId="urn:microsoft.com/office/officeart/2005/8/layout/orgChart1"/>
    <dgm:cxn modelId="{C859CE2E-1098-4093-96B8-9250D1A3C6E3}" type="presParOf" srcId="{55AC38E1-9552-4F44-BA80-3F48C582D626}" destId="{76B0BD3B-D873-4DE7-BD90-A8F0B5168985}" srcOrd="1" destOrd="0" presId="urn:microsoft.com/office/officeart/2005/8/layout/orgChart1"/>
    <dgm:cxn modelId="{6930E844-5454-4B3F-A3B2-8DE74BF1FA03}" type="presParOf" srcId="{55AC38E1-9552-4F44-BA80-3F48C582D626}" destId="{53AF8FAF-4F4E-4CD8-920F-FBB1CFA02BA1}" srcOrd="2" destOrd="0" presId="urn:microsoft.com/office/officeart/2005/8/layout/orgChart1"/>
    <dgm:cxn modelId="{8C30A4C3-2C05-49FC-B04F-A27F47A1F904}" type="presParOf" srcId="{21FCC388-6C1E-427A-A93B-230FCBB5662E}" destId="{17C9584C-B295-4F7C-9968-F927012DB5E7}" srcOrd="2" destOrd="0" presId="urn:microsoft.com/office/officeart/2005/8/layout/orgChart1"/>
    <dgm:cxn modelId="{4A234FBB-486C-48D4-B21B-094D4A7604A1}" type="presParOf" srcId="{B3C66B93-4733-441A-8A53-9E1FB898DC94}" destId="{326A0441-8363-4B56-9C4E-70A11CD68643}" srcOrd="2" destOrd="0" presId="urn:microsoft.com/office/officeart/2005/8/layout/orgChart1"/>
    <dgm:cxn modelId="{341574D3-BD42-4DF6-BA13-7E7A62B4FD52}" type="presParOf" srcId="{2AC44685-E275-4158-B3D7-39B3BB557F07}" destId="{FDA89364-3858-468A-AAA2-805A72E62C8D}" srcOrd="2" destOrd="0" presId="urn:microsoft.com/office/officeart/2005/8/layout/orgChart1"/>
    <dgm:cxn modelId="{C7E28086-1BA4-4538-9E3A-088A3F1CA8B8}" type="presParOf" srcId="{2AC44685-E275-4158-B3D7-39B3BB557F07}" destId="{674480B6-9449-4DB2-8F58-A1EC92F6BC96}" srcOrd="3" destOrd="0" presId="urn:microsoft.com/office/officeart/2005/8/layout/orgChart1"/>
    <dgm:cxn modelId="{AF21929E-D951-4B9F-8850-29FA7E0BD4E9}" type="presParOf" srcId="{674480B6-9449-4DB2-8F58-A1EC92F6BC96}" destId="{E0DF3BF3-1C58-46CC-B5EA-1D0085E5191A}" srcOrd="0" destOrd="0" presId="urn:microsoft.com/office/officeart/2005/8/layout/orgChart1"/>
    <dgm:cxn modelId="{BFC70C60-E19F-40AB-8F8B-3EC030A9B562}" type="presParOf" srcId="{E0DF3BF3-1C58-46CC-B5EA-1D0085E5191A}" destId="{E03A8F3E-0B6B-42A6-96D6-74098ED27472}" srcOrd="0" destOrd="0" presId="urn:microsoft.com/office/officeart/2005/8/layout/orgChart1"/>
    <dgm:cxn modelId="{9A96A494-16FD-4060-BF64-F20EF1BBF419}" type="presParOf" srcId="{E0DF3BF3-1C58-46CC-B5EA-1D0085E5191A}" destId="{9CAC91B5-9D4D-4B08-9424-A84660773813}" srcOrd="1" destOrd="0" presId="urn:microsoft.com/office/officeart/2005/8/layout/orgChart1"/>
    <dgm:cxn modelId="{4291D844-0ACC-4D9D-8B0A-F93B7D4E970A}" type="presParOf" srcId="{674480B6-9449-4DB2-8F58-A1EC92F6BC96}" destId="{3A75446C-C465-44AC-894B-A12600176C5B}" srcOrd="1" destOrd="0" presId="urn:microsoft.com/office/officeart/2005/8/layout/orgChart1"/>
    <dgm:cxn modelId="{CDE39101-44C2-4895-8C2E-44DB9A2FFAFD}" type="presParOf" srcId="{3A75446C-C465-44AC-894B-A12600176C5B}" destId="{FBF831EA-AFE1-4409-9A43-97513AC38993}" srcOrd="0" destOrd="0" presId="urn:microsoft.com/office/officeart/2005/8/layout/orgChart1"/>
    <dgm:cxn modelId="{0A183A4E-EE19-49F7-BC89-1C5F0A2DD7C4}" type="presParOf" srcId="{3A75446C-C465-44AC-894B-A12600176C5B}" destId="{725C4396-222F-40D0-AEC0-9B0FD802BCE3}" srcOrd="1" destOrd="0" presId="urn:microsoft.com/office/officeart/2005/8/layout/orgChart1"/>
    <dgm:cxn modelId="{03012664-5B4C-404E-963F-C86C737F7B91}" type="presParOf" srcId="{725C4396-222F-40D0-AEC0-9B0FD802BCE3}" destId="{8116EC53-7597-432F-A4B3-0AB3ACED5ADC}" srcOrd="0" destOrd="0" presId="urn:microsoft.com/office/officeart/2005/8/layout/orgChart1"/>
    <dgm:cxn modelId="{4EDB79B3-2409-4244-A829-ED5867F5E503}" type="presParOf" srcId="{8116EC53-7597-432F-A4B3-0AB3ACED5ADC}" destId="{52617DA3-E456-449C-B04D-8FC6AF54F07C}" srcOrd="0" destOrd="0" presId="urn:microsoft.com/office/officeart/2005/8/layout/orgChart1"/>
    <dgm:cxn modelId="{38E0CD75-17B7-4C4A-B5AA-DF3AB671AF26}" type="presParOf" srcId="{8116EC53-7597-432F-A4B3-0AB3ACED5ADC}" destId="{EFEF9B43-01BE-4302-91F7-0416C0A0E2D2}" srcOrd="1" destOrd="0" presId="urn:microsoft.com/office/officeart/2005/8/layout/orgChart1"/>
    <dgm:cxn modelId="{E18815D2-EA86-4491-94A7-D933B0C21E3B}" type="presParOf" srcId="{725C4396-222F-40D0-AEC0-9B0FD802BCE3}" destId="{390CEB9C-53F2-4120-9EDE-74CE37EB1ED0}" srcOrd="1" destOrd="0" presId="urn:microsoft.com/office/officeart/2005/8/layout/orgChart1"/>
    <dgm:cxn modelId="{8457979D-EA04-4015-A980-02EFBDF1BC26}" type="presParOf" srcId="{725C4396-222F-40D0-AEC0-9B0FD802BCE3}" destId="{7D6E6A17-17CB-46ED-8E3B-D7FF40E9EF91}" srcOrd="2" destOrd="0" presId="urn:microsoft.com/office/officeart/2005/8/layout/orgChart1"/>
    <dgm:cxn modelId="{D85EC37E-02C8-4B9B-8113-87B14B62BC0A}" type="presParOf" srcId="{674480B6-9449-4DB2-8F58-A1EC92F6BC96}" destId="{A5053507-E841-4391-9783-90FC865819EE}" srcOrd="2" destOrd="0" presId="urn:microsoft.com/office/officeart/2005/8/layout/orgChart1"/>
    <dgm:cxn modelId="{C2D6FCB9-645F-4735-A848-E88D559FDE23}" type="presParOf" srcId="{43E83F0E-DE14-4593-B072-6E4D2C6CBCE7}" destId="{C396340B-E962-4EC9-BC98-48776F6C5407}" srcOrd="2" destOrd="0" presId="urn:microsoft.com/office/officeart/2005/8/layout/orgChart1"/>
    <dgm:cxn modelId="{C8AEA9FC-74F9-4B43-B9D6-171648BC80B6}" type="presParOf" srcId="{2653B149-E122-44B8-9E77-B00E40D15E4B}" destId="{86ED8E28-5DF1-467A-8E9F-0254FB5D444E}" srcOrd="2" destOrd="0" presId="urn:microsoft.com/office/officeart/2005/8/layout/orgChart1"/>
    <dgm:cxn modelId="{CD0E153C-B851-415D-884D-43C92F219F1A}" type="presParOf" srcId="{0093C735-6F08-4E25-9698-674EFEE96BEA}" destId="{F223EC6E-243A-4E43-8E99-4052815252FF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13E58C4D-AAB1-4085-A3AF-1C1E950B5058}" type="doc">
      <dgm:prSet loTypeId="urn:microsoft.com/office/officeart/2005/8/layout/orgChart1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US"/>
        </a:p>
      </dgm:t>
    </dgm:pt>
    <dgm:pt modelId="{FF8F8B10-1A05-4657-A6DB-975C869102E1}">
      <dgm:prSet phldrT="[Text]" custT="1"/>
      <dgm:spPr>
        <a:xfrm>
          <a:off x="2496776" y="1817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&lt;33 wks and vigorous in DR</a:t>
          </a:r>
        </a:p>
      </dgm:t>
    </dgm:pt>
    <dgm:pt modelId="{91E0B00C-AC89-4C08-AE0A-88264323875C}" type="parTrans" cxnId="{D5467CEA-AEFD-46EC-A425-48A10BD076BA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85E3AF5-CF82-4E73-A4F5-BFF98AF5BF2C}" type="sibTrans" cxnId="{D5467CEA-AEFD-46EC-A425-48A10BD076BA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A369978-7617-4015-9EEC-A63A54FEF33F}">
      <dgm:prSet phldrT="[Text]" custT="1"/>
      <dgm:spPr>
        <a:xfrm>
          <a:off x="1058860" y="827675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&lt;30 wks</a:t>
          </a:r>
        </a:p>
      </dgm:t>
    </dgm:pt>
    <dgm:pt modelId="{55CBABE7-7C84-43ED-9EDC-3D9098F08110}" type="parTrans" cxnId="{C03B5337-832E-4947-BF07-157A9D1A54C7}">
      <dgm:prSet/>
      <dgm:spPr>
        <a:xfrm>
          <a:off x="1640451" y="583407"/>
          <a:ext cx="1437915" cy="244267"/>
        </a:xfrm>
        <a:custGeom>
          <a:avLst/>
          <a:gdLst/>
          <a:ahLst/>
          <a:cxnLst/>
          <a:rect l="0" t="0" r="0" b="0"/>
          <a:pathLst>
            <a:path>
              <a:moveTo>
                <a:pt x="1437915" y="0"/>
              </a:moveTo>
              <a:lnTo>
                <a:pt x="1437915" y="122133"/>
              </a:lnTo>
              <a:lnTo>
                <a:pt x="0" y="122133"/>
              </a:lnTo>
              <a:lnTo>
                <a:pt x="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C543AC7-49DA-44F7-9943-EDFBE9B49DE2}" type="sibTrans" cxnId="{C03B5337-832E-4947-BF07-157A9D1A54C7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E298A2F-377F-4C5A-9DA6-A854F892FDFE}">
      <dgm:prSet phldrT="[Text]" custT="1"/>
      <dgm:spPr>
        <a:xfrm>
          <a:off x="3934691" y="827675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30+0 - 32+6 wks</a:t>
          </a:r>
        </a:p>
      </dgm:t>
    </dgm:pt>
    <dgm:pt modelId="{79358810-750E-4E9F-A86D-31A8C2155268}" type="parTrans" cxnId="{73FBB1DE-0717-4D17-A879-2F834E247369}">
      <dgm:prSet/>
      <dgm:spPr>
        <a:xfrm>
          <a:off x="3078366" y="583407"/>
          <a:ext cx="1437915" cy="244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2133"/>
              </a:lnTo>
              <a:lnTo>
                <a:pt x="1437915" y="122133"/>
              </a:lnTo>
              <a:lnTo>
                <a:pt x="1437915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98CB2AA-A63A-4D4E-8475-8EA5B843DE32}" type="sibTrans" cxnId="{73FBB1DE-0717-4D17-A879-2F834E24736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FC8376F-613B-41FC-827D-EF14F383F6D4}">
      <dgm:prSet phldrT="[Text]" custT="1"/>
      <dgm:spPr>
        <a:xfrm>
          <a:off x="3085569" y="1653533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No respiratory distress</a:t>
          </a:r>
        </a:p>
      </dgm:t>
    </dgm:pt>
    <dgm:pt modelId="{85B1BB08-F3ED-4F9B-A7AC-A783C01BA4CA}" type="parTrans" cxnId="{BCFDB264-7F40-4500-94E3-DF679E249F45}">
      <dgm:prSet/>
      <dgm:spPr>
        <a:xfrm>
          <a:off x="3667159" y="1409266"/>
          <a:ext cx="849121" cy="244267"/>
        </a:xfrm>
        <a:custGeom>
          <a:avLst/>
          <a:gdLst/>
          <a:ahLst/>
          <a:cxnLst/>
          <a:rect l="0" t="0" r="0" b="0"/>
          <a:pathLst>
            <a:path>
              <a:moveTo>
                <a:pt x="849121" y="0"/>
              </a:moveTo>
              <a:lnTo>
                <a:pt x="849121" y="122133"/>
              </a:lnTo>
              <a:lnTo>
                <a:pt x="0" y="122133"/>
              </a:lnTo>
              <a:lnTo>
                <a:pt x="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46FA024-9F52-463B-8AA6-955412A354DE}" type="sibTrans" cxnId="{BCFDB264-7F40-4500-94E3-DF679E249F45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00CADD1-C14C-4AA3-B63D-2FB9016CAE94}">
      <dgm:prSet phldrT="[Text]" custT="1"/>
      <dgm:spPr>
        <a:xfrm>
          <a:off x="4783813" y="1653533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Any respiratory distress</a:t>
          </a:r>
        </a:p>
      </dgm:t>
    </dgm:pt>
    <dgm:pt modelId="{A199DCC7-F65E-4F6C-B747-FB3FBCBEB0B7}" type="parTrans" cxnId="{C525FC21-D800-4EB8-952C-FC6027982D4E}">
      <dgm:prSet/>
      <dgm:spPr>
        <a:xfrm>
          <a:off x="4516281" y="1409266"/>
          <a:ext cx="849121" cy="244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2133"/>
              </a:lnTo>
              <a:lnTo>
                <a:pt x="849121" y="122133"/>
              </a:lnTo>
              <a:lnTo>
                <a:pt x="849121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5502509-D7A0-456C-B7ED-24BA9970F12F}" type="sibTrans" cxnId="{C525FC21-D800-4EB8-952C-FC6027982D4E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3C4A683-5925-43C9-AB86-E8210F1F7AF5}">
      <dgm:prSet phldrT="[Text]" custT="1"/>
      <dgm:spPr>
        <a:xfrm>
          <a:off x="3376364" y="247939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ntinue RA</a:t>
          </a:r>
        </a:p>
      </dgm:t>
    </dgm:pt>
    <dgm:pt modelId="{8E53683D-2C51-4DAD-A311-ECD00C280D9F}" type="parTrans" cxnId="{E26C6125-B54C-49D0-9A8E-E1C5A31A3E27}">
      <dgm:prSet/>
      <dgm:spPr>
        <a:xfrm>
          <a:off x="3201887" y="2235124"/>
          <a:ext cx="174477" cy="53506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35063"/>
              </a:lnTo>
              <a:lnTo>
                <a:pt x="174477" y="535063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0E05D63-ADCC-47E8-AEAC-E15155395A17}" type="sibTrans" cxnId="{E26C6125-B54C-49D0-9A8E-E1C5A31A3E27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761D75F-B57D-44D7-B331-E18F28B5B8C4}">
      <dgm:prSet phldrT="[Text]" custT="1"/>
      <dgm:spPr>
        <a:xfrm>
          <a:off x="4783813" y="247939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bCPAP as soon as distress begins</a:t>
          </a:r>
        </a:p>
      </dgm:t>
    </dgm:pt>
    <dgm:pt modelId="{1475DF99-894F-45BB-B64F-B5E80A8879DF}" type="parTrans" cxnId="{89CBC2BA-691D-4279-A141-8B19CDC15B9A}">
      <dgm:prSet/>
      <dgm:spPr>
        <a:xfrm>
          <a:off x="5319683" y="2235124"/>
          <a:ext cx="91440" cy="24426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E2AB1A1-9F29-4299-B1BB-1E67C5D60B19}" type="sibTrans" cxnId="{89CBC2BA-691D-4279-A141-8B19CDC15B9A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48E438E-8D59-4080-B4D2-33A3EBBEB425}">
      <dgm:prSet phldrT="[Text]" custT="1"/>
      <dgm:spPr>
        <a:xfrm>
          <a:off x="1058860" y="1653533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bCPAP in DR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</a:t>
          </a:r>
        </a:p>
      </dgm:t>
    </dgm:pt>
    <dgm:pt modelId="{38C68CED-5900-4444-A22A-934FEE4D29B2}" type="parTrans" cxnId="{007CF181-D790-4119-B736-A0086A2C2BDE}">
      <dgm:prSet/>
      <dgm:spPr>
        <a:xfrm>
          <a:off x="1594731" y="1409266"/>
          <a:ext cx="91440" cy="24426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1304F14-EE7D-44A2-B410-33E82C05CF23}" type="sibTrans" cxnId="{007CF181-D790-4119-B736-A0086A2C2BDE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CD5F3DB-5E12-4C8E-83B4-2C084C60E153}">
      <dgm:prSet phldrT="[Text]" custT="1"/>
      <dgm:spPr>
        <a:xfrm>
          <a:off x="355136" y="247939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tubate if meets criteria and give surfactant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</a:t>
          </a:r>
        </a:p>
      </dgm:t>
    </dgm:pt>
    <dgm:pt modelId="{C84046E8-30BD-4605-92AD-411E04CD1A7B}" type="parTrans" cxnId="{2C7F980B-F9CE-460C-AAD2-A2718D9E4B4D}">
      <dgm:prSet/>
      <dgm:spPr>
        <a:xfrm>
          <a:off x="936726" y="2235124"/>
          <a:ext cx="703724" cy="244267"/>
        </a:xfrm>
        <a:custGeom>
          <a:avLst/>
          <a:gdLst/>
          <a:ahLst/>
          <a:cxnLst/>
          <a:rect l="0" t="0" r="0" b="0"/>
          <a:pathLst>
            <a:path>
              <a:moveTo>
                <a:pt x="703724" y="0"/>
              </a:moveTo>
              <a:lnTo>
                <a:pt x="703724" y="122133"/>
              </a:lnTo>
              <a:lnTo>
                <a:pt x="0" y="122133"/>
              </a:lnTo>
              <a:lnTo>
                <a:pt x="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8346438-209A-4B61-9255-640A26940A48}" type="sibTrans" cxnId="{2C7F980B-F9CE-460C-AAD2-A2718D9E4B4D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DAA99C6-C743-4C4F-AF02-C6046061547E}">
      <dgm:prSet phldrT="[Text]" custT="1"/>
      <dgm:spPr>
        <a:xfrm>
          <a:off x="1762585" y="247939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ntinue bCPAP</a:t>
          </a:r>
        </a:p>
      </dgm:t>
    </dgm:pt>
    <dgm:pt modelId="{6904EFD8-FCC9-4362-8F06-D20345E1F52D}" type="parTrans" cxnId="{0BBF41F5-6AAC-4AB0-AE12-049181392B49}">
      <dgm:prSet/>
      <dgm:spPr>
        <a:xfrm>
          <a:off x="1640451" y="2235124"/>
          <a:ext cx="703724" cy="244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2133"/>
              </a:lnTo>
              <a:lnTo>
                <a:pt x="703724" y="122133"/>
              </a:lnTo>
              <a:lnTo>
                <a:pt x="703724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AB1861C-0674-4972-A042-8F996A465763}" type="sibTrans" cxnId="{0BBF41F5-6AAC-4AB0-AE12-049181392B4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4E45BD8-A30E-4F63-92EB-E022E1A1E217}">
      <dgm:prSet phldrT="[Text]" custT="1"/>
      <dgm:spPr>
        <a:xfrm>
          <a:off x="352484" y="3298550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on SIMV/VG, HFOV or Jet if needed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</a:t>
          </a:r>
        </a:p>
      </dgm:t>
    </dgm:pt>
    <dgm:pt modelId="{5BD6E1A2-3370-4BA2-8FA5-5D8F554FD060}" type="parTrans" cxnId="{59CD239B-EED0-450A-987B-A6B943A10039}">
      <dgm:prSet/>
      <dgm:spPr>
        <a:xfrm>
          <a:off x="888354" y="3060982"/>
          <a:ext cx="91440" cy="237568"/>
        </a:xfrm>
        <a:custGeom>
          <a:avLst/>
          <a:gdLst/>
          <a:ahLst/>
          <a:cxnLst/>
          <a:rect l="0" t="0" r="0" b="0"/>
          <a:pathLst>
            <a:path>
              <a:moveTo>
                <a:pt x="48372" y="0"/>
              </a:moveTo>
              <a:lnTo>
                <a:pt x="48372" y="115434"/>
              </a:lnTo>
              <a:lnTo>
                <a:pt x="45720" y="115434"/>
              </a:lnTo>
              <a:lnTo>
                <a:pt x="45720" y="237568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111840D-327F-44F2-BECD-38700DC1FEE7}" type="sibTrans" cxnId="{59CD239B-EED0-450A-987B-A6B943A1003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FB1F9C0-C650-4E42-8480-B212E015433D}">
      <dgm:prSet phldrT="[Text]" custT="1"/>
      <dgm:spPr>
        <a:xfrm>
          <a:off x="2027313" y="4868961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gm:t>
    </dgm:pt>
    <dgm:pt modelId="{3ABCA396-4BE5-4F69-B333-DF5A1BE918E7}" type="parTrans" cxnId="{8F21DDCE-54A2-4878-AD25-CA2E4BB88E63}">
      <dgm:prSet/>
      <dgm:spPr>
        <a:xfrm>
          <a:off x="1878903" y="3060982"/>
          <a:ext cx="148410" cy="209877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098773"/>
              </a:lnTo>
              <a:lnTo>
                <a:pt x="148410" y="2098773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C6428CB-0682-4F8E-B7C9-A16AC15C8A95}" type="sibTrans" cxnId="{8F21DDCE-54A2-4878-AD25-CA2E4BB88E63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FC83D10-DBE6-4520-84AC-B5411B1C8627}">
      <dgm:prSet phldrT="[Text]" custT="1"/>
      <dgm:spPr>
        <a:xfrm>
          <a:off x="3460828" y="3305250"/>
          <a:ext cx="240170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tubate if subsequently criteria and give surfactant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</a:t>
          </a:r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; start on SIMV/VG, HFOV or Jet as needed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</a:t>
          </a:r>
        </a:p>
      </dgm:t>
    </dgm:pt>
    <dgm:pt modelId="{DCE2C748-9943-4874-8A80-1BA380733CBC}" type="parTrans" cxnId="{3C65B840-BE1D-46A1-B60C-607E101854CE}">
      <dgm:prSet/>
      <dgm:spPr>
        <a:xfrm>
          <a:off x="4661679" y="3060982"/>
          <a:ext cx="703724" cy="244267"/>
        </a:xfrm>
        <a:custGeom>
          <a:avLst/>
          <a:gdLst/>
          <a:ahLst/>
          <a:cxnLst/>
          <a:rect l="0" t="0" r="0" b="0"/>
          <a:pathLst>
            <a:path>
              <a:moveTo>
                <a:pt x="703724" y="0"/>
              </a:moveTo>
              <a:lnTo>
                <a:pt x="703724" y="122133"/>
              </a:lnTo>
              <a:lnTo>
                <a:pt x="0" y="122133"/>
              </a:lnTo>
              <a:lnTo>
                <a:pt x="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D753A95-B092-4A5F-86DD-D77D98806E21}" type="sibTrans" cxnId="{3C65B840-BE1D-46A1-B60C-607E101854CE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58B3FA0-1A00-4058-A584-9E3A4B6CFB95}">
      <dgm:prSet phldrT="[Text]" custT="1"/>
      <dgm:spPr>
        <a:xfrm>
          <a:off x="6106797" y="3305250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ntinue bCPAP</a:t>
          </a:r>
        </a:p>
      </dgm:t>
    </dgm:pt>
    <dgm:pt modelId="{0353E4CA-5DA6-4706-8469-C14E4D6705B2}" type="parTrans" cxnId="{F5E94612-EE0B-482C-8213-CA483E14B3C4}">
      <dgm:prSet/>
      <dgm:spPr>
        <a:xfrm>
          <a:off x="5365403" y="3060982"/>
          <a:ext cx="1322984" cy="244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2133"/>
              </a:lnTo>
              <a:lnTo>
                <a:pt x="1322984" y="122133"/>
              </a:lnTo>
              <a:lnTo>
                <a:pt x="1322984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6CFF985-92A2-4773-BF58-D44000283468}" type="sibTrans" cxnId="{F5E94612-EE0B-482C-8213-CA483E14B3C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8CCAAA3-86AC-4434-948B-B01D3BB1C02A}">
      <dgm:prSet phldrT="[Text]" custT="1"/>
      <dgm:spPr>
        <a:xfrm>
          <a:off x="4080088" y="4131108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xtubate to bCPAP when meets criteria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</a:t>
          </a:r>
        </a:p>
      </dgm:t>
    </dgm:pt>
    <dgm:pt modelId="{71D572E1-46D3-4EE7-97AE-0205159016D8}" type="parTrans" cxnId="{69AFCAC6-C4E4-4B88-9E9E-E6F6094FE2A4}">
      <dgm:prSet/>
      <dgm:spPr>
        <a:xfrm>
          <a:off x="4615959" y="3886841"/>
          <a:ext cx="91440" cy="24426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596BFAE-DC56-4C15-A159-310EFF4B3728}" type="sibTrans" cxnId="{69AFCAC6-C4E4-4B88-9E9E-E6F6094FE2A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2ABDE10-7240-4297-8E4A-25FBA1E36AA4}">
      <dgm:prSet phldrT="[Text]" custT="1"/>
      <dgm:spPr>
        <a:xfrm>
          <a:off x="4356123" y="487303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gm:t>
    </dgm:pt>
    <dgm:pt modelId="{A656F677-D583-486F-AEA5-FC5F6CF15C79}" type="parTrans" cxnId="{0BC5C0EA-BD10-43F2-882F-3316AA4FD891}">
      <dgm:prSet/>
      <dgm:spPr>
        <a:xfrm>
          <a:off x="4196407" y="4712699"/>
          <a:ext cx="159716" cy="45112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451128"/>
              </a:lnTo>
              <a:lnTo>
                <a:pt x="159716" y="451128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B7AE2B2-91AF-4A43-A3A0-4AC86E7E65BA}" type="sibTrans" cxnId="{0BC5C0EA-BD10-43F2-882F-3316AA4FD891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88BA2AE-1AEF-4C47-9BA9-D6761F2FE84B}">
      <dgm:prSet phldrT="[Text]" custT="1"/>
      <dgm:spPr>
        <a:xfrm>
          <a:off x="6406781" y="4878376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gm:t>
    </dgm:pt>
    <dgm:pt modelId="{5F1BFEE2-C1CD-4275-AC77-5700C1EE7A2D}" type="parTrans" cxnId="{7FE422AF-8FAB-4F5D-846B-5E87A525ED70}">
      <dgm:prSet/>
      <dgm:spPr>
        <a:xfrm>
          <a:off x="6223115" y="3886841"/>
          <a:ext cx="183666" cy="128233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82331"/>
              </a:lnTo>
              <a:lnTo>
                <a:pt x="183666" y="1282331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2BF3AF5-51D6-4E62-AAEC-CC251C2C5B44}" type="sibTrans" cxnId="{7FE422AF-8FAB-4F5D-846B-5E87A525ED70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EAF7C20-CBAE-4D32-A9CB-6E52C4C3E071}">
      <dgm:prSet phldrT="[Text]" custT="1"/>
      <dgm:spPr>
        <a:xfrm>
          <a:off x="355136" y="4131108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ysClr val="windowText" lastClr="000000">
              <a:shade val="80000"/>
              <a:hueOff val="0"/>
              <a:satOff val="0"/>
              <a:lumOff val="0"/>
            </a:sysClr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xtubate to bCPAP when meets criteria</a:t>
          </a:r>
          <a:r>
            <a:rPr lang="en-US" sz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</a:t>
          </a:r>
        </a:p>
      </dgm:t>
    </dgm:pt>
    <dgm:pt modelId="{270C3E90-0605-4A24-8731-391097A12A8E}" type="parTrans" cxnId="{9145C4A0-385B-42F3-BAE2-86FE7CCF2B8D}">
      <dgm:prSet/>
      <dgm:spPr>
        <a:xfrm>
          <a:off x="888354" y="3880141"/>
          <a:ext cx="91440" cy="25096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128833"/>
              </a:lnTo>
              <a:lnTo>
                <a:pt x="48372" y="128833"/>
              </a:lnTo>
              <a:lnTo>
                <a:pt x="48372" y="2509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371B091-8FCA-4F11-97A3-9A0A2D0B50DD}" type="sibTrans" cxnId="{9145C4A0-385B-42F3-BAE2-86FE7CCF2B8D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DA2A610-C40F-4E24-9E38-B25DD89570FB}">
      <dgm:prSet phldrT="[Text]" custT="1"/>
      <dgm:spPr>
        <a:xfrm>
          <a:off x="631170" y="487303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r>
            <a:rPr lang="en-US" sz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gm:t>
    </dgm:pt>
    <dgm:pt modelId="{B68430D6-70B9-474D-8DEF-16DD3B788079}" type="parTrans" cxnId="{EAA20D9B-39E7-4BB5-B8A6-CE9B8F79E7A0}">
      <dgm:prSet/>
      <dgm:spPr>
        <a:xfrm>
          <a:off x="471454" y="4712699"/>
          <a:ext cx="159716" cy="45112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451128"/>
              </a:lnTo>
              <a:lnTo>
                <a:pt x="159716" y="451128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gm:spPr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94BABCF-5140-43D2-B10C-E7BDCB69FC21}" type="sibTrans" cxnId="{EAA20D9B-39E7-4BB5-B8A6-CE9B8F79E7A0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05E5FAD-4BA7-4437-9BDF-36E798017B76}" type="pres">
      <dgm:prSet presAssocID="{13E58C4D-AAB1-4085-A3AF-1C1E950B5058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32030AD7-342B-4098-9CFB-B19B60A845D3}" type="pres">
      <dgm:prSet presAssocID="{FF8F8B10-1A05-4657-A6DB-975C869102E1}" presName="hierRoot1" presStyleCnt="0">
        <dgm:presLayoutVars>
          <dgm:hierBranch val="init"/>
        </dgm:presLayoutVars>
      </dgm:prSet>
      <dgm:spPr/>
    </dgm:pt>
    <dgm:pt modelId="{3021BDB3-FE66-4F80-B60F-FA4D81730228}" type="pres">
      <dgm:prSet presAssocID="{FF8F8B10-1A05-4657-A6DB-975C869102E1}" presName="rootComposite1" presStyleCnt="0"/>
      <dgm:spPr/>
    </dgm:pt>
    <dgm:pt modelId="{316F7E75-2C53-44DA-9580-51F22722035A}" type="pres">
      <dgm:prSet presAssocID="{FF8F8B10-1A05-4657-A6DB-975C869102E1}" presName="rootText1" presStyleLbl="node0" presStyleIdx="0" presStyleCnt="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DB0BC28-8ADA-49E3-A694-227E8E4646CC}" type="pres">
      <dgm:prSet presAssocID="{FF8F8B10-1A05-4657-A6DB-975C869102E1}" presName="rootConnector1" presStyleLbl="node1" presStyleIdx="0" presStyleCnt="0"/>
      <dgm:spPr/>
      <dgm:t>
        <a:bodyPr/>
        <a:lstStyle/>
        <a:p>
          <a:endParaRPr lang="en-US"/>
        </a:p>
      </dgm:t>
    </dgm:pt>
    <dgm:pt modelId="{EAA5CF52-EE7A-4C94-B402-696923B6660F}" type="pres">
      <dgm:prSet presAssocID="{FF8F8B10-1A05-4657-A6DB-975C869102E1}" presName="hierChild2" presStyleCnt="0"/>
      <dgm:spPr/>
    </dgm:pt>
    <dgm:pt modelId="{8E25F900-08B2-46B1-B63F-BD507D7D18E6}" type="pres">
      <dgm:prSet presAssocID="{55CBABE7-7C84-43ED-9EDC-3D9098F08110}" presName="Name37" presStyleLbl="parChTrans1D2" presStyleIdx="0" presStyleCnt="2"/>
      <dgm:spPr/>
      <dgm:t>
        <a:bodyPr/>
        <a:lstStyle/>
        <a:p>
          <a:endParaRPr lang="en-US"/>
        </a:p>
      </dgm:t>
    </dgm:pt>
    <dgm:pt modelId="{F6E4A7FB-F43A-455D-B80C-29057CB4594D}" type="pres">
      <dgm:prSet presAssocID="{4A369978-7617-4015-9EEC-A63A54FEF33F}" presName="hierRoot2" presStyleCnt="0">
        <dgm:presLayoutVars>
          <dgm:hierBranch val="init"/>
        </dgm:presLayoutVars>
      </dgm:prSet>
      <dgm:spPr/>
    </dgm:pt>
    <dgm:pt modelId="{A6245810-1C37-43B2-80E3-C4F0D99211DA}" type="pres">
      <dgm:prSet presAssocID="{4A369978-7617-4015-9EEC-A63A54FEF33F}" presName="rootComposite" presStyleCnt="0"/>
      <dgm:spPr/>
    </dgm:pt>
    <dgm:pt modelId="{540EA148-831F-4B59-A5CA-0BC58D7BA3A2}" type="pres">
      <dgm:prSet presAssocID="{4A369978-7617-4015-9EEC-A63A54FEF33F}" presName="rootText" presStyleLbl="node2" presStyleIdx="0" presStyleCnt="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A77AA64-0E26-4AC0-8DF6-A8A9AB145234}" type="pres">
      <dgm:prSet presAssocID="{4A369978-7617-4015-9EEC-A63A54FEF33F}" presName="rootConnector" presStyleLbl="node2" presStyleIdx="0" presStyleCnt="2"/>
      <dgm:spPr/>
      <dgm:t>
        <a:bodyPr/>
        <a:lstStyle/>
        <a:p>
          <a:endParaRPr lang="en-US"/>
        </a:p>
      </dgm:t>
    </dgm:pt>
    <dgm:pt modelId="{317C9588-3999-40F7-B64F-7D1715FA3C83}" type="pres">
      <dgm:prSet presAssocID="{4A369978-7617-4015-9EEC-A63A54FEF33F}" presName="hierChild4" presStyleCnt="0"/>
      <dgm:spPr/>
    </dgm:pt>
    <dgm:pt modelId="{CAF52C0B-CD12-4E72-818C-A64BD411952C}" type="pres">
      <dgm:prSet presAssocID="{38C68CED-5900-4444-A22A-934FEE4D29B2}" presName="Name37" presStyleLbl="parChTrans1D3" presStyleIdx="0" presStyleCnt="3"/>
      <dgm:spPr/>
      <dgm:t>
        <a:bodyPr/>
        <a:lstStyle/>
        <a:p>
          <a:endParaRPr lang="en-US"/>
        </a:p>
      </dgm:t>
    </dgm:pt>
    <dgm:pt modelId="{132B0015-A65D-48B2-BD34-04BF714FC7C6}" type="pres">
      <dgm:prSet presAssocID="{548E438E-8D59-4080-B4D2-33A3EBBEB425}" presName="hierRoot2" presStyleCnt="0">
        <dgm:presLayoutVars>
          <dgm:hierBranch val="init"/>
        </dgm:presLayoutVars>
      </dgm:prSet>
      <dgm:spPr/>
    </dgm:pt>
    <dgm:pt modelId="{AE5745F2-8121-4D16-BD15-0A7D5E2E1102}" type="pres">
      <dgm:prSet presAssocID="{548E438E-8D59-4080-B4D2-33A3EBBEB425}" presName="rootComposite" presStyleCnt="0"/>
      <dgm:spPr/>
    </dgm:pt>
    <dgm:pt modelId="{69AA0C71-1162-4F86-BDD7-A361804246B2}" type="pres">
      <dgm:prSet presAssocID="{548E438E-8D59-4080-B4D2-33A3EBBEB425}" presName="rootText" presStyleLbl="node3" presStyleIdx="0" presStyleCnt="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31C8BB6-BDF6-4F98-A94A-3EA500E39DFA}" type="pres">
      <dgm:prSet presAssocID="{548E438E-8D59-4080-B4D2-33A3EBBEB425}" presName="rootConnector" presStyleLbl="node3" presStyleIdx="0" presStyleCnt="3"/>
      <dgm:spPr/>
      <dgm:t>
        <a:bodyPr/>
        <a:lstStyle/>
        <a:p>
          <a:endParaRPr lang="en-US"/>
        </a:p>
      </dgm:t>
    </dgm:pt>
    <dgm:pt modelId="{70D53545-AD49-48BC-AE6A-6F0812EAE5DD}" type="pres">
      <dgm:prSet presAssocID="{548E438E-8D59-4080-B4D2-33A3EBBEB425}" presName="hierChild4" presStyleCnt="0"/>
      <dgm:spPr/>
    </dgm:pt>
    <dgm:pt modelId="{8C717FC1-4E3E-48F1-AA46-47DD2843595D}" type="pres">
      <dgm:prSet presAssocID="{C84046E8-30BD-4605-92AD-411E04CD1A7B}" presName="Name37" presStyleLbl="parChTrans1D4" presStyleIdx="0" presStyleCnt="13"/>
      <dgm:spPr/>
      <dgm:t>
        <a:bodyPr/>
        <a:lstStyle/>
        <a:p>
          <a:endParaRPr lang="en-US"/>
        </a:p>
      </dgm:t>
    </dgm:pt>
    <dgm:pt modelId="{E23E0C72-3D58-4E8D-9C14-35E8F0A0622E}" type="pres">
      <dgm:prSet presAssocID="{9CD5F3DB-5E12-4C8E-83B4-2C084C60E153}" presName="hierRoot2" presStyleCnt="0">
        <dgm:presLayoutVars>
          <dgm:hierBranch val="init"/>
        </dgm:presLayoutVars>
      </dgm:prSet>
      <dgm:spPr/>
    </dgm:pt>
    <dgm:pt modelId="{5EB56B5C-F9C5-43D3-8418-D17DBFA1DF27}" type="pres">
      <dgm:prSet presAssocID="{9CD5F3DB-5E12-4C8E-83B4-2C084C60E153}" presName="rootComposite" presStyleCnt="0"/>
      <dgm:spPr/>
    </dgm:pt>
    <dgm:pt modelId="{2D0B4369-25A7-4CC0-A231-FD6C16C23C1F}" type="pres">
      <dgm:prSet presAssocID="{9CD5F3DB-5E12-4C8E-83B4-2C084C60E153}" presName="rootText" presStyleLbl="node4" presStyleIdx="0" presStyleCnt="1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82D20FB-EED4-4247-8EA3-2A66D03125FB}" type="pres">
      <dgm:prSet presAssocID="{9CD5F3DB-5E12-4C8E-83B4-2C084C60E153}" presName="rootConnector" presStyleLbl="node4" presStyleIdx="0" presStyleCnt="13"/>
      <dgm:spPr/>
      <dgm:t>
        <a:bodyPr/>
        <a:lstStyle/>
        <a:p>
          <a:endParaRPr lang="en-US"/>
        </a:p>
      </dgm:t>
    </dgm:pt>
    <dgm:pt modelId="{5D9479B4-54C8-4036-B6EB-0B43312DF847}" type="pres">
      <dgm:prSet presAssocID="{9CD5F3DB-5E12-4C8E-83B4-2C084C60E153}" presName="hierChild4" presStyleCnt="0"/>
      <dgm:spPr/>
    </dgm:pt>
    <dgm:pt modelId="{EA154D89-DEA1-42C2-87BD-7D9536AA01AB}" type="pres">
      <dgm:prSet presAssocID="{5BD6E1A2-3370-4BA2-8FA5-5D8F554FD060}" presName="Name37" presStyleLbl="parChTrans1D4" presStyleIdx="1" presStyleCnt="13"/>
      <dgm:spPr/>
      <dgm:t>
        <a:bodyPr/>
        <a:lstStyle/>
        <a:p>
          <a:endParaRPr lang="en-US"/>
        </a:p>
      </dgm:t>
    </dgm:pt>
    <dgm:pt modelId="{2277839E-DD98-482C-B645-156983945008}" type="pres">
      <dgm:prSet presAssocID="{F4E45BD8-A30E-4F63-92EB-E022E1A1E217}" presName="hierRoot2" presStyleCnt="0">
        <dgm:presLayoutVars>
          <dgm:hierBranch val="init"/>
        </dgm:presLayoutVars>
      </dgm:prSet>
      <dgm:spPr/>
    </dgm:pt>
    <dgm:pt modelId="{FE3903D6-8512-45E4-85B1-337A1FEDFE72}" type="pres">
      <dgm:prSet presAssocID="{F4E45BD8-A30E-4F63-92EB-E022E1A1E217}" presName="rootComposite" presStyleCnt="0"/>
      <dgm:spPr/>
    </dgm:pt>
    <dgm:pt modelId="{9A32E1B7-5DCB-4DBA-9DC3-26E913BD054E}" type="pres">
      <dgm:prSet presAssocID="{F4E45BD8-A30E-4F63-92EB-E022E1A1E217}" presName="rootText" presStyleLbl="node4" presStyleIdx="1" presStyleCnt="13" custLinFactNeighborX="-228" custLinFactNeighborY="-115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34C71B0-A2E1-4840-BDCF-79E599AFF9FA}" type="pres">
      <dgm:prSet presAssocID="{F4E45BD8-A30E-4F63-92EB-E022E1A1E217}" presName="rootConnector" presStyleLbl="node4" presStyleIdx="1" presStyleCnt="13"/>
      <dgm:spPr/>
      <dgm:t>
        <a:bodyPr/>
        <a:lstStyle/>
        <a:p>
          <a:endParaRPr lang="en-US"/>
        </a:p>
      </dgm:t>
    </dgm:pt>
    <dgm:pt modelId="{E1230EAF-BA05-476A-A248-36C2B8ECCA4D}" type="pres">
      <dgm:prSet presAssocID="{F4E45BD8-A30E-4F63-92EB-E022E1A1E217}" presName="hierChild4" presStyleCnt="0"/>
      <dgm:spPr/>
    </dgm:pt>
    <dgm:pt modelId="{9A455279-91E0-4465-8CD0-8A0BA40AF2F3}" type="pres">
      <dgm:prSet presAssocID="{270C3E90-0605-4A24-8731-391097A12A8E}" presName="Name37" presStyleLbl="parChTrans1D4" presStyleIdx="2" presStyleCnt="13"/>
      <dgm:spPr/>
      <dgm:t>
        <a:bodyPr/>
        <a:lstStyle/>
        <a:p>
          <a:endParaRPr lang="en-US"/>
        </a:p>
      </dgm:t>
    </dgm:pt>
    <dgm:pt modelId="{4B1DE711-CDE3-473E-BCD6-003B473F04C7}" type="pres">
      <dgm:prSet presAssocID="{0EAF7C20-CBAE-4D32-A9CB-6E52C4C3E071}" presName="hierRoot2" presStyleCnt="0">
        <dgm:presLayoutVars>
          <dgm:hierBranch val="init"/>
        </dgm:presLayoutVars>
      </dgm:prSet>
      <dgm:spPr/>
    </dgm:pt>
    <dgm:pt modelId="{C5613E25-CD6D-4A1C-BCD8-B51C4DAF34C5}" type="pres">
      <dgm:prSet presAssocID="{0EAF7C20-CBAE-4D32-A9CB-6E52C4C3E071}" presName="rootComposite" presStyleCnt="0"/>
      <dgm:spPr/>
    </dgm:pt>
    <dgm:pt modelId="{2BA45C4B-EB5D-4ECB-A1DD-1E21ACDE15B8}" type="pres">
      <dgm:prSet presAssocID="{0EAF7C20-CBAE-4D32-A9CB-6E52C4C3E071}" presName="rootText" presStyleLbl="node4" presStyleIdx="2" presStyleCnt="1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F1983E5-E7CA-4AB5-B7FF-EBCFE89CB486}" type="pres">
      <dgm:prSet presAssocID="{0EAF7C20-CBAE-4D32-A9CB-6E52C4C3E071}" presName="rootConnector" presStyleLbl="node4" presStyleIdx="2" presStyleCnt="13"/>
      <dgm:spPr/>
      <dgm:t>
        <a:bodyPr/>
        <a:lstStyle/>
        <a:p>
          <a:endParaRPr lang="en-US"/>
        </a:p>
      </dgm:t>
    </dgm:pt>
    <dgm:pt modelId="{86E934BE-D151-4480-AB58-AE714B6D0C94}" type="pres">
      <dgm:prSet presAssocID="{0EAF7C20-CBAE-4D32-A9CB-6E52C4C3E071}" presName="hierChild4" presStyleCnt="0"/>
      <dgm:spPr/>
    </dgm:pt>
    <dgm:pt modelId="{31ECBBA8-5795-4D4C-BF31-0C8EC1A75860}" type="pres">
      <dgm:prSet presAssocID="{B68430D6-70B9-474D-8DEF-16DD3B788079}" presName="Name37" presStyleLbl="parChTrans1D4" presStyleIdx="3" presStyleCnt="13"/>
      <dgm:spPr/>
      <dgm:t>
        <a:bodyPr/>
        <a:lstStyle/>
        <a:p>
          <a:endParaRPr lang="en-US"/>
        </a:p>
      </dgm:t>
    </dgm:pt>
    <dgm:pt modelId="{9282EBB8-C16A-4202-8981-6918876A0C14}" type="pres">
      <dgm:prSet presAssocID="{EDA2A610-C40F-4E24-9E38-B25DD89570FB}" presName="hierRoot2" presStyleCnt="0">
        <dgm:presLayoutVars>
          <dgm:hierBranch val="init"/>
        </dgm:presLayoutVars>
      </dgm:prSet>
      <dgm:spPr/>
    </dgm:pt>
    <dgm:pt modelId="{30711303-1A79-4BDD-B060-AAA383AC1DA7}" type="pres">
      <dgm:prSet presAssocID="{EDA2A610-C40F-4E24-9E38-B25DD89570FB}" presName="rootComposite" presStyleCnt="0"/>
      <dgm:spPr/>
    </dgm:pt>
    <dgm:pt modelId="{9D6375D5-4A12-4E0F-A54C-3318F6594B0A}" type="pres">
      <dgm:prSet presAssocID="{EDA2A610-C40F-4E24-9E38-B25DD89570FB}" presName="rootText" presStyleLbl="node4" presStyleIdx="3" presStyleCnt="13" custLinFactNeighborX="-1269" custLinFactNeighborY="-1443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A83B136-A458-467B-AFA5-FD6C90A044E9}" type="pres">
      <dgm:prSet presAssocID="{EDA2A610-C40F-4E24-9E38-B25DD89570FB}" presName="rootConnector" presStyleLbl="node4" presStyleIdx="3" presStyleCnt="13"/>
      <dgm:spPr/>
      <dgm:t>
        <a:bodyPr/>
        <a:lstStyle/>
        <a:p>
          <a:endParaRPr lang="en-US"/>
        </a:p>
      </dgm:t>
    </dgm:pt>
    <dgm:pt modelId="{013311E3-7DCB-4E22-BACA-E26930C619D2}" type="pres">
      <dgm:prSet presAssocID="{EDA2A610-C40F-4E24-9E38-B25DD89570FB}" presName="hierChild4" presStyleCnt="0"/>
      <dgm:spPr/>
    </dgm:pt>
    <dgm:pt modelId="{B0540AE5-B328-4073-B4BB-345A3493678C}" type="pres">
      <dgm:prSet presAssocID="{EDA2A610-C40F-4E24-9E38-B25DD89570FB}" presName="hierChild5" presStyleCnt="0"/>
      <dgm:spPr/>
    </dgm:pt>
    <dgm:pt modelId="{EAD88EE6-2F6D-4BE4-9A01-91FDDFAB1FFB}" type="pres">
      <dgm:prSet presAssocID="{0EAF7C20-CBAE-4D32-A9CB-6E52C4C3E071}" presName="hierChild5" presStyleCnt="0"/>
      <dgm:spPr/>
    </dgm:pt>
    <dgm:pt modelId="{AB9BF06F-7A5C-4613-9B31-B347AB14BCB7}" type="pres">
      <dgm:prSet presAssocID="{F4E45BD8-A30E-4F63-92EB-E022E1A1E217}" presName="hierChild5" presStyleCnt="0"/>
      <dgm:spPr/>
    </dgm:pt>
    <dgm:pt modelId="{764AB13D-D68E-4C09-A34F-4BD7276691AB}" type="pres">
      <dgm:prSet presAssocID="{9CD5F3DB-5E12-4C8E-83B4-2C084C60E153}" presName="hierChild5" presStyleCnt="0"/>
      <dgm:spPr/>
    </dgm:pt>
    <dgm:pt modelId="{32193677-9331-46DE-8ABB-3178A8E28ECC}" type="pres">
      <dgm:prSet presAssocID="{6904EFD8-FCC9-4362-8F06-D20345E1F52D}" presName="Name37" presStyleLbl="parChTrans1D4" presStyleIdx="4" presStyleCnt="13"/>
      <dgm:spPr/>
      <dgm:t>
        <a:bodyPr/>
        <a:lstStyle/>
        <a:p>
          <a:endParaRPr lang="en-US"/>
        </a:p>
      </dgm:t>
    </dgm:pt>
    <dgm:pt modelId="{F0FA71D7-68BC-41C5-BE64-60644A58928E}" type="pres">
      <dgm:prSet presAssocID="{ADAA99C6-C743-4C4F-AF02-C6046061547E}" presName="hierRoot2" presStyleCnt="0">
        <dgm:presLayoutVars>
          <dgm:hierBranch val="init"/>
        </dgm:presLayoutVars>
      </dgm:prSet>
      <dgm:spPr/>
    </dgm:pt>
    <dgm:pt modelId="{A4C9F0BB-E983-4EE6-83D1-F522891B2F6F}" type="pres">
      <dgm:prSet presAssocID="{ADAA99C6-C743-4C4F-AF02-C6046061547E}" presName="rootComposite" presStyleCnt="0"/>
      <dgm:spPr/>
    </dgm:pt>
    <dgm:pt modelId="{5DE326EE-9851-434C-8EDC-05276E75C0B8}" type="pres">
      <dgm:prSet presAssocID="{ADAA99C6-C743-4C4F-AF02-C6046061547E}" presName="rootText" presStyleLbl="node4" presStyleIdx="4" presStyleCnt="1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21F6026-D679-4E44-9D63-D929D9E7411A}" type="pres">
      <dgm:prSet presAssocID="{ADAA99C6-C743-4C4F-AF02-C6046061547E}" presName="rootConnector" presStyleLbl="node4" presStyleIdx="4" presStyleCnt="13"/>
      <dgm:spPr/>
      <dgm:t>
        <a:bodyPr/>
        <a:lstStyle/>
        <a:p>
          <a:endParaRPr lang="en-US"/>
        </a:p>
      </dgm:t>
    </dgm:pt>
    <dgm:pt modelId="{E68621AF-CB50-40B5-B115-593B0F9C4939}" type="pres">
      <dgm:prSet presAssocID="{ADAA99C6-C743-4C4F-AF02-C6046061547E}" presName="hierChild4" presStyleCnt="0"/>
      <dgm:spPr/>
    </dgm:pt>
    <dgm:pt modelId="{BE0C8F46-ECE4-4D8B-9B56-1DBCA13D674E}" type="pres">
      <dgm:prSet presAssocID="{3ABCA396-4BE5-4F69-B333-DF5A1BE918E7}" presName="Name37" presStyleLbl="parChTrans1D4" presStyleIdx="5" presStyleCnt="13"/>
      <dgm:spPr/>
      <dgm:t>
        <a:bodyPr/>
        <a:lstStyle/>
        <a:p>
          <a:endParaRPr lang="en-US"/>
        </a:p>
      </dgm:t>
    </dgm:pt>
    <dgm:pt modelId="{92EC5971-AA81-4155-BD52-3075708E27BF}" type="pres">
      <dgm:prSet presAssocID="{FFB1F9C0-C650-4E42-8480-B212E015433D}" presName="hierRoot2" presStyleCnt="0">
        <dgm:presLayoutVars>
          <dgm:hierBranch val="init"/>
        </dgm:presLayoutVars>
      </dgm:prSet>
      <dgm:spPr/>
    </dgm:pt>
    <dgm:pt modelId="{E0AEC89A-4363-4A05-A8B1-EA7D5AE1B8A3}" type="pres">
      <dgm:prSet presAssocID="{FFB1F9C0-C650-4E42-8480-B212E015433D}" presName="rootComposite" presStyleCnt="0"/>
      <dgm:spPr/>
    </dgm:pt>
    <dgm:pt modelId="{735D910B-E050-4E92-8E02-BFAD2F2AD77A}" type="pres">
      <dgm:prSet presAssocID="{FFB1F9C0-C650-4E42-8480-B212E015433D}" presName="rootText" presStyleLbl="node4" presStyleIdx="5" presStyleCnt="13" custLinFactY="100000" custLinFactNeighborX="-2241" custLinFactNeighborY="16886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BE2428E-085A-4A5A-924C-E26171F3D9C9}" type="pres">
      <dgm:prSet presAssocID="{FFB1F9C0-C650-4E42-8480-B212E015433D}" presName="rootConnector" presStyleLbl="node4" presStyleIdx="5" presStyleCnt="13"/>
      <dgm:spPr/>
      <dgm:t>
        <a:bodyPr/>
        <a:lstStyle/>
        <a:p>
          <a:endParaRPr lang="en-US"/>
        </a:p>
      </dgm:t>
    </dgm:pt>
    <dgm:pt modelId="{2BD73E50-53E8-4CB9-B666-D7967A68D388}" type="pres">
      <dgm:prSet presAssocID="{FFB1F9C0-C650-4E42-8480-B212E015433D}" presName="hierChild4" presStyleCnt="0"/>
      <dgm:spPr/>
    </dgm:pt>
    <dgm:pt modelId="{D4E06BD2-33B9-4669-8B55-8250AE86A53B}" type="pres">
      <dgm:prSet presAssocID="{FFB1F9C0-C650-4E42-8480-B212E015433D}" presName="hierChild5" presStyleCnt="0"/>
      <dgm:spPr/>
    </dgm:pt>
    <dgm:pt modelId="{10A2986A-E8CB-4421-A43B-651C49164573}" type="pres">
      <dgm:prSet presAssocID="{ADAA99C6-C743-4C4F-AF02-C6046061547E}" presName="hierChild5" presStyleCnt="0"/>
      <dgm:spPr/>
    </dgm:pt>
    <dgm:pt modelId="{4F03BCC2-8A42-49BC-A83F-806226A3E10C}" type="pres">
      <dgm:prSet presAssocID="{548E438E-8D59-4080-B4D2-33A3EBBEB425}" presName="hierChild5" presStyleCnt="0"/>
      <dgm:spPr/>
    </dgm:pt>
    <dgm:pt modelId="{BAF556EF-DE82-47AA-81BE-5AFFF44283C6}" type="pres">
      <dgm:prSet presAssocID="{4A369978-7617-4015-9EEC-A63A54FEF33F}" presName="hierChild5" presStyleCnt="0"/>
      <dgm:spPr/>
    </dgm:pt>
    <dgm:pt modelId="{219BAF5B-EC7A-424B-986A-B1E37CCDAFA5}" type="pres">
      <dgm:prSet presAssocID="{79358810-750E-4E9F-A86D-31A8C2155268}" presName="Name37" presStyleLbl="parChTrans1D2" presStyleIdx="1" presStyleCnt="2"/>
      <dgm:spPr/>
      <dgm:t>
        <a:bodyPr/>
        <a:lstStyle/>
        <a:p>
          <a:endParaRPr lang="en-US"/>
        </a:p>
      </dgm:t>
    </dgm:pt>
    <dgm:pt modelId="{E34AF575-7542-4EA8-8257-7B024E767079}" type="pres">
      <dgm:prSet presAssocID="{7E298A2F-377F-4C5A-9DA6-A854F892FDFE}" presName="hierRoot2" presStyleCnt="0">
        <dgm:presLayoutVars>
          <dgm:hierBranch val="init"/>
        </dgm:presLayoutVars>
      </dgm:prSet>
      <dgm:spPr/>
    </dgm:pt>
    <dgm:pt modelId="{0B38B274-E533-447C-9E91-70E6ABAD55CF}" type="pres">
      <dgm:prSet presAssocID="{7E298A2F-377F-4C5A-9DA6-A854F892FDFE}" presName="rootComposite" presStyleCnt="0"/>
      <dgm:spPr/>
    </dgm:pt>
    <dgm:pt modelId="{4B3901EF-3305-45FA-9275-1CFECD108D4D}" type="pres">
      <dgm:prSet presAssocID="{7E298A2F-377F-4C5A-9DA6-A854F892FDFE}" presName="rootText" presStyleLbl="node2" presStyleIdx="1" presStyleCnt="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1E99CB7-DFDA-4BC7-9FC3-0ED7A9E42B7B}" type="pres">
      <dgm:prSet presAssocID="{7E298A2F-377F-4C5A-9DA6-A854F892FDFE}" presName="rootConnector" presStyleLbl="node2" presStyleIdx="1" presStyleCnt="2"/>
      <dgm:spPr/>
      <dgm:t>
        <a:bodyPr/>
        <a:lstStyle/>
        <a:p>
          <a:endParaRPr lang="en-US"/>
        </a:p>
      </dgm:t>
    </dgm:pt>
    <dgm:pt modelId="{BF163086-CC9E-45EF-B244-732BC048E632}" type="pres">
      <dgm:prSet presAssocID="{7E298A2F-377F-4C5A-9DA6-A854F892FDFE}" presName="hierChild4" presStyleCnt="0"/>
      <dgm:spPr/>
    </dgm:pt>
    <dgm:pt modelId="{B78914A4-EA34-47AF-8CBA-E2B8E236BAC2}" type="pres">
      <dgm:prSet presAssocID="{85B1BB08-F3ED-4F9B-A7AC-A783C01BA4CA}" presName="Name37" presStyleLbl="parChTrans1D3" presStyleIdx="1" presStyleCnt="3"/>
      <dgm:spPr/>
      <dgm:t>
        <a:bodyPr/>
        <a:lstStyle/>
        <a:p>
          <a:endParaRPr lang="en-US"/>
        </a:p>
      </dgm:t>
    </dgm:pt>
    <dgm:pt modelId="{157E5380-8DA1-46EE-AE32-BD847F9DCA35}" type="pres">
      <dgm:prSet presAssocID="{BFC8376F-613B-41FC-827D-EF14F383F6D4}" presName="hierRoot2" presStyleCnt="0">
        <dgm:presLayoutVars>
          <dgm:hierBranch val="init"/>
        </dgm:presLayoutVars>
      </dgm:prSet>
      <dgm:spPr/>
    </dgm:pt>
    <dgm:pt modelId="{211A602F-F136-4DAD-8D33-7C2549E096FE}" type="pres">
      <dgm:prSet presAssocID="{BFC8376F-613B-41FC-827D-EF14F383F6D4}" presName="rootComposite" presStyleCnt="0"/>
      <dgm:spPr/>
    </dgm:pt>
    <dgm:pt modelId="{537CABBE-B7C2-40B7-A99D-BC27D1511C09}" type="pres">
      <dgm:prSet presAssocID="{BFC8376F-613B-41FC-827D-EF14F383F6D4}" presName="rootText" presStyleLbl="node3" presStyleIdx="1" presStyleCnt="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A16A8E3-CB8E-414C-8B4D-AC881884DCD5}" type="pres">
      <dgm:prSet presAssocID="{BFC8376F-613B-41FC-827D-EF14F383F6D4}" presName="rootConnector" presStyleLbl="node3" presStyleIdx="1" presStyleCnt="3"/>
      <dgm:spPr/>
      <dgm:t>
        <a:bodyPr/>
        <a:lstStyle/>
        <a:p>
          <a:endParaRPr lang="en-US"/>
        </a:p>
      </dgm:t>
    </dgm:pt>
    <dgm:pt modelId="{75597123-3A0E-4146-9DEC-5CE03E2BC89A}" type="pres">
      <dgm:prSet presAssocID="{BFC8376F-613B-41FC-827D-EF14F383F6D4}" presName="hierChild4" presStyleCnt="0"/>
      <dgm:spPr/>
    </dgm:pt>
    <dgm:pt modelId="{FBCCC868-4018-4775-9E5C-F114D979F4A5}" type="pres">
      <dgm:prSet presAssocID="{8E53683D-2C51-4DAD-A311-ECD00C280D9F}" presName="Name37" presStyleLbl="parChTrans1D4" presStyleIdx="6" presStyleCnt="13"/>
      <dgm:spPr/>
      <dgm:t>
        <a:bodyPr/>
        <a:lstStyle/>
        <a:p>
          <a:endParaRPr lang="en-US"/>
        </a:p>
      </dgm:t>
    </dgm:pt>
    <dgm:pt modelId="{FA2CA2F9-8B1D-4124-8BB9-61B82A7C07F6}" type="pres">
      <dgm:prSet presAssocID="{23C4A683-5925-43C9-AB86-E8210F1F7AF5}" presName="hierRoot2" presStyleCnt="0">
        <dgm:presLayoutVars>
          <dgm:hierBranch val="init"/>
        </dgm:presLayoutVars>
      </dgm:prSet>
      <dgm:spPr/>
    </dgm:pt>
    <dgm:pt modelId="{9630A865-AC2E-463F-9B6B-4A81D70A1C7A}" type="pres">
      <dgm:prSet presAssocID="{23C4A683-5925-43C9-AB86-E8210F1F7AF5}" presName="rootComposite" presStyleCnt="0"/>
      <dgm:spPr/>
    </dgm:pt>
    <dgm:pt modelId="{CED15ED1-BE3F-4AB6-93AB-8C698EE46D06}" type="pres">
      <dgm:prSet presAssocID="{23C4A683-5925-43C9-AB86-E8210F1F7AF5}" presName="rootText" presStyleLbl="node4" presStyleIdx="6" presStyleCnt="1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07B5381-1146-4D2D-9C40-E8E8C206B6C2}" type="pres">
      <dgm:prSet presAssocID="{23C4A683-5925-43C9-AB86-E8210F1F7AF5}" presName="rootConnector" presStyleLbl="node4" presStyleIdx="6" presStyleCnt="13"/>
      <dgm:spPr/>
      <dgm:t>
        <a:bodyPr/>
        <a:lstStyle/>
        <a:p>
          <a:endParaRPr lang="en-US"/>
        </a:p>
      </dgm:t>
    </dgm:pt>
    <dgm:pt modelId="{328A34AE-8890-4217-B64F-5E418287B91F}" type="pres">
      <dgm:prSet presAssocID="{23C4A683-5925-43C9-AB86-E8210F1F7AF5}" presName="hierChild4" presStyleCnt="0"/>
      <dgm:spPr/>
    </dgm:pt>
    <dgm:pt modelId="{193D35EC-F2E8-4BBD-987C-168879245712}" type="pres">
      <dgm:prSet presAssocID="{23C4A683-5925-43C9-AB86-E8210F1F7AF5}" presName="hierChild5" presStyleCnt="0"/>
      <dgm:spPr/>
    </dgm:pt>
    <dgm:pt modelId="{CECE8821-860A-4950-B0FD-95662D85730E}" type="pres">
      <dgm:prSet presAssocID="{BFC8376F-613B-41FC-827D-EF14F383F6D4}" presName="hierChild5" presStyleCnt="0"/>
      <dgm:spPr/>
    </dgm:pt>
    <dgm:pt modelId="{8C62BEED-2FF8-45C3-B01B-6BB0A0FA8AAC}" type="pres">
      <dgm:prSet presAssocID="{A199DCC7-F65E-4F6C-B747-FB3FBCBEB0B7}" presName="Name37" presStyleLbl="parChTrans1D3" presStyleIdx="2" presStyleCnt="3"/>
      <dgm:spPr/>
      <dgm:t>
        <a:bodyPr/>
        <a:lstStyle/>
        <a:p>
          <a:endParaRPr lang="en-US"/>
        </a:p>
      </dgm:t>
    </dgm:pt>
    <dgm:pt modelId="{23CAD4E0-E7F9-4A99-9D88-FF66A8ACB62E}" type="pres">
      <dgm:prSet presAssocID="{500CADD1-C14C-4AA3-B63D-2FB9016CAE94}" presName="hierRoot2" presStyleCnt="0">
        <dgm:presLayoutVars>
          <dgm:hierBranch val="init"/>
        </dgm:presLayoutVars>
      </dgm:prSet>
      <dgm:spPr/>
    </dgm:pt>
    <dgm:pt modelId="{A5977595-182C-4756-9C28-2C239DDC189C}" type="pres">
      <dgm:prSet presAssocID="{500CADD1-C14C-4AA3-B63D-2FB9016CAE94}" presName="rootComposite" presStyleCnt="0"/>
      <dgm:spPr/>
    </dgm:pt>
    <dgm:pt modelId="{75159275-F1FF-4249-B1FB-B4E2948EED4B}" type="pres">
      <dgm:prSet presAssocID="{500CADD1-C14C-4AA3-B63D-2FB9016CAE94}" presName="rootText" presStyleLbl="node3" presStyleIdx="2" presStyleCnt="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A903A5D-0E28-46B1-8951-FDDA59FBA092}" type="pres">
      <dgm:prSet presAssocID="{500CADD1-C14C-4AA3-B63D-2FB9016CAE94}" presName="rootConnector" presStyleLbl="node3" presStyleIdx="2" presStyleCnt="3"/>
      <dgm:spPr/>
      <dgm:t>
        <a:bodyPr/>
        <a:lstStyle/>
        <a:p>
          <a:endParaRPr lang="en-US"/>
        </a:p>
      </dgm:t>
    </dgm:pt>
    <dgm:pt modelId="{DB278AA9-B573-40D4-B195-A75C103FC38B}" type="pres">
      <dgm:prSet presAssocID="{500CADD1-C14C-4AA3-B63D-2FB9016CAE94}" presName="hierChild4" presStyleCnt="0"/>
      <dgm:spPr/>
    </dgm:pt>
    <dgm:pt modelId="{723256B6-A72F-481C-B391-067AF3F0A50C}" type="pres">
      <dgm:prSet presAssocID="{1475DF99-894F-45BB-B64F-B5E80A8879DF}" presName="Name37" presStyleLbl="parChTrans1D4" presStyleIdx="7" presStyleCnt="13"/>
      <dgm:spPr/>
      <dgm:t>
        <a:bodyPr/>
        <a:lstStyle/>
        <a:p>
          <a:endParaRPr lang="en-US"/>
        </a:p>
      </dgm:t>
    </dgm:pt>
    <dgm:pt modelId="{12FF6F10-E9A4-4B54-95B5-1E3B8EDEEF3E}" type="pres">
      <dgm:prSet presAssocID="{0761D75F-B57D-44D7-B331-E18F28B5B8C4}" presName="hierRoot2" presStyleCnt="0">
        <dgm:presLayoutVars>
          <dgm:hierBranch val="init"/>
        </dgm:presLayoutVars>
      </dgm:prSet>
      <dgm:spPr/>
    </dgm:pt>
    <dgm:pt modelId="{83769434-3E5F-4DAF-9F14-C9FF12F51511}" type="pres">
      <dgm:prSet presAssocID="{0761D75F-B57D-44D7-B331-E18F28B5B8C4}" presName="rootComposite" presStyleCnt="0"/>
      <dgm:spPr/>
    </dgm:pt>
    <dgm:pt modelId="{62731CA0-C3BB-47B6-A1AC-45EF69306C69}" type="pres">
      <dgm:prSet presAssocID="{0761D75F-B57D-44D7-B331-E18F28B5B8C4}" presName="rootText" presStyleLbl="node4" presStyleIdx="7" presStyleCnt="1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AAD6B9C-DC8C-4A8F-A19E-30A8088DC536}" type="pres">
      <dgm:prSet presAssocID="{0761D75F-B57D-44D7-B331-E18F28B5B8C4}" presName="rootConnector" presStyleLbl="node4" presStyleIdx="7" presStyleCnt="13"/>
      <dgm:spPr/>
      <dgm:t>
        <a:bodyPr/>
        <a:lstStyle/>
        <a:p>
          <a:endParaRPr lang="en-US"/>
        </a:p>
      </dgm:t>
    </dgm:pt>
    <dgm:pt modelId="{D1A22180-CD3E-4968-8050-D2CE617605DF}" type="pres">
      <dgm:prSet presAssocID="{0761D75F-B57D-44D7-B331-E18F28B5B8C4}" presName="hierChild4" presStyleCnt="0"/>
      <dgm:spPr/>
    </dgm:pt>
    <dgm:pt modelId="{EE46DB7E-DFA6-4EE7-B928-53A393BD8D10}" type="pres">
      <dgm:prSet presAssocID="{DCE2C748-9943-4874-8A80-1BA380733CBC}" presName="Name37" presStyleLbl="parChTrans1D4" presStyleIdx="8" presStyleCnt="13"/>
      <dgm:spPr/>
      <dgm:t>
        <a:bodyPr/>
        <a:lstStyle/>
        <a:p>
          <a:endParaRPr lang="en-US"/>
        </a:p>
      </dgm:t>
    </dgm:pt>
    <dgm:pt modelId="{619C66DE-5618-4934-9F35-01949BC36E23}" type="pres">
      <dgm:prSet presAssocID="{8FC83D10-DBE6-4520-84AC-B5411B1C8627}" presName="hierRoot2" presStyleCnt="0">
        <dgm:presLayoutVars>
          <dgm:hierBranch val="init"/>
        </dgm:presLayoutVars>
      </dgm:prSet>
      <dgm:spPr/>
    </dgm:pt>
    <dgm:pt modelId="{D6BFE26A-4868-4C3C-A54F-B1A2CAC97C04}" type="pres">
      <dgm:prSet presAssocID="{8FC83D10-DBE6-4520-84AC-B5411B1C8627}" presName="rootComposite" presStyleCnt="0"/>
      <dgm:spPr/>
    </dgm:pt>
    <dgm:pt modelId="{D1BC1C52-63A7-4755-B5F2-3483E2890746}" type="pres">
      <dgm:prSet presAssocID="{8FC83D10-DBE6-4520-84AC-B5411B1C8627}" presName="rootText" presStyleLbl="node4" presStyleIdx="8" presStyleCnt="13" custScaleX="20647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BA81EAF-8911-4D48-81E7-0BBD27A7DD0D}" type="pres">
      <dgm:prSet presAssocID="{8FC83D10-DBE6-4520-84AC-B5411B1C8627}" presName="rootConnector" presStyleLbl="node4" presStyleIdx="8" presStyleCnt="13"/>
      <dgm:spPr/>
      <dgm:t>
        <a:bodyPr/>
        <a:lstStyle/>
        <a:p>
          <a:endParaRPr lang="en-US"/>
        </a:p>
      </dgm:t>
    </dgm:pt>
    <dgm:pt modelId="{A5E11DF6-4225-4204-9CFF-49B5371345C1}" type="pres">
      <dgm:prSet presAssocID="{8FC83D10-DBE6-4520-84AC-B5411B1C8627}" presName="hierChild4" presStyleCnt="0"/>
      <dgm:spPr/>
    </dgm:pt>
    <dgm:pt modelId="{631372C7-EBAD-4D65-9912-8B18643DCC8F}" type="pres">
      <dgm:prSet presAssocID="{71D572E1-46D3-4EE7-97AE-0205159016D8}" presName="Name37" presStyleLbl="parChTrans1D4" presStyleIdx="9" presStyleCnt="13"/>
      <dgm:spPr/>
      <dgm:t>
        <a:bodyPr/>
        <a:lstStyle/>
        <a:p>
          <a:endParaRPr lang="en-US"/>
        </a:p>
      </dgm:t>
    </dgm:pt>
    <dgm:pt modelId="{8A2D374B-458A-4AF3-84A5-B34072BB706B}" type="pres">
      <dgm:prSet presAssocID="{B8CCAAA3-86AC-4434-948B-B01D3BB1C02A}" presName="hierRoot2" presStyleCnt="0">
        <dgm:presLayoutVars>
          <dgm:hierBranch val="init"/>
        </dgm:presLayoutVars>
      </dgm:prSet>
      <dgm:spPr/>
    </dgm:pt>
    <dgm:pt modelId="{7433A366-CF83-4C3C-9B81-960A13BD1D80}" type="pres">
      <dgm:prSet presAssocID="{B8CCAAA3-86AC-4434-948B-B01D3BB1C02A}" presName="rootComposite" presStyleCnt="0"/>
      <dgm:spPr/>
    </dgm:pt>
    <dgm:pt modelId="{AF715ACC-4D12-4228-B645-24C45F97D853}" type="pres">
      <dgm:prSet presAssocID="{B8CCAAA3-86AC-4434-948B-B01D3BB1C02A}" presName="rootText" presStyleLbl="node4" presStyleIdx="9" presStyleCnt="1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AC7CA92-0903-4D77-BD81-4082BFB8F61A}" type="pres">
      <dgm:prSet presAssocID="{B8CCAAA3-86AC-4434-948B-B01D3BB1C02A}" presName="rootConnector" presStyleLbl="node4" presStyleIdx="9" presStyleCnt="13"/>
      <dgm:spPr/>
      <dgm:t>
        <a:bodyPr/>
        <a:lstStyle/>
        <a:p>
          <a:endParaRPr lang="en-US"/>
        </a:p>
      </dgm:t>
    </dgm:pt>
    <dgm:pt modelId="{8C1A34B1-B902-45DF-9044-ED6B8B5CE4B7}" type="pres">
      <dgm:prSet presAssocID="{B8CCAAA3-86AC-4434-948B-B01D3BB1C02A}" presName="hierChild4" presStyleCnt="0"/>
      <dgm:spPr/>
    </dgm:pt>
    <dgm:pt modelId="{AD9931AB-5D63-4E48-95CD-8ECFF39ABB92}" type="pres">
      <dgm:prSet presAssocID="{A656F677-D583-486F-AEA5-FC5F6CF15C79}" presName="Name37" presStyleLbl="parChTrans1D4" presStyleIdx="10" presStyleCnt="13"/>
      <dgm:spPr/>
      <dgm:t>
        <a:bodyPr/>
        <a:lstStyle/>
        <a:p>
          <a:endParaRPr lang="en-US"/>
        </a:p>
      </dgm:t>
    </dgm:pt>
    <dgm:pt modelId="{D63E330B-508D-440B-BD55-89CC6D35F938}" type="pres">
      <dgm:prSet presAssocID="{92ABDE10-7240-4297-8E4A-25FBA1E36AA4}" presName="hierRoot2" presStyleCnt="0">
        <dgm:presLayoutVars>
          <dgm:hierBranch val="init"/>
        </dgm:presLayoutVars>
      </dgm:prSet>
      <dgm:spPr/>
    </dgm:pt>
    <dgm:pt modelId="{1AB85D30-1D40-42E3-A8DB-C9F1D815B6B4}" type="pres">
      <dgm:prSet presAssocID="{92ABDE10-7240-4297-8E4A-25FBA1E36AA4}" presName="rootComposite" presStyleCnt="0"/>
      <dgm:spPr/>
    </dgm:pt>
    <dgm:pt modelId="{096C6924-E277-4E36-BE1E-21B979E93C0A}" type="pres">
      <dgm:prSet presAssocID="{92ABDE10-7240-4297-8E4A-25FBA1E36AA4}" presName="rootText" presStyleLbl="node4" presStyleIdx="10" presStyleCnt="13" custLinFactNeighborX="-1269" custLinFactNeighborY="-1443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B722D9E-513A-4857-BD11-B52EEB6F75B6}" type="pres">
      <dgm:prSet presAssocID="{92ABDE10-7240-4297-8E4A-25FBA1E36AA4}" presName="rootConnector" presStyleLbl="node4" presStyleIdx="10" presStyleCnt="13"/>
      <dgm:spPr/>
      <dgm:t>
        <a:bodyPr/>
        <a:lstStyle/>
        <a:p>
          <a:endParaRPr lang="en-US"/>
        </a:p>
      </dgm:t>
    </dgm:pt>
    <dgm:pt modelId="{555BB7B1-E4CE-44C3-A348-6FE6F2922356}" type="pres">
      <dgm:prSet presAssocID="{92ABDE10-7240-4297-8E4A-25FBA1E36AA4}" presName="hierChild4" presStyleCnt="0"/>
      <dgm:spPr/>
    </dgm:pt>
    <dgm:pt modelId="{969713CF-6979-4B53-8F08-9E7AFC31CCFB}" type="pres">
      <dgm:prSet presAssocID="{92ABDE10-7240-4297-8E4A-25FBA1E36AA4}" presName="hierChild5" presStyleCnt="0"/>
      <dgm:spPr/>
    </dgm:pt>
    <dgm:pt modelId="{E35D51EB-F2AD-4AFC-9E17-3EF3CCD8514A}" type="pres">
      <dgm:prSet presAssocID="{B8CCAAA3-86AC-4434-948B-B01D3BB1C02A}" presName="hierChild5" presStyleCnt="0"/>
      <dgm:spPr/>
    </dgm:pt>
    <dgm:pt modelId="{1E0C88F6-4D8E-44E9-8D8A-BC32AAECB7C4}" type="pres">
      <dgm:prSet presAssocID="{8FC83D10-DBE6-4520-84AC-B5411B1C8627}" presName="hierChild5" presStyleCnt="0"/>
      <dgm:spPr/>
    </dgm:pt>
    <dgm:pt modelId="{5D3CA998-6F46-449C-BAE8-437D88BA755F}" type="pres">
      <dgm:prSet presAssocID="{0353E4CA-5DA6-4706-8469-C14E4D6705B2}" presName="Name37" presStyleLbl="parChTrans1D4" presStyleIdx="11" presStyleCnt="13"/>
      <dgm:spPr/>
      <dgm:t>
        <a:bodyPr/>
        <a:lstStyle/>
        <a:p>
          <a:endParaRPr lang="en-US"/>
        </a:p>
      </dgm:t>
    </dgm:pt>
    <dgm:pt modelId="{E22B4EBF-CC74-4F39-842E-BF5A7B162DE5}" type="pres">
      <dgm:prSet presAssocID="{A58B3FA0-1A00-4058-A584-9E3A4B6CFB95}" presName="hierRoot2" presStyleCnt="0">
        <dgm:presLayoutVars>
          <dgm:hierBranch val="init"/>
        </dgm:presLayoutVars>
      </dgm:prSet>
      <dgm:spPr/>
    </dgm:pt>
    <dgm:pt modelId="{BA87A8C4-2E7D-49F4-B5BD-931D3E6D37B0}" type="pres">
      <dgm:prSet presAssocID="{A58B3FA0-1A00-4058-A584-9E3A4B6CFB95}" presName="rootComposite" presStyleCnt="0"/>
      <dgm:spPr/>
    </dgm:pt>
    <dgm:pt modelId="{78AF51FD-FFC5-44E5-9765-9E2F883ECD56}" type="pres">
      <dgm:prSet presAssocID="{A58B3FA0-1A00-4058-A584-9E3A4B6CFB95}" presName="rootText" presStyleLbl="node4" presStyleIdx="11" presStyleCnt="1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54072B4-A9A5-458F-AE87-80CBC7BB0128}" type="pres">
      <dgm:prSet presAssocID="{A58B3FA0-1A00-4058-A584-9E3A4B6CFB95}" presName="rootConnector" presStyleLbl="node4" presStyleIdx="11" presStyleCnt="13"/>
      <dgm:spPr/>
      <dgm:t>
        <a:bodyPr/>
        <a:lstStyle/>
        <a:p>
          <a:endParaRPr lang="en-US"/>
        </a:p>
      </dgm:t>
    </dgm:pt>
    <dgm:pt modelId="{8EB5EAAD-B9C8-4ED9-8513-66B9039C670B}" type="pres">
      <dgm:prSet presAssocID="{A58B3FA0-1A00-4058-A584-9E3A4B6CFB95}" presName="hierChild4" presStyleCnt="0"/>
      <dgm:spPr/>
    </dgm:pt>
    <dgm:pt modelId="{C63EA82D-BEFE-463A-BC48-457D1AEDD6FF}" type="pres">
      <dgm:prSet presAssocID="{5F1BFEE2-C1CD-4275-AC77-5700C1EE7A2D}" presName="Name37" presStyleLbl="parChTrans1D4" presStyleIdx="12" presStyleCnt="13"/>
      <dgm:spPr/>
      <dgm:t>
        <a:bodyPr/>
        <a:lstStyle/>
        <a:p>
          <a:endParaRPr lang="en-US"/>
        </a:p>
      </dgm:t>
    </dgm:pt>
    <dgm:pt modelId="{99A10FF1-2AB8-451A-BC8B-76128A74F5C0}" type="pres">
      <dgm:prSet presAssocID="{688BA2AE-1AEF-4C47-9BA9-D6761F2FE84B}" presName="hierRoot2" presStyleCnt="0">
        <dgm:presLayoutVars>
          <dgm:hierBranch val="init"/>
        </dgm:presLayoutVars>
      </dgm:prSet>
      <dgm:spPr/>
    </dgm:pt>
    <dgm:pt modelId="{FB38FCC3-65C5-4F9E-99BE-52431CACB7AC}" type="pres">
      <dgm:prSet presAssocID="{688BA2AE-1AEF-4C47-9BA9-D6761F2FE84B}" presName="rootComposite" presStyleCnt="0"/>
      <dgm:spPr/>
    </dgm:pt>
    <dgm:pt modelId="{AB299217-BEB7-4637-8492-B505E68ABD2C}" type="pres">
      <dgm:prSet presAssocID="{688BA2AE-1AEF-4C47-9BA9-D6761F2FE84B}" presName="rootText" presStyleLbl="node4" presStyleIdx="12" presStyleCnt="13" custLinFactY="28487" custLinFactNeighborX="790" custLinFactNeighborY="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10D08E7-A4FF-44DC-BF4F-A4FE87A2452E}" type="pres">
      <dgm:prSet presAssocID="{688BA2AE-1AEF-4C47-9BA9-D6761F2FE84B}" presName="rootConnector" presStyleLbl="node4" presStyleIdx="12" presStyleCnt="13"/>
      <dgm:spPr/>
      <dgm:t>
        <a:bodyPr/>
        <a:lstStyle/>
        <a:p>
          <a:endParaRPr lang="en-US"/>
        </a:p>
      </dgm:t>
    </dgm:pt>
    <dgm:pt modelId="{61B13FEA-A5F6-4C5A-B115-649EE720F485}" type="pres">
      <dgm:prSet presAssocID="{688BA2AE-1AEF-4C47-9BA9-D6761F2FE84B}" presName="hierChild4" presStyleCnt="0"/>
      <dgm:spPr/>
    </dgm:pt>
    <dgm:pt modelId="{4AA8ECFF-9C3B-4978-84B6-ADD0117A1E23}" type="pres">
      <dgm:prSet presAssocID="{688BA2AE-1AEF-4C47-9BA9-D6761F2FE84B}" presName="hierChild5" presStyleCnt="0"/>
      <dgm:spPr/>
    </dgm:pt>
    <dgm:pt modelId="{2EFAA707-D5C3-4292-9310-3089B4DE60E1}" type="pres">
      <dgm:prSet presAssocID="{A58B3FA0-1A00-4058-A584-9E3A4B6CFB95}" presName="hierChild5" presStyleCnt="0"/>
      <dgm:spPr/>
    </dgm:pt>
    <dgm:pt modelId="{5A6BF4FD-19A3-4928-99EC-E6A3AF3FDA04}" type="pres">
      <dgm:prSet presAssocID="{0761D75F-B57D-44D7-B331-E18F28B5B8C4}" presName="hierChild5" presStyleCnt="0"/>
      <dgm:spPr/>
    </dgm:pt>
    <dgm:pt modelId="{FC7455E5-12D1-4DD7-8685-AFDDBD7CF98F}" type="pres">
      <dgm:prSet presAssocID="{500CADD1-C14C-4AA3-B63D-2FB9016CAE94}" presName="hierChild5" presStyleCnt="0"/>
      <dgm:spPr/>
    </dgm:pt>
    <dgm:pt modelId="{E2B0C4BD-EB0B-4869-887B-CE67070FA3D5}" type="pres">
      <dgm:prSet presAssocID="{7E298A2F-377F-4C5A-9DA6-A854F892FDFE}" presName="hierChild5" presStyleCnt="0"/>
      <dgm:spPr/>
    </dgm:pt>
    <dgm:pt modelId="{EAE3B9E6-C580-490F-92D6-448F5EFFA8A6}" type="pres">
      <dgm:prSet presAssocID="{FF8F8B10-1A05-4657-A6DB-975C869102E1}" presName="hierChild3" presStyleCnt="0"/>
      <dgm:spPr/>
    </dgm:pt>
  </dgm:ptLst>
  <dgm:cxnLst>
    <dgm:cxn modelId="{5FB56A92-1154-497F-B668-F44D93C8C3BB}" type="presOf" srcId="{FFB1F9C0-C650-4E42-8480-B212E015433D}" destId="{735D910B-E050-4E92-8E02-BFAD2F2AD77A}" srcOrd="0" destOrd="0" presId="urn:microsoft.com/office/officeart/2005/8/layout/orgChart1"/>
    <dgm:cxn modelId="{F274D010-95FF-4EDA-9A9C-EBD975B483F9}" type="presOf" srcId="{B8CCAAA3-86AC-4434-948B-B01D3BB1C02A}" destId="{AF715ACC-4D12-4228-B645-24C45F97D853}" srcOrd="0" destOrd="0" presId="urn:microsoft.com/office/officeart/2005/8/layout/orgChart1"/>
    <dgm:cxn modelId="{DB148D4C-F35F-4F42-B6BF-6CD0B0B2BD9F}" type="presOf" srcId="{C84046E8-30BD-4605-92AD-411E04CD1A7B}" destId="{8C717FC1-4E3E-48F1-AA46-47DD2843595D}" srcOrd="0" destOrd="0" presId="urn:microsoft.com/office/officeart/2005/8/layout/orgChart1"/>
    <dgm:cxn modelId="{9D6A8AD5-B163-4B93-ACA1-378B8555E50E}" type="presOf" srcId="{FFB1F9C0-C650-4E42-8480-B212E015433D}" destId="{3BE2428E-085A-4A5A-924C-E26171F3D9C9}" srcOrd="1" destOrd="0" presId="urn:microsoft.com/office/officeart/2005/8/layout/orgChart1"/>
    <dgm:cxn modelId="{8E918532-6825-4771-8BAC-92AD0F2A4D5E}" type="presOf" srcId="{B8CCAAA3-86AC-4434-948B-B01D3BB1C02A}" destId="{8AC7CA92-0903-4D77-BD81-4082BFB8F61A}" srcOrd="1" destOrd="0" presId="urn:microsoft.com/office/officeart/2005/8/layout/orgChart1"/>
    <dgm:cxn modelId="{3C65B840-BE1D-46A1-B60C-607E101854CE}" srcId="{0761D75F-B57D-44D7-B331-E18F28B5B8C4}" destId="{8FC83D10-DBE6-4520-84AC-B5411B1C8627}" srcOrd="0" destOrd="0" parTransId="{DCE2C748-9943-4874-8A80-1BA380733CBC}" sibTransId="{6D753A95-B092-4A5F-86DD-D77D98806E21}"/>
    <dgm:cxn modelId="{80A6936A-AE91-4317-A939-6AD8345E5920}" type="presOf" srcId="{23C4A683-5925-43C9-AB86-E8210F1F7AF5}" destId="{A07B5381-1146-4D2D-9C40-E8E8C206B6C2}" srcOrd="1" destOrd="0" presId="urn:microsoft.com/office/officeart/2005/8/layout/orgChart1"/>
    <dgm:cxn modelId="{72D64472-6337-44BC-877D-86ED229B6063}" type="presOf" srcId="{79358810-750E-4E9F-A86D-31A8C2155268}" destId="{219BAF5B-EC7A-424B-986A-B1E37CCDAFA5}" srcOrd="0" destOrd="0" presId="urn:microsoft.com/office/officeart/2005/8/layout/orgChart1"/>
    <dgm:cxn modelId="{2784842A-B172-4596-B9F1-B1228B7748A5}" type="presOf" srcId="{7E298A2F-377F-4C5A-9DA6-A854F892FDFE}" destId="{81E99CB7-DFDA-4BC7-9FC3-0ED7A9E42B7B}" srcOrd="1" destOrd="0" presId="urn:microsoft.com/office/officeart/2005/8/layout/orgChart1"/>
    <dgm:cxn modelId="{1265B3E6-80AF-43BC-8FEA-0A34F2CF269A}" type="presOf" srcId="{92ABDE10-7240-4297-8E4A-25FBA1E36AA4}" destId="{7B722D9E-513A-4857-BD11-B52EEB6F75B6}" srcOrd="1" destOrd="0" presId="urn:microsoft.com/office/officeart/2005/8/layout/orgChart1"/>
    <dgm:cxn modelId="{E26C6125-B54C-49D0-9A8E-E1C5A31A3E27}" srcId="{BFC8376F-613B-41FC-827D-EF14F383F6D4}" destId="{23C4A683-5925-43C9-AB86-E8210F1F7AF5}" srcOrd="0" destOrd="0" parTransId="{8E53683D-2C51-4DAD-A311-ECD00C280D9F}" sibTransId="{00E05D63-ADCC-47E8-AEAC-E15155395A17}"/>
    <dgm:cxn modelId="{89CBC2BA-691D-4279-A141-8B19CDC15B9A}" srcId="{500CADD1-C14C-4AA3-B63D-2FB9016CAE94}" destId="{0761D75F-B57D-44D7-B331-E18F28B5B8C4}" srcOrd="0" destOrd="0" parTransId="{1475DF99-894F-45BB-B64F-B5E80A8879DF}" sibTransId="{2E2AB1A1-9F29-4299-B1BB-1E67C5D60B19}"/>
    <dgm:cxn modelId="{FCACEC6C-B802-47B3-B950-C907F7FEC239}" type="presOf" srcId="{0353E4CA-5DA6-4706-8469-C14E4D6705B2}" destId="{5D3CA998-6F46-449C-BAE8-437D88BA755F}" srcOrd="0" destOrd="0" presId="urn:microsoft.com/office/officeart/2005/8/layout/orgChart1"/>
    <dgm:cxn modelId="{C9B59D97-B6BC-4541-A079-255622B05295}" type="presOf" srcId="{8FC83D10-DBE6-4520-84AC-B5411B1C8627}" destId="{ABA81EAF-8911-4D48-81E7-0BBD27A7DD0D}" srcOrd="1" destOrd="0" presId="urn:microsoft.com/office/officeart/2005/8/layout/orgChart1"/>
    <dgm:cxn modelId="{DF031618-A2A5-47D1-88CB-7EAFA6668984}" type="presOf" srcId="{4A369978-7617-4015-9EEC-A63A54FEF33F}" destId="{DA77AA64-0E26-4AC0-8DF6-A8A9AB145234}" srcOrd="1" destOrd="0" presId="urn:microsoft.com/office/officeart/2005/8/layout/orgChart1"/>
    <dgm:cxn modelId="{0FC64DFD-EF28-4FF7-BC5C-A6DD4D249FFA}" type="presOf" srcId="{A58B3FA0-1A00-4058-A584-9E3A4B6CFB95}" destId="{78AF51FD-FFC5-44E5-9765-9E2F883ECD56}" srcOrd="0" destOrd="0" presId="urn:microsoft.com/office/officeart/2005/8/layout/orgChart1"/>
    <dgm:cxn modelId="{D97CF0C2-24E0-4649-9559-4604D059053D}" type="presOf" srcId="{A656F677-D583-486F-AEA5-FC5F6CF15C79}" destId="{AD9931AB-5D63-4E48-95CD-8ECFF39ABB92}" srcOrd="0" destOrd="0" presId="urn:microsoft.com/office/officeart/2005/8/layout/orgChart1"/>
    <dgm:cxn modelId="{0BBF41F5-6AAC-4AB0-AE12-049181392B49}" srcId="{548E438E-8D59-4080-B4D2-33A3EBBEB425}" destId="{ADAA99C6-C743-4C4F-AF02-C6046061547E}" srcOrd="1" destOrd="0" parTransId="{6904EFD8-FCC9-4362-8F06-D20345E1F52D}" sibTransId="{EAB1861C-0674-4972-A042-8F996A465763}"/>
    <dgm:cxn modelId="{AB7AB37C-7087-41ED-B880-48CAC7080B64}" type="presOf" srcId="{B68430D6-70B9-474D-8DEF-16DD3B788079}" destId="{31ECBBA8-5795-4D4C-BF31-0C8EC1A75860}" srcOrd="0" destOrd="0" presId="urn:microsoft.com/office/officeart/2005/8/layout/orgChart1"/>
    <dgm:cxn modelId="{3C364A65-A083-482C-9177-00A5E1BA24FF}" type="presOf" srcId="{688BA2AE-1AEF-4C47-9BA9-D6761F2FE84B}" destId="{AB299217-BEB7-4637-8492-B505E68ABD2C}" srcOrd="0" destOrd="0" presId="urn:microsoft.com/office/officeart/2005/8/layout/orgChart1"/>
    <dgm:cxn modelId="{EAA20D9B-39E7-4BB5-B8A6-CE9B8F79E7A0}" srcId="{0EAF7C20-CBAE-4D32-A9CB-6E52C4C3E071}" destId="{EDA2A610-C40F-4E24-9E38-B25DD89570FB}" srcOrd="0" destOrd="0" parTransId="{B68430D6-70B9-474D-8DEF-16DD3B788079}" sibTransId="{494BABCF-5140-43D2-B10C-E7BDCB69FC21}"/>
    <dgm:cxn modelId="{CC630566-F059-4F5B-A867-FAA95A775859}" type="presOf" srcId="{8FC83D10-DBE6-4520-84AC-B5411B1C8627}" destId="{D1BC1C52-63A7-4755-B5F2-3483E2890746}" srcOrd="0" destOrd="0" presId="urn:microsoft.com/office/officeart/2005/8/layout/orgChart1"/>
    <dgm:cxn modelId="{C163FDB4-D289-4EE8-953C-6E7FC1716A3E}" type="presOf" srcId="{7E298A2F-377F-4C5A-9DA6-A854F892FDFE}" destId="{4B3901EF-3305-45FA-9275-1CFECD108D4D}" srcOrd="0" destOrd="0" presId="urn:microsoft.com/office/officeart/2005/8/layout/orgChart1"/>
    <dgm:cxn modelId="{8E94F22A-32B1-41C9-8DBC-02CFA1352118}" type="presOf" srcId="{500CADD1-C14C-4AA3-B63D-2FB9016CAE94}" destId="{DA903A5D-0E28-46B1-8951-FDDA59FBA092}" srcOrd="1" destOrd="0" presId="urn:microsoft.com/office/officeart/2005/8/layout/orgChart1"/>
    <dgm:cxn modelId="{FCA7E704-3D90-496A-888A-F7D41704EBEF}" type="presOf" srcId="{FF8F8B10-1A05-4657-A6DB-975C869102E1}" destId="{2DB0BC28-8ADA-49E3-A694-227E8E4646CC}" srcOrd="1" destOrd="0" presId="urn:microsoft.com/office/officeart/2005/8/layout/orgChart1"/>
    <dgm:cxn modelId="{F8C77A89-084B-48A9-A8A6-0D89A867B2C8}" type="presOf" srcId="{A58B3FA0-1A00-4058-A584-9E3A4B6CFB95}" destId="{554072B4-A9A5-458F-AE87-80CBC7BB0128}" srcOrd="1" destOrd="0" presId="urn:microsoft.com/office/officeart/2005/8/layout/orgChart1"/>
    <dgm:cxn modelId="{C03B5337-832E-4947-BF07-157A9D1A54C7}" srcId="{FF8F8B10-1A05-4657-A6DB-975C869102E1}" destId="{4A369978-7617-4015-9EEC-A63A54FEF33F}" srcOrd="0" destOrd="0" parTransId="{55CBABE7-7C84-43ED-9EDC-3D9098F08110}" sibTransId="{BC543AC7-49DA-44F7-9943-EDFBE9B49DE2}"/>
    <dgm:cxn modelId="{A469D6EA-E1E8-407A-B341-1A78D2E450B2}" type="presOf" srcId="{F4E45BD8-A30E-4F63-92EB-E022E1A1E217}" destId="{9A32E1B7-5DCB-4DBA-9DC3-26E913BD054E}" srcOrd="0" destOrd="0" presId="urn:microsoft.com/office/officeart/2005/8/layout/orgChart1"/>
    <dgm:cxn modelId="{F971EAF3-46BD-4267-B583-7C23D56F6165}" type="presOf" srcId="{0761D75F-B57D-44D7-B331-E18F28B5B8C4}" destId="{0AAD6B9C-DC8C-4A8F-A19E-30A8088DC536}" srcOrd="1" destOrd="0" presId="urn:microsoft.com/office/officeart/2005/8/layout/orgChart1"/>
    <dgm:cxn modelId="{76B9C18B-0B93-49DD-9F78-DD0F120DB497}" type="presOf" srcId="{4A369978-7617-4015-9EEC-A63A54FEF33F}" destId="{540EA148-831F-4B59-A5CA-0BC58D7BA3A2}" srcOrd="0" destOrd="0" presId="urn:microsoft.com/office/officeart/2005/8/layout/orgChart1"/>
    <dgm:cxn modelId="{C525FC21-D800-4EB8-952C-FC6027982D4E}" srcId="{7E298A2F-377F-4C5A-9DA6-A854F892FDFE}" destId="{500CADD1-C14C-4AA3-B63D-2FB9016CAE94}" srcOrd="1" destOrd="0" parTransId="{A199DCC7-F65E-4F6C-B747-FB3FBCBEB0B7}" sibTransId="{75502509-D7A0-456C-B7ED-24BA9970F12F}"/>
    <dgm:cxn modelId="{C24A642E-4F98-4545-933F-14D36ECDC9E0}" type="presOf" srcId="{548E438E-8D59-4080-B4D2-33A3EBBEB425}" destId="{69AA0C71-1162-4F86-BDD7-A361804246B2}" srcOrd="0" destOrd="0" presId="urn:microsoft.com/office/officeart/2005/8/layout/orgChart1"/>
    <dgm:cxn modelId="{7FE422AF-8FAB-4F5D-846B-5E87A525ED70}" srcId="{A58B3FA0-1A00-4058-A584-9E3A4B6CFB95}" destId="{688BA2AE-1AEF-4C47-9BA9-D6761F2FE84B}" srcOrd="0" destOrd="0" parTransId="{5F1BFEE2-C1CD-4275-AC77-5700C1EE7A2D}" sibTransId="{A2BF3AF5-51D6-4E62-AAEC-CC251C2C5B44}"/>
    <dgm:cxn modelId="{3809BA09-E2F2-449F-AB3F-B88C6FAA1260}" type="presOf" srcId="{1475DF99-894F-45BB-B64F-B5E80A8879DF}" destId="{723256B6-A72F-481C-B391-067AF3F0A50C}" srcOrd="0" destOrd="0" presId="urn:microsoft.com/office/officeart/2005/8/layout/orgChart1"/>
    <dgm:cxn modelId="{FE02EC11-FFA6-45C6-B57A-D5866071D660}" type="presOf" srcId="{688BA2AE-1AEF-4C47-9BA9-D6761F2FE84B}" destId="{910D08E7-A4FF-44DC-BF4F-A4FE87A2452E}" srcOrd="1" destOrd="0" presId="urn:microsoft.com/office/officeart/2005/8/layout/orgChart1"/>
    <dgm:cxn modelId="{FCECE671-F697-4858-9DC8-73AF72C1F3E5}" type="presOf" srcId="{13E58C4D-AAB1-4085-A3AF-1C1E950B5058}" destId="{205E5FAD-4BA7-4437-9BDF-36E798017B76}" srcOrd="0" destOrd="0" presId="urn:microsoft.com/office/officeart/2005/8/layout/orgChart1"/>
    <dgm:cxn modelId="{B4F30CA0-A25F-4074-9342-28AACB5D2ADA}" type="presOf" srcId="{FF8F8B10-1A05-4657-A6DB-975C869102E1}" destId="{316F7E75-2C53-44DA-9580-51F22722035A}" srcOrd="0" destOrd="0" presId="urn:microsoft.com/office/officeart/2005/8/layout/orgChart1"/>
    <dgm:cxn modelId="{D5467CEA-AEFD-46EC-A425-48A10BD076BA}" srcId="{13E58C4D-AAB1-4085-A3AF-1C1E950B5058}" destId="{FF8F8B10-1A05-4657-A6DB-975C869102E1}" srcOrd="0" destOrd="0" parTransId="{91E0B00C-AC89-4C08-AE0A-88264323875C}" sibTransId="{385E3AF5-CF82-4E73-A4F5-BFF98AF5BF2C}"/>
    <dgm:cxn modelId="{AFCCEBB1-9F34-4B4B-9940-C13E670F422B}" type="presOf" srcId="{9CD5F3DB-5E12-4C8E-83B4-2C084C60E153}" destId="{282D20FB-EED4-4247-8EA3-2A66D03125FB}" srcOrd="1" destOrd="0" presId="urn:microsoft.com/office/officeart/2005/8/layout/orgChart1"/>
    <dgm:cxn modelId="{69AFCAC6-C4E4-4B88-9E9E-E6F6094FE2A4}" srcId="{8FC83D10-DBE6-4520-84AC-B5411B1C8627}" destId="{B8CCAAA3-86AC-4434-948B-B01D3BB1C02A}" srcOrd="0" destOrd="0" parTransId="{71D572E1-46D3-4EE7-97AE-0205159016D8}" sibTransId="{E596BFAE-DC56-4C15-A159-310EFF4B3728}"/>
    <dgm:cxn modelId="{67A24804-8A44-4F8F-9743-609F808047BA}" type="presOf" srcId="{EDA2A610-C40F-4E24-9E38-B25DD89570FB}" destId="{BA83B136-A458-467B-AFA5-FD6C90A044E9}" srcOrd="1" destOrd="0" presId="urn:microsoft.com/office/officeart/2005/8/layout/orgChart1"/>
    <dgm:cxn modelId="{2BEB1F8D-DD3B-4C16-95AA-EE1169759E4A}" type="presOf" srcId="{BFC8376F-613B-41FC-827D-EF14F383F6D4}" destId="{537CABBE-B7C2-40B7-A99D-BC27D1511C09}" srcOrd="0" destOrd="0" presId="urn:microsoft.com/office/officeart/2005/8/layout/orgChart1"/>
    <dgm:cxn modelId="{4DEB33EE-BBEC-46F5-A11C-3EED1BCE9254}" type="presOf" srcId="{0EAF7C20-CBAE-4D32-A9CB-6E52C4C3E071}" destId="{5F1983E5-E7CA-4AB5-B7FF-EBCFE89CB486}" srcOrd="1" destOrd="0" presId="urn:microsoft.com/office/officeart/2005/8/layout/orgChart1"/>
    <dgm:cxn modelId="{97B34D13-036C-4245-B3E5-6BFC139B9348}" type="presOf" srcId="{6904EFD8-FCC9-4362-8F06-D20345E1F52D}" destId="{32193677-9331-46DE-8ABB-3178A8E28ECC}" srcOrd="0" destOrd="0" presId="urn:microsoft.com/office/officeart/2005/8/layout/orgChart1"/>
    <dgm:cxn modelId="{484BC8CF-ADC6-4E26-A38A-329325E08B4D}" type="presOf" srcId="{5F1BFEE2-C1CD-4275-AC77-5700C1EE7A2D}" destId="{C63EA82D-BEFE-463A-BC48-457D1AEDD6FF}" srcOrd="0" destOrd="0" presId="urn:microsoft.com/office/officeart/2005/8/layout/orgChart1"/>
    <dgm:cxn modelId="{D7E96B39-F38D-4B36-9BF4-631E8AF1EC95}" type="presOf" srcId="{71D572E1-46D3-4EE7-97AE-0205159016D8}" destId="{631372C7-EBAD-4D65-9912-8B18643DCC8F}" srcOrd="0" destOrd="0" presId="urn:microsoft.com/office/officeart/2005/8/layout/orgChart1"/>
    <dgm:cxn modelId="{DB82D00F-61C2-4AD2-8638-87B3722AFB59}" type="presOf" srcId="{23C4A683-5925-43C9-AB86-E8210F1F7AF5}" destId="{CED15ED1-BE3F-4AB6-93AB-8C698EE46D06}" srcOrd="0" destOrd="0" presId="urn:microsoft.com/office/officeart/2005/8/layout/orgChart1"/>
    <dgm:cxn modelId="{CE10EA17-69E9-464A-B4B3-FCDFA38ABEB9}" type="presOf" srcId="{3ABCA396-4BE5-4F69-B333-DF5A1BE918E7}" destId="{BE0C8F46-ECE4-4D8B-9B56-1DBCA13D674E}" srcOrd="0" destOrd="0" presId="urn:microsoft.com/office/officeart/2005/8/layout/orgChart1"/>
    <dgm:cxn modelId="{3A59EBE7-3702-45E8-BAA0-6A669876CFAD}" type="presOf" srcId="{ADAA99C6-C743-4C4F-AF02-C6046061547E}" destId="{221F6026-D679-4E44-9D63-D929D9E7411A}" srcOrd="1" destOrd="0" presId="urn:microsoft.com/office/officeart/2005/8/layout/orgChart1"/>
    <dgm:cxn modelId="{EEC49850-FDF1-4CEB-AFD7-043A1A5D5BD3}" type="presOf" srcId="{F4E45BD8-A30E-4F63-92EB-E022E1A1E217}" destId="{434C71B0-A2E1-4840-BDCF-79E599AFF9FA}" srcOrd="1" destOrd="0" presId="urn:microsoft.com/office/officeart/2005/8/layout/orgChart1"/>
    <dgm:cxn modelId="{3CB13191-A53E-4C46-9053-D1B1B0EF5D42}" type="presOf" srcId="{0EAF7C20-CBAE-4D32-A9CB-6E52C4C3E071}" destId="{2BA45C4B-EB5D-4ECB-A1DD-1E21ACDE15B8}" srcOrd="0" destOrd="0" presId="urn:microsoft.com/office/officeart/2005/8/layout/orgChart1"/>
    <dgm:cxn modelId="{59CD239B-EED0-450A-987B-A6B943A10039}" srcId="{9CD5F3DB-5E12-4C8E-83B4-2C084C60E153}" destId="{F4E45BD8-A30E-4F63-92EB-E022E1A1E217}" srcOrd="0" destOrd="0" parTransId="{5BD6E1A2-3370-4BA2-8FA5-5D8F554FD060}" sibTransId="{0111840D-327F-44F2-BECD-38700DC1FEE7}"/>
    <dgm:cxn modelId="{9DB43C8C-03FA-471D-99B3-CFD7AC560AC7}" type="presOf" srcId="{EDA2A610-C40F-4E24-9E38-B25DD89570FB}" destId="{9D6375D5-4A12-4E0F-A54C-3318F6594B0A}" srcOrd="0" destOrd="0" presId="urn:microsoft.com/office/officeart/2005/8/layout/orgChart1"/>
    <dgm:cxn modelId="{94271D23-9F37-422C-91EB-7A6B03BB0E35}" type="presOf" srcId="{0761D75F-B57D-44D7-B331-E18F28B5B8C4}" destId="{62731CA0-C3BB-47B6-A1AC-45EF69306C69}" srcOrd="0" destOrd="0" presId="urn:microsoft.com/office/officeart/2005/8/layout/orgChart1"/>
    <dgm:cxn modelId="{BCFDB264-7F40-4500-94E3-DF679E249F45}" srcId="{7E298A2F-377F-4C5A-9DA6-A854F892FDFE}" destId="{BFC8376F-613B-41FC-827D-EF14F383F6D4}" srcOrd="0" destOrd="0" parTransId="{85B1BB08-F3ED-4F9B-A7AC-A783C01BA4CA}" sibTransId="{346FA024-9F52-463B-8AA6-955412A354DE}"/>
    <dgm:cxn modelId="{2EAA56EE-6507-455E-94E5-6F2EF800D6F6}" type="presOf" srcId="{500CADD1-C14C-4AA3-B63D-2FB9016CAE94}" destId="{75159275-F1FF-4249-B1FB-B4E2948EED4B}" srcOrd="0" destOrd="0" presId="urn:microsoft.com/office/officeart/2005/8/layout/orgChart1"/>
    <dgm:cxn modelId="{34DC2A79-3C7B-49A5-8B97-101D89AA1412}" type="presOf" srcId="{DCE2C748-9943-4874-8A80-1BA380733CBC}" destId="{EE46DB7E-DFA6-4EE7-B928-53A393BD8D10}" srcOrd="0" destOrd="0" presId="urn:microsoft.com/office/officeart/2005/8/layout/orgChart1"/>
    <dgm:cxn modelId="{73FBB1DE-0717-4D17-A879-2F834E247369}" srcId="{FF8F8B10-1A05-4657-A6DB-975C869102E1}" destId="{7E298A2F-377F-4C5A-9DA6-A854F892FDFE}" srcOrd="1" destOrd="0" parTransId="{79358810-750E-4E9F-A86D-31A8C2155268}" sibTransId="{A98CB2AA-A63A-4D4E-8475-8EA5B843DE32}"/>
    <dgm:cxn modelId="{361A50A8-C04D-4AA2-9B2D-75FB35B3901F}" type="presOf" srcId="{BFC8376F-613B-41FC-827D-EF14F383F6D4}" destId="{2A16A8E3-CB8E-414C-8B4D-AC881884DCD5}" srcOrd="1" destOrd="0" presId="urn:microsoft.com/office/officeart/2005/8/layout/orgChart1"/>
    <dgm:cxn modelId="{9145C4A0-385B-42F3-BAE2-86FE7CCF2B8D}" srcId="{F4E45BD8-A30E-4F63-92EB-E022E1A1E217}" destId="{0EAF7C20-CBAE-4D32-A9CB-6E52C4C3E071}" srcOrd="0" destOrd="0" parTransId="{270C3E90-0605-4A24-8731-391097A12A8E}" sibTransId="{5371B091-8FCA-4F11-97A3-9A0A2D0B50DD}"/>
    <dgm:cxn modelId="{57C5F78E-2E2B-476C-88CC-388F509FB7AD}" type="presOf" srcId="{38C68CED-5900-4444-A22A-934FEE4D29B2}" destId="{CAF52C0B-CD12-4E72-818C-A64BD411952C}" srcOrd="0" destOrd="0" presId="urn:microsoft.com/office/officeart/2005/8/layout/orgChart1"/>
    <dgm:cxn modelId="{1DA37869-B24D-468A-873F-A40A88E2B427}" type="presOf" srcId="{92ABDE10-7240-4297-8E4A-25FBA1E36AA4}" destId="{096C6924-E277-4E36-BE1E-21B979E93C0A}" srcOrd="0" destOrd="0" presId="urn:microsoft.com/office/officeart/2005/8/layout/orgChart1"/>
    <dgm:cxn modelId="{143343C6-3E4F-43F3-ACC4-661AA2E69988}" type="presOf" srcId="{8E53683D-2C51-4DAD-A311-ECD00C280D9F}" destId="{FBCCC868-4018-4775-9E5C-F114D979F4A5}" srcOrd="0" destOrd="0" presId="urn:microsoft.com/office/officeart/2005/8/layout/orgChart1"/>
    <dgm:cxn modelId="{2ABCC6CA-E616-442B-AA83-C5DE725F9BD6}" type="presOf" srcId="{A199DCC7-F65E-4F6C-B747-FB3FBCBEB0B7}" destId="{8C62BEED-2FF8-45C3-B01B-6BB0A0FA8AAC}" srcOrd="0" destOrd="0" presId="urn:microsoft.com/office/officeart/2005/8/layout/orgChart1"/>
    <dgm:cxn modelId="{A1E377B4-A6B1-4D41-B012-D2B79D67A41F}" type="presOf" srcId="{548E438E-8D59-4080-B4D2-33A3EBBEB425}" destId="{831C8BB6-BDF6-4F98-A94A-3EA500E39DFA}" srcOrd="1" destOrd="0" presId="urn:microsoft.com/office/officeart/2005/8/layout/orgChart1"/>
    <dgm:cxn modelId="{4FB659C7-C8B0-43AF-BF3E-F6F27C816D92}" type="presOf" srcId="{55CBABE7-7C84-43ED-9EDC-3D9098F08110}" destId="{8E25F900-08B2-46B1-B63F-BD507D7D18E6}" srcOrd="0" destOrd="0" presId="urn:microsoft.com/office/officeart/2005/8/layout/orgChart1"/>
    <dgm:cxn modelId="{2C7F980B-F9CE-460C-AAD2-A2718D9E4B4D}" srcId="{548E438E-8D59-4080-B4D2-33A3EBBEB425}" destId="{9CD5F3DB-5E12-4C8E-83B4-2C084C60E153}" srcOrd="0" destOrd="0" parTransId="{C84046E8-30BD-4605-92AD-411E04CD1A7B}" sibTransId="{A8346438-209A-4B61-9255-640A26940A48}"/>
    <dgm:cxn modelId="{90B2B214-CD6D-4E1D-8CB2-888D3A22B301}" type="presOf" srcId="{ADAA99C6-C743-4C4F-AF02-C6046061547E}" destId="{5DE326EE-9851-434C-8EDC-05276E75C0B8}" srcOrd="0" destOrd="0" presId="urn:microsoft.com/office/officeart/2005/8/layout/orgChart1"/>
    <dgm:cxn modelId="{FB56EA49-51E0-499A-B612-1384F236814F}" type="presOf" srcId="{5BD6E1A2-3370-4BA2-8FA5-5D8F554FD060}" destId="{EA154D89-DEA1-42C2-87BD-7D9536AA01AB}" srcOrd="0" destOrd="0" presId="urn:microsoft.com/office/officeart/2005/8/layout/orgChart1"/>
    <dgm:cxn modelId="{F5E94612-EE0B-482C-8213-CA483E14B3C4}" srcId="{0761D75F-B57D-44D7-B331-E18F28B5B8C4}" destId="{A58B3FA0-1A00-4058-A584-9E3A4B6CFB95}" srcOrd="1" destOrd="0" parTransId="{0353E4CA-5DA6-4706-8469-C14E4D6705B2}" sibTransId="{06CFF985-92A2-4773-BF58-D44000283468}"/>
    <dgm:cxn modelId="{CEA7628D-68B3-414E-9098-7D1DA38D71B4}" type="presOf" srcId="{9CD5F3DB-5E12-4C8E-83B4-2C084C60E153}" destId="{2D0B4369-25A7-4CC0-A231-FD6C16C23C1F}" srcOrd="0" destOrd="0" presId="urn:microsoft.com/office/officeart/2005/8/layout/orgChart1"/>
    <dgm:cxn modelId="{0BC5C0EA-BD10-43F2-882F-3316AA4FD891}" srcId="{B8CCAAA3-86AC-4434-948B-B01D3BB1C02A}" destId="{92ABDE10-7240-4297-8E4A-25FBA1E36AA4}" srcOrd="0" destOrd="0" parTransId="{A656F677-D583-486F-AEA5-FC5F6CF15C79}" sibTransId="{5B7AE2B2-91AF-4A43-A3A0-4AC86E7E65BA}"/>
    <dgm:cxn modelId="{8D7673DD-9260-4A83-A458-095DFAD52001}" type="presOf" srcId="{85B1BB08-F3ED-4F9B-A7AC-A783C01BA4CA}" destId="{B78914A4-EA34-47AF-8CBA-E2B8E236BAC2}" srcOrd="0" destOrd="0" presId="urn:microsoft.com/office/officeart/2005/8/layout/orgChart1"/>
    <dgm:cxn modelId="{007CF181-D790-4119-B736-A0086A2C2BDE}" srcId="{4A369978-7617-4015-9EEC-A63A54FEF33F}" destId="{548E438E-8D59-4080-B4D2-33A3EBBEB425}" srcOrd="0" destOrd="0" parTransId="{38C68CED-5900-4444-A22A-934FEE4D29B2}" sibTransId="{B1304F14-EE7D-44A2-B410-33E82C05CF23}"/>
    <dgm:cxn modelId="{38E7980C-6960-4F66-893D-256EA326688B}" type="presOf" srcId="{270C3E90-0605-4A24-8731-391097A12A8E}" destId="{9A455279-91E0-4465-8CD0-8A0BA40AF2F3}" srcOrd="0" destOrd="0" presId="urn:microsoft.com/office/officeart/2005/8/layout/orgChart1"/>
    <dgm:cxn modelId="{8F21DDCE-54A2-4878-AD25-CA2E4BB88E63}" srcId="{ADAA99C6-C743-4C4F-AF02-C6046061547E}" destId="{FFB1F9C0-C650-4E42-8480-B212E015433D}" srcOrd="0" destOrd="0" parTransId="{3ABCA396-4BE5-4F69-B333-DF5A1BE918E7}" sibTransId="{5C6428CB-0682-4F8E-B7C9-A16AC15C8A95}"/>
    <dgm:cxn modelId="{6C7FC52E-5CE8-4D20-A109-B341FB8B3FF4}" type="presParOf" srcId="{205E5FAD-4BA7-4437-9BDF-36E798017B76}" destId="{32030AD7-342B-4098-9CFB-B19B60A845D3}" srcOrd="0" destOrd="0" presId="urn:microsoft.com/office/officeart/2005/8/layout/orgChart1"/>
    <dgm:cxn modelId="{20A6ADCB-8706-4797-B526-6A94CA716D43}" type="presParOf" srcId="{32030AD7-342B-4098-9CFB-B19B60A845D3}" destId="{3021BDB3-FE66-4F80-B60F-FA4D81730228}" srcOrd="0" destOrd="0" presId="urn:microsoft.com/office/officeart/2005/8/layout/orgChart1"/>
    <dgm:cxn modelId="{37AE3ACA-6EBC-445C-9AF8-DB27AC2EB50F}" type="presParOf" srcId="{3021BDB3-FE66-4F80-B60F-FA4D81730228}" destId="{316F7E75-2C53-44DA-9580-51F22722035A}" srcOrd="0" destOrd="0" presId="urn:microsoft.com/office/officeart/2005/8/layout/orgChart1"/>
    <dgm:cxn modelId="{686603FC-BA44-4580-942E-AB1799018DD3}" type="presParOf" srcId="{3021BDB3-FE66-4F80-B60F-FA4D81730228}" destId="{2DB0BC28-8ADA-49E3-A694-227E8E4646CC}" srcOrd="1" destOrd="0" presId="urn:microsoft.com/office/officeart/2005/8/layout/orgChart1"/>
    <dgm:cxn modelId="{0A644EC2-1D18-412C-9981-A08DC1955CB8}" type="presParOf" srcId="{32030AD7-342B-4098-9CFB-B19B60A845D3}" destId="{EAA5CF52-EE7A-4C94-B402-696923B6660F}" srcOrd="1" destOrd="0" presId="urn:microsoft.com/office/officeart/2005/8/layout/orgChart1"/>
    <dgm:cxn modelId="{2D74633B-A601-4411-B971-A3089FC53A65}" type="presParOf" srcId="{EAA5CF52-EE7A-4C94-B402-696923B6660F}" destId="{8E25F900-08B2-46B1-B63F-BD507D7D18E6}" srcOrd="0" destOrd="0" presId="urn:microsoft.com/office/officeart/2005/8/layout/orgChart1"/>
    <dgm:cxn modelId="{99F8B0B4-76CA-44D3-A90E-0EECF4EA658E}" type="presParOf" srcId="{EAA5CF52-EE7A-4C94-B402-696923B6660F}" destId="{F6E4A7FB-F43A-455D-B80C-29057CB4594D}" srcOrd="1" destOrd="0" presId="urn:microsoft.com/office/officeart/2005/8/layout/orgChart1"/>
    <dgm:cxn modelId="{D81076FD-39AB-47AE-A2DB-85D00588C5DE}" type="presParOf" srcId="{F6E4A7FB-F43A-455D-B80C-29057CB4594D}" destId="{A6245810-1C37-43B2-80E3-C4F0D99211DA}" srcOrd="0" destOrd="0" presId="urn:microsoft.com/office/officeart/2005/8/layout/orgChart1"/>
    <dgm:cxn modelId="{5B4D00DA-4042-4A2E-92F8-083A4FA32D51}" type="presParOf" srcId="{A6245810-1C37-43B2-80E3-C4F0D99211DA}" destId="{540EA148-831F-4B59-A5CA-0BC58D7BA3A2}" srcOrd="0" destOrd="0" presId="urn:microsoft.com/office/officeart/2005/8/layout/orgChart1"/>
    <dgm:cxn modelId="{8F982B10-8987-4DEE-A715-888A7FBBC672}" type="presParOf" srcId="{A6245810-1C37-43B2-80E3-C4F0D99211DA}" destId="{DA77AA64-0E26-4AC0-8DF6-A8A9AB145234}" srcOrd="1" destOrd="0" presId="urn:microsoft.com/office/officeart/2005/8/layout/orgChart1"/>
    <dgm:cxn modelId="{20EBB3DD-45F5-421B-AE15-C8CC34D2BF78}" type="presParOf" srcId="{F6E4A7FB-F43A-455D-B80C-29057CB4594D}" destId="{317C9588-3999-40F7-B64F-7D1715FA3C83}" srcOrd="1" destOrd="0" presId="urn:microsoft.com/office/officeart/2005/8/layout/orgChart1"/>
    <dgm:cxn modelId="{1DB7F280-5FC7-412E-AA59-2C786AD9DDB6}" type="presParOf" srcId="{317C9588-3999-40F7-B64F-7D1715FA3C83}" destId="{CAF52C0B-CD12-4E72-818C-A64BD411952C}" srcOrd="0" destOrd="0" presId="urn:microsoft.com/office/officeart/2005/8/layout/orgChart1"/>
    <dgm:cxn modelId="{1BCDA238-B285-4D8F-B264-080FF0269360}" type="presParOf" srcId="{317C9588-3999-40F7-B64F-7D1715FA3C83}" destId="{132B0015-A65D-48B2-BD34-04BF714FC7C6}" srcOrd="1" destOrd="0" presId="urn:microsoft.com/office/officeart/2005/8/layout/orgChart1"/>
    <dgm:cxn modelId="{ADA5D000-343A-4DBE-B858-57F471D156CD}" type="presParOf" srcId="{132B0015-A65D-48B2-BD34-04BF714FC7C6}" destId="{AE5745F2-8121-4D16-BD15-0A7D5E2E1102}" srcOrd="0" destOrd="0" presId="urn:microsoft.com/office/officeart/2005/8/layout/orgChart1"/>
    <dgm:cxn modelId="{1DEDBBC7-C6BD-44B7-8C2A-C0731A4C06D1}" type="presParOf" srcId="{AE5745F2-8121-4D16-BD15-0A7D5E2E1102}" destId="{69AA0C71-1162-4F86-BDD7-A361804246B2}" srcOrd="0" destOrd="0" presId="urn:microsoft.com/office/officeart/2005/8/layout/orgChart1"/>
    <dgm:cxn modelId="{ADB954E6-E2AC-48B0-B5DE-8DF73B91E86F}" type="presParOf" srcId="{AE5745F2-8121-4D16-BD15-0A7D5E2E1102}" destId="{831C8BB6-BDF6-4F98-A94A-3EA500E39DFA}" srcOrd="1" destOrd="0" presId="urn:microsoft.com/office/officeart/2005/8/layout/orgChart1"/>
    <dgm:cxn modelId="{48883051-6FA5-440E-B21D-8C62A2D0B37A}" type="presParOf" srcId="{132B0015-A65D-48B2-BD34-04BF714FC7C6}" destId="{70D53545-AD49-48BC-AE6A-6F0812EAE5DD}" srcOrd="1" destOrd="0" presId="urn:microsoft.com/office/officeart/2005/8/layout/orgChart1"/>
    <dgm:cxn modelId="{7940C3AE-713A-4B5A-995C-4BB234D2C530}" type="presParOf" srcId="{70D53545-AD49-48BC-AE6A-6F0812EAE5DD}" destId="{8C717FC1-4E3E-48F1-AA46-47DD2843595D}" srcOrd="0" destOrd="0" presId="urn:microsoft.com/office/officeart/2005/8/layout/orgChart1"/>
    <dgm:cxn modelId="{AC23A6EF-AE5B-451E-9C98-36882FD2F040}" type="presParOf" srcId="{70D53545-AD49-48BC-AE6A-6F0812EAE5DD}" destId="{E23E0C72-3D58-4E8D-9C14-35E8F0A0622E}" srcOrd="1" destOrd="0" presId="urn:microsoft.com/office/officeart/2005/8/layout/orgChart1"/>
    <dgm:cxn modelId="{F8ADB66C-392B-4370-832A-7ACB5DAEAF87}" type="presParOf" srcId="{E23E0C72-3D58-4E8D-9C14-35E8F0A0622E}" destId="{5EB56B5C-F9C5-43D3-8418-D17DBFA1DF27}" srcOrd="0" destOrd="0" presId="urn:microsoft.com/office/officeart/2005/8/layout/orgChart1"/>
    <dgm:cxn modelId="{1706DC64-FCE4-454C-AB12-224D8C21222D}" type="presParOf" srcId="{5EB56B5C-F9C5-43D3-8418-D17DBFA1DF27}" destId="{2D0B4369-25A7-4CC0-A231-FD6C16C23C1F}" srcOrd="0" destOrd="0" presId="urn:microsoft.com/office/officeart/2005/8/layout/orgChart1"/>
    <dgm:cxn modelId="{8DA51D09-9989-4F1B-899C-F9D6B7E4487E}" type="presParOf" srcId="{5EB56B5C-F9C5-43D3-8418-D17DBFA1DF27}" destId="{282D20FB-EED4-4247-8EA3-2A66D03125FB}" srcOrd="1" destOrd="0" presId="urn:microsoft.com/office/officeart/2005/8/layout/orgChart1"/>
    <dgm:cxn modelId="{3F182728-F490-4785-9E7A-B90723E02468}" type="presParOf" srcId="{E23E0C72-3D58-4E8D-9C14-35E8F0A0622E}" destId="{5D9479B4-54C8-4036-B6EB-0B43312DF847}" srcOrd="1" destOrd="0" presId="urn:microsoft.com/office/officeart/2005/8/layout/orgChart1"/>
    <dgm:cxn modelId="{D14EA3D2-FA51-4E96-9FD6-A9DD0BCDE740}" type="presParOf" srcId="{5D9479B4-54C8-4036-B6EB-0B43312DF847}" destId="{EA154D89-DEA1-42C2-87BD-7D9536AA01AB}" srcOrd="0" destOrd="0" presId="urn:microsoft.com/office/officeart/2005/8/layout/orgChart1"/>
    <dgm:cxn modelId="{55AD7E96-6803-4FF5-8097-526490E24D0B}" type="presParOf" srcId="{5D9479B4-54C8-4036-B6EB-0B43312DF847}" destId="{2277839E-DD98-482C-B645-156983945008}" srcOrd="1" destOrd="0" presId="urn:microsoft.com/office/officeart/2005/8/layout/orgChart1"/>
    <dgm:cxn modelId="{F1BDBA10-3EDA-483A-B171-56E08E1E0EC8}" type="presParOf" srcId="{2277839E-DD98-482C-B645-156983945008}" destId="{FE3903D6-8512-45E4-85B1-337A1FEDFE72}" srcOrd="0" destOrd="0" presId="urn:microsoft.com/office/officeart/2005/8/layout/orgChart1"/>
    <dgm:cxn modelId="{0DA55236-7A78-4507-9233-AFB46F52E99F}" type="presParOf" srcId="{FE3903D6-8512-45E4-85B1-337A1FEDFE72}" destId="{9A32E1B7-5DCB-4DBA-9DC3-26E913BD054E}" srcOrd="0" destOrd="0" presId="urn:microsoft.com/office/officeart/2005/8/layout/orgChart1"/>
    <dgm:cxn modelId="{B59E0A1C-E3CD-4594-9263-81F20A81AEA2}" type="presParOf" srcId="{FE3903D6-8512-45E4-85B1-337A1FEDFE72}" destId="{434C71B0-A2E1-4840-BDCF-79E599AFF9FA}" srcOrd="1" destOrd="0" presId="urn:microsoft.com/office/officeart/2005/8/layout/orgChart1"/>
    <dgm:cxn modelId="{4984EDF6-4729-4700-8C6D-E746C28A67FA}" type="presParOf" srcId="{2277839E-DD98-482C-B645-156983945008}" destId="{E1230EAF-BA05-476A-A248-36C2B8ECCA4D}" srcOrd="1" destOrd="0" presId="urn:microsoft.com/office/officeart/2005/8/layout/orgChart1"/>
    <dgm:cxn modelId="{5E38C0B0-B8A5-4E10-A665-E753D2260B82}" type="presParOf" srcId="{E1230EAF-BA05-476A-A248-36C2B8ECCA4D}" destId="{9A455279-91E0-4465-8CD0-8A0BA40AF2F3}" srcOrd="0" destOrd="0" presId="urn:microsoft.com/office/officeart/2005/8/layout/orgChart1"/>
    <dgm:cxn modelId="{60CF3CA8-1E83-4402-A87F-EF243ADFD8BC}" type="presParOf" srcId="{E1230EAF-BA05-476A-A248-36C2B8ECCA4D}" destId="{4B1DE711-CDE3-473E-BCD6-003B473F04C7}" srcOrd="1" destOrd="0" presId="urn:microsoft.com/office/officeart/2005/8/layout/orgChart1"/>
    <dgm:cxn modelId="{7E567107-59CF-4100-8F57-11ED95347BB7}" type="presParOf" srcId="{4B1DE711-CDE3-473E-BCD6-003B473F04C7}" destId="{C5613E25-CD6D-4A1C-BCD8-B51C4DAF34C5}" srcOrd="0" destOrd="0" presId="urn:microsoft.com/office/officeart/2005/8/layout/orgChart1"/>
    <dgm:cxn modelId="{634EFF8A-A8B0-4545-9203-12C3B8D502C3}" type="presParOf" srcId="{C5613E25-CD6D-4A1C-BCD8-B51C4DAF34C5}" destId="{2BA45C4B-EB5D-4ECB-A1DD-1E21ACDE15B8}" srcOrd="0" destOrd="0" presId="urn:microsoft.com/office/officeart/2005/8/layout/orgChart1"/>
    <dgm:cxn modelId="{B143333A-4433-421E-9B2A-46644801C7B7}" type="presParOf" srcId="{C5613E25-CD6D-4A1C-BCD8-B51C4DAF34C5}" destId="{5F1983E5-E7CA-4AB5-B7FF-EBCFE89CB486}" srcOrd="1" destOrd="0" presId="urn:microsoft.com/office/officeart/2005/8/layout/orgChart1"/>
    <dgm:cxn modelId="{372551D2-7C9A-4344-B4D8-856F171C6447}" type="presParOf" srcId="{4B1DE711-CDE3-473E-BCD6-003B473F04C7}" destId="{86E934BE-D151-4480-AB58-AE714B6D0C94}" srcOrd="1" destOrd="0" presId="urn:microsoft.com/office/officeart/2005/8/layout/orgChart1"/>
    <dgm:cxn modelId="{F9B695BD-BEFC-4B46-982C-C14000CF9E75}" type="presParOf" srcId="{86E934BE-D151-4480-AB58-AE714B6D0C94}" destId="{31ECBBA8-5795-4D4C-BF31-0C8EC1A75860}" srcOrd="0" destOrd="0" presId="urn:microsoft.com/office/officeart/2005/8/layout/orgChart1"/>
    <dgm:cxn modelId="{C3C863D6-03ED-4A39-AC61-AE1CE279655F}" type="presParOf" srcId="{86E934BE-D151-4480-AB58-AE714B6D0C94}" destId="{9282EBB8-C16A-4202-8981-6918876A0C14}" srcOrd="1" destOrd="0" presId="urn:microsoft.com/office/officeart/2005/8/layout/orgChart1"/>
    <dgm:cxn modelId="{26000D8D-111A-4413-9FCF-76B3F53574E6}" type="presParOf" srcId="{9282EBB8-C16A-4202-8981-6918876A0C14}" destId="{30711303-1A79-4BDD-B060-AAA383AC1DA7}" srcOrd="0" destOrd="0" presId="urn:microsoft.com/office/officeart/2005/8/layout/orgChart1"/>
    <dgm:cxn modelId="{6560DD2D-2966-4464-A31A-65978ACEEEAB}" type="presParOf" srcId="{30711303-1A79-4BDD-B060-AAA383AC1DA7}" destId="{9D6375D5-4A12-4E0F-A54C-3318F6594B0A}" srcOrd="0" destOrd="0" presId="urn:microsoft.com/office/officeart/2005/8/layout/orgChart1"/>
    <dgm:cxn modelId="{7280F7DB-7D07-422D-BD53-D87D388A5A29}" type="presParOf" srcId="{30711303-1A79-4BDD-B060-AAA383AC1DA7}" destId="{BA83B136-A458-467B-AFA5-FD6C90A044E9}" srcOrd="1" destOrd="0" presId="urn:microsoft.com/office/officeart/2005/8/layout/orgChart1"/>
    <dgm:cxn modelId="{5C4801DD-7CAE-4B20-9F0F-3C50F21F273D}" type="presParOf" srcId="{9282EBB8-C16A-4202-8981-6918876A0C14}" destId="{013311E3-7DCB-4E22-BACA-E26930C619D2}" srcOrd="1" destOrd="0" presId="urn:microsoft.com/office/officeart/2005/8/layout/orgChart1"/>
    <dgm:cxn modelId="{3A0ECCF8-D63E-407C-9A9B-A9794BEF8B9C}" type="presParOf" srcId="{9282EBB8-C16A-4202-8981-6918876A0C14}" destId="{B0540AE5-B328-4073-B4BB-345A3493678C}" srcOrd="2" destOrd="0" presId="urn:microsoft.com/office/officeart/2005/8/layout/orgChart1"/>
    <dgm:cxn modelId="{1B1C39EE-FF98-447B-9CCA-F8F96BCA02C9}" type="presParOf" srcId="{4B1DE711-CDE3-473E-BCD6-003B473F04C7}" destId="{EAD88EE6-2F6D-4BE4-9A01-91FDDFAB1FFB}" srcOrd="2" destOrd="0" presId="urn:microsoft.com/office/officeart/2005/8/layout/orgChart1"/>
    <dgm:cxn modelId="{3ABFF0F8-FF5E-4594-B39E-FFCA7E18AA52}" type="presParOf" srcId="{2277839E-DD98-482C-B645-156983945008}" destId="{AB9BF06F-7A5C-4613-9B31-B347AB14BCB7}" srcOrd="2" destOrd="0" presId="urn:microsoft.com/office/officeart/2005/8/layout/orgChart1"/>
    <dgm:cxn modelId="{11113DB3-6A87-48EC-8FED-D8FA04C93E03}" type="presParOf" srcId="{E23E0C72-3D58-4E8D-9C14-35E8F0A0622E}" destId="{764AB13D-D68E-4C09-A34F-4BD7276691AB}" srcOrd="2" destOrd="0" presId="urn:microsoft.com/office/officeart/2005/8/layout/orgChart1"/>
    <dgm:cxn modelId="{0D8FEB69-39A0-40B3-BA1D-B9BA00FDB4D3}" type="presParOf" srcId="{70D53545-AD49-48BC-AE6A-6F0812EAE5DD}" destId="{32193677-9331-46DE-8ABB-3178A8E28ECC}" srcOrd="2" destOrd="0" presId="urn:microsoft.com/office/officeart/2005/8/layout/orgChart1"/>
    <dgm:cxn modelId="{89257236-F00D-4475-8772-1649B83E26A3}" type="presParOf" srcId="{70D53545-AD49-48BC-AE6A-6F0812EAE5DD}" destId="{F0FA71D7-68BC-41C5-BE64-60644A58928E}" srcOrd="3" destOrd="0" presId="urn:microsoft.com/office/officeart/2005/8/layout/orgChart1"/>
    <dgm:cxn modelId="{D6421598-BD87-4EF0-83B2-E519AC3A48DD}" type="presParOf" srcId="{F0FA71D7-68BC-41C5-BE64-60644A58928E}" destId="{A4C9F0BB-E983-4EE6-83D1-F522891B2F6F}" srcOrd="0" destOrd="0" presId="urn:microsoft.com/office/officeart/2005/8/layout/orgChart1"/>
    <dgm:cxn modelId="{D17FFF07-36A5-4ED9-B68E-886DD21E1565}" type="presParOf" srcId="{A4C9F0BB-E983-4EE6-83D1-F522891B2F6F}" destId="{5DE326EE-9851-434C-8EDC-05276E75C0B8}" srcOrd="0" destOrd="0" presId="urn:microsoft.com/office/officeart/2005/8/layout/orgChart1"/>
    <dgm:cxn modelId="{D1F85B4A-4C80-400B-A9FE-53A7615F3295}" type="presParOf" srcId="{A4C9F0BB-E983-4EE6-83D1-F522891B2F6F}" destId="{221F6026-D679-4E44-9D63-D929D9E7411A}" srcOrd="1" destOrd="0" presId="urn:microsoft.com/office/officeart/2005/8/layout/orgChart1"/>
    <dgm:cxn modelId="{A47D6B02-1E4F-4CA7-9907-1130F25E4A28}" type="presParOf" srcId="{F0FA71D7-68BC-41C5-BE64-60644A58928E}" destId="{E68621AF-CB50-40B5-B115-593B0F9C4939}" srcOrd="1" destOrd="0" presId="urn:microsoft.com/office/officeart/2005/8/layout/orgChart1"/>
    <dgm:cxn modelId="{C598029E-F4E5-4204-B54C-FAE3B7D470AA}" type="presParOf" srcId="{E68621AF-CB50-40B5-B115-593B0F9C4939}" destId="{BE0C8F46-ECE4-4D8B-9B56-1DBCA13D674E}" srcOrd="0" destOrd="0" presId="urn:microsoft.com/office/officeart/2005/8/layout/orgChart1"/>
    <dgm:cxn modelId="{BCF67338-09CD-4087-8819-9043AC3E36B0}" type="presParOf" srcId="{E68621AF-CB50-40B5-B115-593B0F9C4939}" destId="{92EC5971-AA81-4155-BD52-3075708E27BF}" srcOrd="1" destOrd="0" presId="urn:microsoft.com/office/officeart/2005/8/layout/orgChart1"/>
    <dgm:cxn modelId="{D9A1FA46-AE55-4954-8749-00F9203FF7F5}" type="presParOf" srcId="{92EC5971-AA81-4155-BD52-3075708E27BF}" destId="{E0AEC89A-4363-4A05-A8B1-EA7D5AE1B8A3}" srcOrd="0" destOrd="0" presId="urn:microsoft.com/office/officeart/2005/8/layout/orgChart1"/>
    <dgm:cxn modelId="{4AF8CEF9-BA9E-4683-A31B-D55D542E1A1C}" type="presParOf" srcId="{E0AEC89A-4363-4A05-A8B1-EA7D5AE1B8A3}" destId="{735D910B-E050-4E92-8E02-BFAD2F2AD77A}" srcOrd="0" destOrd="0" presId="urn:microsoft.com/office/officeart/2005/8/layout/orgChart1"/>
    <dgm:cxn modelId="{CFAAFCCC-9D1C-4105-803F-E347A3654F48}" type="presParOf" srcId="{E0AEC89A-4363-4A05-A8B1-EA7D5AE1B8A3}" destId="{3BE2428E-085A-4A5A-924C-E26171F3D9C9}" srcOrd="1" destOrd="0" presId="urn:microsoft.com/office/officeart/2005/8/layout/orgChart1"/>
    <dgm:cxn modelId="{F2D52008-9C09-4F73-9B5D-0FB60E320474}" type="presParOf" srcId="{92EC5971-AA81-4155-BD52-3075708E27BF}" destId="{2BD73E50-53E8-4CB9-B666-D7967A68D388}" srcOrd="1" destOrd="0" presId="urn:microsoft.com/office/officeart/2005/8/layout/orgChart1"/>
    <dgm:cxn modelId="{A52329CF-AD99-42FB-86A1-C3AA20FF4B49}" type="presParOf" srcId="{92EC5971-AA81-4155-BD52-3075708E27BF}" destId="{D4E06BD2-33B9-4669-8B55-8250AE86A53B}" srcOrd="2" destOrd="0" presId="urn:microsoft.com/office/officeart/2005/8/layout/orgChart1"/>
    <dgm:cxn modelId="{23C726BE-9D04-48D1-BC42-0C03A2DF62D2}" type="presParOf" srcId="{F0FA71D7-68BC-41C5-BE64-60644A58928E}" destId="{10A2986A-E8CB-4421-A43B-651C49164573}" srcOrd="2" destOrd="0" presId="urn:microsoft.com/office/officeart/2005/8/layout/orgChart1"/>
    <dgm:cxn modelId="{076CB3D9-1106-46AB-8389-2B4F54607776}" type="presParOf" srcId="{132B0015-A65D-48B2-BD34-04BF714FC7C6}" destId="{4F03BCC2-8A42-49BC-A83F-806226A3E10C}" srcOrd="2" destOrd="0" presId="urn:microsoft.com/office/officeart/2005/8/layout/orgChart1"/>
    <dgm:cxn modelId="{5796D880-A7EF-454F-ACF7-3FCABC64AB22}" type="presParOf" srcId="{F6E4A7FB-F43A-455D-B80C-29057CB4594D}" destId="{BAF556EF-DE82-47AA-81BE-5AFFF44283C6}" srcOrd="2" destOrd="0" presId="urn:microsoft.com/office/officeart/2005/8/layout/orgChart1"/>
    <dgm:cxn modelId="{5CE927B2-47B9-4CA5-973E-D4E51CD9B452}" type="presParOf" srcId="{EAA5CF52-EE7A-4C94-B402-696923B6660F}" destId="{219BAF5B-EC7A-424B-986A-B1E37CCDAFA5}" srcOrd="2" destOrd="0" presId="urn:microsoft.com/office/officeart/2005/8/layout/orgChart1"/>
    <dgm:cxn modelId="{149BBE42-3A8D-4B04-87A6-DD463123C432}" type="presParOf" srcId="{EAA5CF52-EE7A-4C94-B402-696923B6660F}" destId="{E34AF575-7542-4EA8-8257-7B024E767079}" srcOrd="3" destOrd="0" presId="urn:microsoft.com/office/officeart/2005/8/layout/orgChart1"/>
    <dgm:cxn modelId="{43808BA5-32C5-44B4-BEC3-442D699E22E6}" type="presParOf" srcId="{E34AF575-7542-4EA8-8257-7B024E767079}" destId="{0B38B274-E533-447C-9E91-70E6ABAD55CF}" srcOrd="0" destOrd="0" presId="urn:microsoft.com/office/officeart/2005/8/layout/orgChart1"/>
    <dgm:cxn modelId="{96A0A8FC-1E3F-49B0-BDFE-2DC4A66924D2}" type="presParOf" srcId="{0B38B274-E533-447C-9E91-70E6ABAD55CF}" destId="{4B3901EF-3305-45FA-9275-1CFECD108D4D}" srcOrd="0" destOrd="0" presId="urn:microsoft.com/office/officeart/2005/8/layout/orgChart1"/>
    <dgm:cxn modelId="{910E5275-91BF-425C-A599-0CC10746D827}" type="presParOf" srcId="{0B38B274-E533-447C-9E91-70E6ABAD55CF}" destId="{81E99CB7-DFDA-4BC7-9FC3-0ED7A9E42B7B}" srcOrd="1" destOrd="0" presId="urn:microsoft.com/office/officeart/2005/8/layout/orgChart1"/>
    <dgm:cxn modelId="{0B648C38-B56B-4BE8-A2D7-55BE2663C954}" type="presParOf" srcId="{E34AF575-7542-4EA8-8257-7B024E767079}" destId="{BF163086-CC9E-45EF-B244-732BC048E632}" srcOrd="1" destOrd="0" presId="urn:microsoft.com/office/officeart/2005/8/layout/orgChart1"/>
    <dgm:cxn modelId="{91493B09-47D9-4100-9685-5DF617D60E2B}" type="presParOf" srcId="{BF163086-CC9E-45EF-B244-732BC048E632}" destId="{B78914A4-EA34-47AF-8CBA-E2B8E236BAC2}" srcOrd="0" destOrd="0" presId="urn:microsoft.com/office/officeart/2005/8/layout/orgChart1"/>
    <dgm:cxn modelId="{28E9C234-8C7F-46EC-8F11-6A1AFCBBAF6A}" type="presParOf" srcId="{BF163086-CC9E-45EF-B244-732BC048E632}" destId="{157E5380-8DA1-46EE-AE32-BD847F9DCA35}" srcOrd="1" destOrd="0" presId="urn:microsoft.com/office/officeart/2005/8/layout/orgChart1"/>
    <dgm:cxn modelId="{FE89B4F4-160F-4FE5-B617-9F064B035C60}" type="presParOf" srcId="{157E5380-8DA1-46EE-AE32-BD847F9DCA35}" destId="{211A602F-F136-4DAD-8D33-7C2549E096FE}" srcOrd="0" destOrd="0" presId="urn:microsoft.com/office/officeart/2005/8/layout/orgChart1"/>
    <dgm:cxn modelId="{86A782D5-6EB5-45C4-9397-B977DAD13A8A}" type="presParOf" srcId="{211A602F-F136-4DAD-8D33-7C2549E096FE}" destId="{537CABBE-B7C2-40B7-A99D-BC27D1511C09}" srcOrd="0" destOrd="0" presId="urn:microsoft.com/office/officeart/2005/8/layout/orgChart1"/>
    <dgm:cxn modelId="{913C53FF-B62A-4805-A972-7A89B6228C2F}" type="presParOf" srcId="{211A602F-F136-4DAD-8D33-7C2549E096FE}" destId="{2A16A8E3-CB8E-414C-8B4D-AC881884DCD5}" srcOrd="1" destOrd="0" presId="urn:microsoft.com/office/officeart/2005/8/layout/orgChart1"/>
    <dgm:cxn modelId="{655EA811-9926-44C9-880A-42618631F94D}" type="presParOf" srcId="{157E5380-8DA1-46EE-AE32-BD847F9DCA35}" destId="{75597123-3A0E-4146-9DEC-5CE03E2BC89A}" srcOrd="1" destOrd="0" presId="urn:microsoft.com/office/officeart/2005/8/layout/orgChart1"/>
    <dgm:cxn modelId="{A17A4E33-3D3F-4BA2-A785-EF47E5168D09}" type="presParOf" srcId="{75597123-3A0E-4146-9DEC-5CE03E2BC89A}" destId="{FBCCC868-4018-4775-9E5C-F114D979F4A5}" srcOrd="0" destOrd="0" presId="urn:microsoft.com/office/officeart/2005/8/layout/orgChart1"/>
    <dgm:cxn modelId="{0C151E9F-C036-485A-8D46-96E0D15097F3}" type="presParOf" srcId="{75597123-3A0E-4146-9DEC-5CE03E2BC89A}" destId="{FA2CA2F9-8B1D-4124-8BB9-61B82A7C07F6}" srcOrd="1" destOrd="0" presId="urn:microsoft.com/office/officeart/2005/8/layout/orgChart1"/>
    <dgm:cxn modelId="{47AD9D5E-9FB4-4CBF-BD55-91E5732D4E84}" type="presParOf" srcId="{FA2CA2F9-8B1D-4124-8BB9-61B82A7C07F6}" destId="{9630A865-AC2E-463F-9B6B-4A81D70A1C7A}" srcOrd="0" destOrd="0" presId="urn:microsoft.com/office/officeart/2005/8/layout/orgChart1"/>
    <dgm:cxn modelId="{EC9F1A4D-3F29-4768-9B76-524D59843280}" type="presParOf" srcId="{9630A865-AC2E-463F-9B6B-4A81D70A1C7A}" destId="{CED15ED1-BE3F-4AB6-93AB-8C698EE46D06}" srcOrd="0" destOrd="0" presId="urn:microsoft.com/office/officeart/2005/8/layout/orgChart1"/>
    <dgm:cxn modelId="{5BF9E60F-D444-4DE1-B6D7-5044DC2374B2}" type="presParOf" srcId="{9630A865-AC2E-463F-9B6B-4A81D70A1C7A}" destId="{A07B5381-1146-4D2D-9C40-E8E8C206B6C2}" srcOrd="1" destOrd="0" presId="urn:microsoft.com/office/officeart/2005/8/layout/orgChart1"/>
    <dgm:cxn modelId="{765127AB-CD94-47CD-B559-023A2D37B7E5}" type="presParOf" srcId="{FA2CA2F9-8B1D-4124-8BB9-61B82A7C07F6}" destId="{328A34AE-8890-4217-B64F-5E418287B91F}" srcOrd="1" destOrd="0" presId="urn:microsoft.com/office/officeart/2005/8/layout/orgChart1"/>
    <dgm:cxn modelId="{D035C54F-8412-469D-9B86-577409A672C8}" type="presParOf" srcId="{FA2CA2F9-8B1D-4124-8BB9-61B82A7C07F6}" destId="{193D35EC-F2E8-4BBD-987C-168879245712}" srcOrd="2" destOrd="0" presId="urn:microsoft.com/office/officeart/2005/8/layout/orgChart1"/>
    <dgm:cxn modelId="{DF6FB3A2-6ECF-4720-A35B-9560D5AB6FA7}" type="presParOf" srcId="{157E5380-8DA1-46EE-AE32-BD847F9DCA35}" destId="{CECE8821-860A-4950-B0FD-95662D85730E}" srcOrd="2" destOrd="0" presId="urn:microsoft.com/office/officeart/2005/8/layout/orgChart1"/>
    <dgm:cxn modelId="{3E0581AC-0ABC-40EF-912C-4557E9471A3A}" type="presParOf" srcId="{BF163086-CC9E-45EF-B244-732BC048E632}" destId="{8C62BEED-2FF8-45C3-B01B-6BB0A0FA8AAC}" srcOrd="2" destOrd="0" presId="urn:microsoft.com/office/officeart/2005/8/layout/orgChart1"/>
    <dgm:cxn modelId="{4C3E4AE1-73B1-4E21-9819-6CABF9B891B3}" type="presParOf" srcId="{BF163086-CC9E-45EF-B244-732BC048E632}" destId="{23CAD4E0-E7F9-4A99-9D88-FF66A8ACB62E}" srcOrd="3" destOrd="0" presId="urn:microsoft.com/office/officeart/2005/8/layout/orgChart1"/>
    <dgm:cxn modelId="{BC40682B-5EE4-46D7-B47A-3D4FC29B43A2}" type="presParOf" srcId="{23CAD4E0-E7F9-4A99-9D88-FF66A8ACB62E}" destId="{A5977595-182C-4756-9C28-2C239DDC189C}" srcOrd="0" destOrd="0" presId="urn:microsoft.com/office/officeart/2005/8/layout/orgChart1"/>
    <dgm:cxn modelId="{0A067448-2F11-4241-B30C-BE02CA9173DC}" type="presParOf" srcId="{A5977595-182C-4756-9C28-2C239DDC189C}" destId="{75159275-F1FF-4249-B1FB-B4E2948EED4B}" srcOrd="0" destOrd="0" presId="urn:microsoft.com/office/officeart/2005/8/layout/orgChart1"/>
    <dgm:cxn modelId="{3B1F3155-F07F-4102-9E50-DF148966B3DA}" type="presParOf" srcId="{A5977595-182C-4756-9C28-2C239DDC189C}" destId="{DA903A5D-0E28-46B1-8951-FDDA59FBA092}" srcOrd="1" destOrd="0" presId="urn:microsoft.com/office/officeart/2005/8/layout/orgChart1"/>
    <dgm:cxn modelId="{4577562B-4977-4EBB-AC9A-F2F3F82A48D4}" type="presParOf" srcId="{23CAD4E0-E7F9-4A99-9D88-FF66A8ACB62E}" destId="{DB278AA9-B573-40D4-B195-A75C103FC38B}" srcOrd="1" destOrd="0" presId="urn:microsoft.com/office/officeart/2005/8/layout/orgChart1"/>
    <dgm:cxn modelId="{CFB99990-4246-4EEB-823D-3B6060C7FCDA}" type="presParOf" srcId="{DB278AA9-B573-40D4-B195-A75C103FC38B}" destId="{723256B6-A72F-481C-B391-067AF3F0A50C}" srcOrd="0" destOrd="0" presId="urn:microsoft.com/office/officeart/2005/8/layout/orgChart1"/>
    <dgm:cxn modelId="{3D24A16E-6BFB-48FD-A0DB-B47EC6B3083E}" type="presParOf" srcId="{DB278AA9-B573-40D4-B195-A75C103FC38B}" destId="{12FF6F10-E9A4-4B54-95B5-1E3B8EDEEF3E}" srcOrd="1" destOrd="0" presId="urn:microsoft.com/office/officeart/2005/8/layout/orgChart1"/>
    <dgm:cxn modelId="{03FA9448-C797-4365-A988-73D090EEDE3E}" type="presParOf" srcId="{12FF6F10-E9A4-4B54-95B5-1E3B8EDEEF3E}" destId="{83769434-3E5F-4DAF-9F14-C9FF12F51511}" srcOrd="0" destOrd="0" presId="urn:microsoft.com/office/officeart/2005/8/layout/orgChart1"/>
    <dgm:cxn modelId="{F7B64A16-0AC6-4A06-AAA1-9EDF5CA3FBCC}" type="presParOf" srcId="{83769434-3E5F-4DAF-9F14-C9FF12F51511}" destId="{62731CA0-C3BB-47B6-A1AC-45EF69306C69}" srcOrd="0" destOrd="0" presId="urn:microsoft.com/office/officeart/2005/8/layout/orgChart1"/>
    <dgm:cxn modelId="{CE0F6EA4-ED28-4784-8864-501A9DBE76BD}" type="presParOf" srcId="{83769434-3E5F-4DAF-9F14-C9FF12F51511}" destId="{0AAD6B9C-DC8C-4A8F-A19E-30A8088DC536}" srcOrd="1" destOrd="0" presId="urn:microsoft.com/office/officeart/2005/8/layout/orgChart1"/>
    <dgm:cxn modelId="{F49E8064-769B-442D-ACB3-8A773EA1CA3D}" type="presParOf" srcId="{12FF6F10-E9A4-4B54-95B5-1E3B8EDEEF3E}" destId="{D1A22180-CD3E-4968-8050-D2CE617605DF}" srcOrd="1" destOrd="0" presId="urn:microsoft.com/office/officeart/2005/8/layout/orgChart1"/>
    <dgm:cxn modelId="{BFE4D729-376B-4623-B891-1E9C402D1B65}" type="presParOf" srcId="{D1A22180-CD3E-4968-8050-D2CE617605DF}" destId="{EE46DB7E-DFA6-4EE7-B928-53A393BD8D10}" srcOrd="0" destOrd="0" presId="urn:microsoft.com/office/officeart/2005/8/layout/orgChart1"/>
    <dgm:cxn modelId="{804EE9DE-DE28-4052-97A5-B52DB61B16E4}" type="presParOf" srcId="{D1A22180-CD3E-4968-8050-D2CE617605DF}" destId="{619C66DE-5618-4934-9F35-01949BC36E23}" srcOrd="1" destOrd="0" presId="urn:microsoft.com/office/officeart/2005/8/layout/orgChart1"/>
    <dgm:cxn modelId="{E38CAECA-03F0-485E-9AB7-F1CAB112EF80}" type="presParOf" srcId="{619C66DE-5618-4934-9F35-01949BC36E23}" destId="{D6BFE26A-4868-4C3C-A54F-B1A2CAC97C04}" srcOrd="0" destOrd="0" presId="urn:microsoft.com/office/officeart/2005/8/layout/orgChart1"/>
    <dgm:cxn modelId="{9791C0E5-D53D-42FD-9F50-CF80A68CD698}" type="presParOf" srcId="{D6BFE26A-4868-4C3C-A54F-B1A2CAC97C04}" destId="{D1BC1C52-63A7-4755-B5F2-3483E2890746}" srcOrd="0" destOrd="0" presId="urn:microsoft.com/office/officeart/2005/8/layout/orgChart1"/>
    <dgm:cxn modelId="{0A092D23-2BB8-48F9-A8FB-1FD559D9D507}" type="presParOf" srcId="{D6BFE26A-4868-4C3C-A54F-B1A2CAC97C04}" destId="{ABA81EAF-8911-4D48-81E7-0BBD27A7DD0D}" srcOrd="1" destOrd="0" presId="urn:microsoft.com/office/officeart/2005/8/layout/orgChart1"/>
    <dgm:cxn modelId="{62D74260-0F49-4ED4-8267-E03698462839}" type="presParOf" srcId="{619C66DE-5618-4934-9F35-01949BC36E23}" destId="{A5E11DF6-4225-4204-9CFF-49B5371345C1}" srcOrd="1" destOrd="0" presId="urn:microsoft.com/office/officeart/2005/8/layout/orgChart1"/>
    <dgm:cxn modelId="{210AC7F3-E28C-4800-BFFF-A329E84760E4}" type="presParOf" srcId="{A5E11DF6-4225-4204-9CFF-49B5371345C1}" destId="{631372C7-EBAD-4D65-9912-8B18643DCC8F}" srcOrd="0" destOrd="0" presId="urn:microsoft.com/office/officeart/2005/8/layout/orgChart1"/>
    <dgm:cxn modelId="{A2B3F585-40EF-41B2-B326-D76BC142DA1A}" type="presParOf" srcId="{A5E11DF6-4225-4204-9CFF-49B5371345C1}" destId="{8A2D374B-458A-4AF3-84A5-B34072BB706B}" srcOrd="1" destOrd="0" presId="urn:microsoft.com/office/officeart/2005/8/layout/orgChart1"/>
    <dgm:cxn modelId="{648925B6-3F51-45EC-99FC-55DA4662886E}" type="presParOf" srcId="{8A2D374B-458A-4AF3-84A5-B34072BB706B}" destId="{7433A366-CF83-4C3C-9B81-960A13BD1D80}" srcOrd="0" destOrd="0" presId="urn:microsoft.com/office/officeart/2005/8/layout/orgChart1"/>
    <dgm:cxn modelId="{E1C014AA-135F-4B61-A070-9791C1702706}" type="presParOf" srcId="{7433A366-CF83-4C3C-9B81-960A13BD1D80}" destId="{AF715ACC-4D12-4228-B645-24C45F97D853}" srcOrd="0" destOrd="0" presId="urn:microsoft.com/office/officeart/2005/8/layout/orgChart1"/>
    <dgm:cxn modelId="{FAB64D13-31D7-4DE3-A0D0-0B406FA3E776}" type="presParOf" srcId="{7433A366-CF83-4C3C-9B81-960A13BD1D80}" destId="{8AC7CA92-0903-4D77-BD81-4082BFB8F61A}" srcOrd="1" destOrd="0" presId="urn:microsoft.com/office/officeart/2005/8/layout/orgChart1"/>
    <dgm:cxn modelId="{7074B786-00D4-4343-B030-AABF2400EF27}" type="presParOf" srcId="{8A2D374B-458A-4AF3-84A5-B34072BB706B}" destId="{8C1A34B1-B902-45DF-9044-ED6B8B5CE4B7}" srcOrd="1" destOrd="0" presId="urn:microsoft.com/office/officeart/2005/8/layout/orgChart1"/>
    <dgm:cxn modelId="{4E83422C-E4B6-48C2-A7BB-8CD37777E563}" type="presParOf" srcId="{8C1A34B1-B902-45DF-9044-ED6B8B5CE4B7}" destId="{AD9931AB-5D63-4E48-95CD-8ECFF39ABB92}" srcOrd="0" destOrd="0" presId="urn:microsoft.com/office/officeart/2005/8/layout/orgChart1"/>
    <dgm:cxn modelId="{AFF44820-1014-4D61-839A-B75691C61B8E}" type="presParOf" srcId="{8C1A34B1-B902-45DF-9044-ED6B8B5CE4B7}" destId="{D63E330B-508D-440B-BD55-89CC6D35F938}" srcOrd="1" destOrd="0" presId="urn:microsoft.com/office/officeart/2005/8/layout/orgChart1"/>
    <dgm:cxn modelId="{16C81020-134B-46AD-A0E8-1708ABBAA61D}" type="presParOf" srcId="{D63E330B-508D-440B-BD55-89CC6D35F938}" destId="{1AB85D30-1D40-42E3-A8DB-C9F1D815B6B4}" srcOrd="0" destOrd="0" presId="urn:microsoft.com/office/officeart/2005/8/layout/orgChart1"/>
    <dgm:cxn modelId="{85BC188F-D817-46EE-AEFA-2029B5F309AD}" type="presParOf" srcId="{1AB85D30-1D40-42E3-A8DB-C9F1D815B6B4}" destId="{096C6924-E277-4E36-BE1E-21B979E93C0A}" srcOrd="0" destOrd="0" presId="urn:microsoft.com/office/officeart/2005/8/layout/orgChart1"/>
    <dgm:cxn modelId="{151A98AE-E4ED-4940-BCBB-F3080CC9BC0E}" type="presParOf" srcId="{1AB85D30-1D40-42E3-A8DB-C9F1D815B6B4}" destId="{7B722D9E-513A-4857-BD11-B52EEB6F75B6}" srcOrd="1" destOrd="0" presId="urn:microsoft.com/office/officeart/2005/8/layout/orgChart1"/>
    <dgm:cxn modelId="{A924FCCE-20D1-449F-B9FC-FA3D6E3E693A}" type="presParOf" srcId="{D63E330B-508D-440B-BD55-89CC6D35F938}" destId="{555BB7B1-E4CE-44C3-A348-6FE6F2922356}" srcOrd="1" destOrd="0" presId="urn:microsoft.com/office/officeart/2005/8/layout/orgChart1"/>
    <dgm:cxn modelId="{80C5A44F-BBA3-42D3-89C8-3BC59CADEBC6}" type="presParOf" srcId="{D63E330B-508D-440B-BD55-89CC6D35F938}" destId="{969713CF-6979-4B53-8F08-9E7AFC31CCFB}" srcOrd="2" destOrd="0" presId="urn:microsoft.com/office/officeart/2005/8/layout/orgChart1"/>
    <dgm:cxn modelId="{1CAAA976-1B8E-4480-B2CA-9FDD7930E6C8}" type="presParOf" srcId="{8A2D374B-458A-4AF3-84A5-B34072BB706B}" destId="{E35D51EB-F2AD-4AFC-9E17-3EF3CCD8514A}" srcOrd="2" destOrd="0" presId="urn:microsoft.com/office/officeart/2005/8/layout/orgChart1"/>
    <dgm:cxn modelId="{E7AD4641-D2BA-46F1-84E5-B7003D1059BE}" type="presParOf" srcId="{619C66DE-5618-4934-9F35-01949BC36E23}" destId="{1E0C88F6-4D8E-44E9-8D8A-BC32AAECB7C4}" srcOrd="2" destOrd="0" presId="urn:microsoft.com/office/officeart/2005/8/layout/orgChart1"/>
    <dgm:cxn modelId="{B29B3BF9-330B-4AE8-917F-267EC7DB9791}" type="presParOf" srcId="{D1A22180-CD3E-4968-8050-D2CE617605DF}" destId="{5D3CA998-6F46-449C-BAE8-437D88BA755F}" srcOrd="2" destOrd="0" presId="urn:microsoft.com/office/officeart/2005/8/layout/orgChart1"/>
    <dgm:cxn modelId="{49D612C4-5725-4730-A873-A0BE1336361F}" type="presParOf" srcId="{D1A22180-CD3E-4968-8050-D2CE617605DF}" destId="{E22B4EBF-CC74-4F39-842E-BF5A7B162DE5}" srcOrd="3" destOrd="0" presId="urn:microsoft.com/office/officeart/2005/8/layout/orgChart1"/>
    <dgm:cxn modelId="{133B7F26-9E1E-4A6C-A543-21DAF31C0B12}" type="presParOf" srcId="{E22B4EBF-CC74-4F39-842E-BF5A7B162DE5}" destId="{BA87A8C4-2E7D-49F4-B5BD-931D3E6D37B0}" srcOrd="0" destOrd="0" presId="urn:microsoft.com/office/officeart/2005/8/layout/orgChart1"/>
    <dgm:cxn modelId="{0B94A03B-BA11-4E57-A8FE-9964E43CB01C}" type="presParOf" srcId="{BA87A8C4-2E7D-49F4-B5BD-931D3E6D37B0}" destId="{78AF51FD-FFC5-44E5-9765-9E2F883ECD56}" srcOrd="0" destOrd="0" presId="urn:microsoft.com/office/officeart/2005/8/layout/orgChart1"/>
    <dgm:cxn modelId="{DB190975-D728-4E57-9D2C-C14FD353A3DA}" type="presParOf" srcId="{BA87A8C4-2E7D-49F4-B5BD-931D3E6D37B0}" destId="{554072B4-A9A5-458F-AE87-80CBC7BB0128}" srcOrd="1" destOrd="0" presId="urn:microsoft.com/office/officeart/2005/8/layout/orgChart1"/>
    <dgm:cxn modelId="{544C4CA6-D691-427D-BABE-CF45502BC2EE}" type="presParOf" srcId="{E22B4EBF-CC74-4F39-842E-BF5A7B162DE5}" destId="{8EB5EAAD-B9C8-4ED9-8513-66B9039C670B}" srcOrd="1" destOrd="0" presId="urn:microsoft.com/office/officeart/2005/8/layout/orgChart1"/>
    <dgm:cxn modelId="{F62C3CB4-4ACD-4DEE-894E-88BD5133D50D}" type="presParOf" srcId="{8EB5EAAD-B9C8-4ED9-8513-66B9039C670B}" destId="{C63EA82D-BEFE-463A-BC48-457D1AEDD6FF}" srcOrd="0" destOrd="0" presId="urn:microsoft.com/office/officeart/2005/8/layout/orgChart1"/>
    <dgm:cxn modelId="{D17E75D3-CFE1-49A5-8F95-02A5711BA68A}" type="presParOf" srcId="{8EB5EAAD-B9C8-4ED9-8513-66B9039C670B}" destId="{99A10FF1-2AB8-451A-BC8B-76128A74F5C0}" srcOrd="1" destOrd="0" presId="urn:microsoft.com/office/officeart/2005/8/layout/orgChart1"/>
    <dgm:cxn modelId="{3988CF88-70D3-4B5C-A80C-80BA35F66202}" type="presParOf" srcId="{99A10FF1-2AB8-451A-BC8B-76128A74F5C0}" destId="{FB38FCC3-65C5-4F9E-99BE-52431CACB7AC}" srcOrd="0" destOrd="0" presId="urn:microsoft.com/office/officeart/2005/8/layout/orgChart1"/>
    <dgm:cxn modelId="{157F7190-E23B-468A-A0B3-182ADE4E9624}" type="presParOf" srcId="{FB38FCC3-65C5-4F9E-99BE-52431CACB7AC}" destId="{AB299217-BEB7-4637-8492-B505E68ABD2C}" srcOrd="0" destOrd="0" presId="urn:microsoft.com/office/officeart/2005/8/layout/orgChart1"/>
    <dgm:cxn modelId="{DD85F554-6E98-483B-A3B1-63F86F686CDB}" type="presParOf" srcId="{FB38FCC3-65C5-4F9E-99BE-52431CACB7AC}" destId="{910D08E7-A4FF-44DC-BF4F-A4FE87A2452E}" srcOrd="1" destOrd="0" presId="urn:microsoft.com/office/officeart/2005/8/layout/orgChart1"/>
    <dgm:cxn modelId="{B53BCA6B-BE33-4016-9AD0-72F4F4E32FC7}" type="presParOf" srcId="{99A10FF1-2AB8-451A-BC8B-76128A74F5C0}" destId="{61B13FEA-A5F6-4C5A-B115-649EE720F485}" srcOrd="1" destOrd="0" presId="urn:microsoft.com/office/officeart/2005/8/layout/orgChart1"/>
    <dgm:cxn modelId="{88DF27D9-CF1B-40D6-BB7E-49C373D96B4C}" type="presParOf" srcId="{99A10FF1-2AB8-451A-BC8B-76128A74F5C0}" destId="{4AA8ECFF-9C3B-4978-84B6-ADD0117A1E23}" srcOrd="2" destOrd="0" presId="urn:microsoft.com/office/officeart/2005/8/layout/orgChart1"/>
    <dgm:cxn modelId="{75F07AE0-9922-469E-9CFD-7F49E55934CA}" type="presParOf" srcId="{E22B4EBF-CC74-4F39-842E-BF5A7B162DE5}" destId="{2EFAA707-D5C3-4292-9310-3089B4DE60E1}" srcOrd="2" destOrd="0" presId="urn:microsoft.com/office/officeart/2005/8/layout/orgChart1"/>
    <dgm:cxn modelId="{A3C4BAD7-63C5-4133-86C9-DCD0226673EA}" type="presParOf" srcId="{12FF6F10-E9A4-4B54-95B5-1E3B8EDEEF3E}" destId="{5A6BF4FD-19A3-4928-99EC-E6A3AF3FDA04}" srcOrd="2" destOrd="0" presId="urn:microsoft.com/office/officeart/2005/8/layout/orgChart1"/>
    <dgm:cxn modelId="{12E9F324-37D8-4337-9AAC-C76317A50C76}" type="presParOf" srcId="{23CAD4E0-E7F9-4A99-9D88-FF66A8ACB62E}" destId="{FC7455E5-12D1-4DD7-8685-AFDDBD7CF98F}" srcOrd="2" destOrd="0" presId="urn:microsoft.com/office/officeart/2005/8/layout/orgChart1"/>
    <dgm:cxn modelId="{9FFF9BB7-E307-4377-B472-A03A6A3AA157}" type="presParOf" srcId="{E34AF575-7542-4EA8-8257-7B024E767079}" destId="{E2B0C4BD-EB0B-4869-887B-CE67070FA3D5}" srcOrd="2" destOrd="0" presId="urn:microsoft.com/office/officeart/2005/8/layout/orgChart1"/>
    <dgm:cxn modelId="{BD73E362-73C7-4D07-B8F2-C2CB9B6AFC7E}" type="presParOf" srcId="{32030AD7-342B-4098-9CFB-B19B60A845D3}" destId="{EAE3B9E6-C580-490F-92D6-448F5EFFA8A6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D6A87FD5-7E66-41D8-92DD-003C93D45C7C}" type="doc">
      <dgm:prSet loTypeId="urn:microsoft.com/office/officeart/2005/8/layout/hList1" loCatId="list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US"/>
        </a:p>
      </dgm:t>
    </dgm:pt>
    <dgm:pt modelId="{2DD53B9B-FF17-4442-978B-6EEDFA253E9A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FiO</a:t>
          </a:r>
          <a:r>
            <a:rPr lang="en-US" sz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 ≥0.40</a:t>
          </a:r>
          <a:r>
            <a:rPr lang="en-US" sz="1200" baseline="3000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  </a:t>
          </a:r>
        </a:p>
      </dgm:t>
    </dgm:pt>
    <dgm:pt modelId="{474061A2-A3B2-475D-8279-C669D6274D5A}" type="parTrans" cxnId="{8E406A30-2BAC-41AA-B321-4F222FD4DFC0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B0B29DA-7936-41DE-BA93-310DD6D36484}" type="sibTrans" cxnId="{8E406A30-2BAC-41AA-B321-4F222FD4DFC0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6BFFCF1-8AEB-462A-8E69-74F80BC2885B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Extubation Criteria</a:t>
          </a:r>
        </a:p>
      </dgm:t>
    </dgm:pt>
    <dgm:pt modelId="{9927D082-2926-487F-AAF9-287E2E548E4F}" type="parTrans" cxnId="{FA4908C6-1159-4062-B739-553D72AAD972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E6AE5A2-00BE-42A2-8C7A-E15DEB5858E3}" type="sibTrans" cxnId="{FA4908C6-1159-4062-B739-553D72AAD972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2B71F9F-F3BB-42F4-B5EE-E830CDB12CBC}">
      <dgm:prSet phldrT="[Text]" custT="1"/>
      <dgm:spPr>
        <a:ln w="19050"/>
      </dgm:spPr>
      <dgm:t>
        <a:bodyPr/>
        <a:lstStyle/>
        <a:p>
          <a:r>
            <a:rPr lang="en-US" sz="1200" b="0">
              <a:latin typeface="Times New Roman" panose="02020603050405020304" pitchFamily="18" charset="0"/>
              <a:cs typeface="Times New Roman" panose="02020603050405020304" pitchFamily="18" charset="0"/>
            </a:rPr>
            <a:t>Consider extubating to bCPAP 7-9 cmH</a:t>
          </a:r>
          <a:r>
            <a:rPr lang="en-US" sz="1200" b="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 b="0">
              <a:latin typeface="Times New Roman" panose="02020603050405020304" pitchFamily="18" charset="0"/>
              <a:cs typeface="Times New Roman" panose="02020603050405020304" pitchFamily="18" charset="0"/>
            </a:rPr>
            <a:t>O if prolonged MV, evidence of lung disease, and/or FiO2 ≥0.25</a:t>
          </a:r>
          <a:r>
            <a:rPr lang="en-US" sz="1200" b="0" baseline="3000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r>
            <a:rPr lang="en-US" sz="1200" b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</dgm:t>
    </dgm:pt>
    <dgm:pt modelId="{3DA71D5E-2842-4FDF-9C9F-49C11B6EC640}" type="parTrans" cxnId="{7F39493D-D5E3-4320-B4F0-080F4C2F1D8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C458FE8-73D7-45BA-931C-16CE62E5BCA0}" type="sibTrans" cxnId="{7F39493D-D5E3-4320-B4F0-080F4C2F1D8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E4E923E-95B1-4D5E-B280-CD273E2F2B84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Trial off bCPAP Criteria</a:t>
          </a:r>
        </a:p>
      </dgm:t>
    </dgm:pt>
    <dgm:pt modelId="{D93EB422-902A-4EAF-B0FA-88D8AF04FE8E}" type="parTrans" cxnId="{20E97DFB-9111-4E5C-A338-C8E98817895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5CA7460-ADC9-42F9-B9C9-311C158426A8}" type="sibTrans" cxnId="{20E97DFB-9111-4E5C-A338-C8E98817895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7BE3714-E71E-4F78-87D4-72E44C252396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bCPAP 5 x RA for ≥48 hrs</a:t>
          </a:r>
          <a:r>
            <a:rPr lang="en-US" sz="1200" baseline="3000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dgm:t>
    </dgm:pt>
    <dgm:pt modelId="{6DC8358C-E385-4B0D-AD45-56884BA4F314}" type="parTrans" cxnId="{9C50C74A-3468-4790-8A37-1972FC6C1EC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37691B7-E8C2-4D08-8F56-3D63DDA97914}" type="sibTrans" cxnId="{9C50C74A-3468-4790-8A37-1972FC6C1EC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561F7C6-5033-4778-8F48-4C9A15C1BBD7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Significant WOB/retractions</a:t>
          </a:r>
        </a:p>
      </dgm:t>
    </dgm:pt>
    <dgm:pt modelId="{3310358C-3E7E-4613-A58E-7998E34A796D}" type="parTrans" cxnId="{E541DA4F-2F2B-4522-B5C0-ED41992A2D8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59EC8D8-5200-4C64-9BD3-F3D680AC68D0}" type="sibTrans" cxnId="{E541DA4F-2F2B-4522-B5C0-ED41992A2D8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906AA42-BF0D-42A2-A238-D1CEA11A3206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Frequent apneic episodes (&gt;6/6 hrs requiring vigorous     stimulation or more than 1 requiring PPV)</a:t>
          </a:r>
        </a:p>
      </dgm:t>
    </dgm:pt>
    <dgm:pt modelId="{2CA5873C-64FD-45BC-BC72-B5E7C8BBBAF0}" type="parTrans" cxnId="{870E9276-CBDA-447A-B5F8-BEA37BD56A5F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BDD4BE8-B233-4DEE-91C5-A300986F6F58}" type="sibTrans" cxnId="{870E9276-CBDA-447A-B5F8-BEA37BD56A5F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430505E-B5EE-4BE6-9CEC-DB412E487E8E}">
      <dgm:prSet custT="1"/>
      <dgm:spPr>
        <a:ln w="19050"/>
      </dgm:spPr>
      <dgm:t>
        <a:bodyPr/>
        <a:lstStyle/>
        <a:p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Arterial pH &lt;7.20 and PaCO</a:t>
          </a:r>
          <a:r>
            <a:rPr lang="en-US" sz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&gt;65 mmHg on 2 gasses &gt;30 minutes apart</a:t>
          </a:r>
        </a:p>
      </dgm:t>
    </dgm:pt>
    <dgm:pt modelId="{B0C95210-5FBA-4763-811D-01E090AA8212}" type="parTrans" cxnId="{34F15FCD-EBA9-424E-BF04-338D453327C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559AF13-5570-4A34-A700-6EA5D793C62A}" type="sibTrans" cxnId="{34F15FCD-EBA9-424E-BF04-338D453327C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A1490E9-7C84-4B68-B08E-82844E7658D1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Capillary pH &lt;7.19 and PcCO</a:t>
          </a:r>
          <a:r>
            <a:rPr lang="en-US" sz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 &gt;68 mmHg on 2 gasses &gt;30 minutes apart</a:t>
          </a:r>
        </a:p>
      </dgm:t>
    </dgm:pt>
    <dgm:pt modelId="{CDAAC3F1-9F56-4EED-8CB7-B65FDA5B2DCC}" type="parTrans" cxnId="{B895DB48-F258-4D0E-A2E9-5226D9EC3C15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596DED8-B571-4BA6-B6C5-7C877F67E874}" type="sibTrans" cxnId="{B895DB48-F258-4D0E-A2E9-5226D9EC3C15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690629F-D74A-45D5-83FF-185E78E42124}">
      <dgm:prSet custT="1"/>
      <dgm:spPr>
        <a:ln w="19050"/>
      </dgm:spPr>
      <dgm:t>
        <a:bodyPr/>
        <a:lstStyle/>
        <a:p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Venous pH &lt;7.17 and PvCO</a:t>
          </a:r>
          <a:r>
            <a:rPr lang="en-US" sz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2 </a:t>
          </a:r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&gt;71 mmHg on 2 gasses &gt;30 minutes apart</a:t>
          </a:r>
        </a:p>
      </dgm:t>
    </dgm:pt>
    <dgm:pt modelId="{32F8D09D-9242-495F-A146-0535D6716A4A}" type="parTrans" cxnId="{4B18CF45-88B6-4369-AB0C-D4BA3759212E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9DFC69A-078A-4C13-AE23-63C4F6D406A8}" type="sibTrans" cxnId="{4B18CF45-88B6-4369-AB0C-D4BA3759212E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4EDE82B-3E45-44F5-B7FE-C87CA0B27024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Refractory metabolic acidosis      </a:t>
          </a:r>
        </a:p>
      </dgm:t>
    </dgm:pt>
    <dgm:pt modelId="{FCC157DA-1F8A-4C00-8A0F-582F2F2D3C41}" type="parTrans" cxnId="{41218C27-FB1E-413E-99F5-F328B384C84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7865EBD-2F9F-4B04-B9DA-FD69A5404895}" type="sibTrans" cxnId="{41218C27-FB1E-413E-99F5-F328B384C849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B67E9C0-D1EE-4DF0-8758-62D21496D1C4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Need for anesthetic or intervention requiring intubation    </a:t>
          </a:r>
        </a:p>
      </dgm:t>
    </dgm:pt>
    <dgm:pt modelId="{8CBE6196-8282-419C-962E-2EE09A3264FB}" type="parTrans" cxnId="{B184774D-CF36-4BD9-88C1-4758508E83D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0886DE7-68CB-4803-8095-E725EC0E0B9C}" type="sibTrans" cxnId="{B184774D-CF36-4BD9-88C1-4758508E83D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FF1839F-8C7F-4C5C-A956-F0DCF7ED2A9E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FiO</a:t>
          </a:r>
          <a:r>
            <a:rPr lang="en-US" sz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 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&lt;0.3</a:t>
          </a:r>
          <a:r>
            <a:rPr lang="en-US" sz="1200" baseline="3000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dgm:t>
    </dgm:pt>
    <dgm:pt modelId="{0A23AE63-1806-427C-951C-3F27EBA498A9}" type="parTrans" cxnId="{9BCE83B7-D322-4284-B53F-A0C0C1D2F74F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C7C9628-636F-4916-9EF3-0B81F2380BC0}" type="sibTrans" cxnId="{9BCE83B7-D322-4284-B53F-A0C0C1D2F74F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08E933D-9F87-47D1-90AE-C57BB0DFD514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Peak inspiratory pressure &lt;20 cmH</a:t>
          </a:r>
          <a:r>
            <a:rPr lang="en-US" sz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O</a:t>
          </a:r>
        </a:p>
      </dgm:t>
    </dgm:pt>
    <dgm:pt modelId="{C5FA192F-3547-493C-A060-66B036F8DFD2}" type="parTrans" cxnId="{A74E4FBD-5793-42E1-8F66-4AF763BDC83A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B65E6EC-69A1-4593-AE97-669BC4FB75AA}" type="sibTrans" cxnId="{A74E4FBD-5793-42E1-8F66-4AF763BDC83A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93994D2-DADD-427F-9D64-A48BB3102579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Ventilator rate &lt;20</a:t>
          </a:r>
        </a:p>
      </dgm:t>
    </dgm:pt>
    <dgm:pt modelId="{D3AD7A55-5FB7-4CCE-B2CF-0CBE6E9576C9}" type="parTrans" cxnId="{6D1E04E5-B031-49EB-9969-3B940BD1769C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65B05A4-45BF-4D20-B4A0-87E76A04BA20}" type="sibTrans" cxnId="{6D1E04E5-B031-49EB-9969-3B940BD1769C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7289522-547B-4228-99B4-0A6BEFEF313B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Spontaneous breathing over the ventilator</a:t>
          </a:r>
        </a:p>
      </dgm:t>
    </dgm:pt>
    <dgm:pt modelId="{7EC39DB5-3B90-497D-B853-A835CB1D5CDF}" type="parTrans" cxnId="{61E00729-47C3-4A77-8ED6-9ABE29CE2BD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F24F979-16EE-4E8A-B3D3-5AB41833B9AA}" type="sibTrans" cxnId="{61E00729-47C3-4A77-8ED6-9ABE29CE2BD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7568B15-5CC6-46E5-9527-EA38C5D4A05C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PaCO2 &lt;60 mmHg </a:t>
          </a:r>
        </a:p>
      </dgm:t>
    </dgm:pt>
    <dgm:pt modelId="{C01D04FA-DBCA-4151-B79D-1BF9D5616AEE}" type="sibTrans" cxnId="{4B7D8B46-A979-4272-8777-564AB3047C27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5CAE194-7648-4718-AB8C-FC02ECCDC569}" type="parTrans" cxnId="{4B7D8B46-A979-4272-8777-564AB3047C27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2318388-5E31-4C40-9F37-E458C8E529C0}">
      <dgm:prSet custT="1"/>
      <dgm:spPr>
        <a:ln w="19050"/>
      </dgm:spPr>
      <dgm:t>
        <a:bodyPr/>
        <a:lstStyle/>
        <a:p>
          <a:r>
            <a:rPr lang="en-US" sz="1200" b="0">
              <a:latin typeface="Times New Roman" panose="02020603050405020304" pitchFamily="18" charset="0"/>
              <a:cs typeface="Times New Roman" panose="02020603050405020304" pitchFamily="18" charset="0"/>
            </a:rPr>
            <a:t>Restart bCPAP 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if RR &gt;70, requires supplemental O</a:t>
          </a:r>
          <a:r>
            <a:rPr lang="en-US" sz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, 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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WOB or 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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spells</a:t>
          </a:r>
        </a:p>
      </dgm:t>
    </dgm:pt>
    <dgm:pt modelId="{EF12B1AC-7C5D-4F4A-B208-EA186A340CAF}" type="parTrans" cxnId="{3AB01B63-265E-443C-9E2E-869F60E6647B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12334B4-A2BF-4364-970F-C58ED60B94B7}" type="sibTrans" cxnId="{3AB01B63-265E-443C-9E2E-869F60E6647B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33CEC8C-7C47-4195-B824-ED025C6A6D1C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No significant retractions/WOB</a:t>
          </a:r>
        </a:p>
      </dgm:t>
    </dgm:pt>
    <dgm:pt modelId="{4B624C2E-684A-40E2-A0DC-52245911CA5E}" type="parTrans" cxnId="{1BB83E98-F094-4B88-BF70-E5D80BF372ED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EC57AAD-58BD-47B3-9873-76E4C402A0D1}" type="sibTrans" cxnId="{1BB83E98-F094-4B88-BF70-E5D80BF372ED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B246152-0D6E-4F6F-A41D-4B45591DA12A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Infrequent spells</a:t>
          </a:r>
        </a:p>
      </dgm:t>
    </dgm:pt>
    <dgm:pt modelId="{28EF4241-FFF1-4616-B08F-65FC08ACD400}" type="sibTrans" cxnId="{65F57C64-4C2A-4E4C-9289-5E44C4015276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D985BBD-4420-4500-BBEB-CD3429389C9E}" type="parTrans" cxnId="{65F57C64-4C2A-4E4C-9289-5E44C4015276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1B8DAE8-3129-4F92-BBD8-A51923FB82AD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RR &lt;60 for past 24 hours</a:t>
          </a:r>
        </a:p>
      </dgm:t>
    </dgm:pt>
    <dgm:pt modelId="{9C20CBC4-DFDC-470D-AEA7-C17EF8D07D49}" type="parTrans" cxnId="{8A061168-E7B0-4C3C-A5E2-F6ED2ACD4DAB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6452F44-AFB6-4982-9C6F-5E75DDA53F27}" type="sibTrans" cxnId="{8A061168-E7B0-4C3C-A5E2-F6ED2ACD4DAB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AB941CB-D15E-4185-A7C2-0A1BEA250598}">
      <dgm:prSet custT="1"/>
      <dgm:spPr>
        <a:ln w="19050"/>
      </dgm:spPr>
      <dgm:t>
        <a:bodyPr/>
        <a:lstStyle/>
        <a:p>
          <a:r>
            <a:rPr lang="en-US" sz="1200" b="0">
              <a:latin typeface="Times New Roman" panose="02020603050405020304" pitchFamily="18" charset="0"/>
              <a:cs typeface="Times New Roman" panose="02020603050405020304" pitchFamily="18" charset="0"/>
            </a:rPr>
            <a:t>If unable to wean off bCPAP to RA 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and &gt;34 weeks PMA, may consider </a:t>
          </a:r>
          <a:r>
            <a:rPr lang="en-US" sz="1200" u="sng">
              <a:latin typeface="Times New Roman" panose="02020603050405020304" pitchFamily="18" charset="0"/>
              <a:cs typeface="Times New Roman" panose="02020603050405020304" pitchFamily="18" charset="0"/>
            </a:rPr>
            <a:t>continuing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 bCPAP (nasal mask or prong or RAM cannula) </a:t>
          </a:r>
          <a:r>
            <a:rPr lang="en-US" sz="1200" i="1">
              <a:latin typeface="Times New Roman" panose="02020603050405020304" pitchFamily="18" charset="0"/>
              <a:cs typeface="Times New Roman" panose="02020603050405020304" pitchFamily="18" charset="0"/>
            </a:rPr>
            <a:t>OR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1200" u="sng">
              <a:latin typeface="Times New Roman" panose="02020603050405020304" pitchFamily="18" charset="0"/>
              <a:cs typeface="Times New Roman" panose="02020603050405020304" pitchFamily="18" charset="0"/>
            </a:rPr>
            <a:t>sprinting 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off bCPAP on either RA or HFNC </a:t>
          </a:r>
          <a:r>
            <a:rPr lang="en-US" sz="1200" i="1">
              <a:latin typeface="Times New Roman" panose="02020603050405020304" pitchFamily="18" charset="0"/>
              <a:cs typeface="Times New Roman" panose="02020603050405020304" pitchFamily="18" charset="0"/>
            </a:rPr>
            <a:t>OR </a:t>
          </a:r>
          <a:r>
            <a:rPr lang="en-US" sz="1200" u="sng">
              <a:latin typeface="Times New Roman" panose="02020603050405020304" pitchFamily="18" charset="0"/>
              <a:cs typeface="Times New Roman" panose="02020603050405020304" pitchFamily="18" charset="0"/>
            </a:rPr>
            <a:t>weaning </a:t>
          </a:r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to HFNC </a:t>
          </a:r>
        </a:p>
      </dgm:t>
    </dgm:pt>
    <dgm:pt modelId="{EC86AA25-5FD4-4C3E-9337-194B1C82E73F}" type="parTrans" cxnId="{D01ADDBA-C69D-4C9B-AAD4-26BA6B079670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B9BC0D7-4C2A-42A5-8B60-720E76E9D10C}" type="sibTrans" cxnId="{D01ADDBA-C69D-4C9B-AAD4-26BA6B079670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93CE747-DF46-4E9A-92C2-C048B6A1E0FE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bCPAP may be used to re-recruit lung volumes in infants on RA or NC, as needed.</a:t>
          </a:r>
        </a:p>
      </dgm:t>
    </dgm:pt>
    <dgm:pt modelId="{3EAEE867-6446-4918-B7AD-DCF199A5FD7E}" type="parTrans" cxnId="{6AF0BBC2-B1A9-4370-8148-B55C572985D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20EDB6E-5147-45AA-9311-B3AB53763427}" type="sibTrans" cxnId="{6AF0BBC2-B1A9-4370-8148-B55C572985D4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F1752B2-09C6-45C3-B16D-C17268CD4EBF}">
      <dgm:prSet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Generally should wait 2-5 days between trials off bCPAP. </a:t>
          </a:r>
        </a:p>
      </dgm:t>
    </dgm:pt>
    <dgm:pt modelId="{946DDB78-345B-4BB0-A135-C89FD12CE886}" type="parTrans" cxnId="{D7BFAF59-FBE7-4B0C-B0EE-D0240CB2EF15}">
      <dgm:prSet/>
      <dgm:spPr/>
      <dgm:t>
        <a:bodyPr/>
        <a:lstStyle/>
        <a:p>
          <a:endParaRPr lang="en-US"/>
        </a:p>
      </dgm:t>
    </dgm:pt>
    <dgm:pt modelId="{2AA495B9-22AF-4099-8365-FDF6918E583D}" type="sibTrans" cxnId="{D7BFAF59-FBE7-4B0C-B0EE-D0240CB2EF15}">
      <dgm:prSet/>
      <dgm:spPr/>
      <dgm:t>
        <a:bodyPr/>
        <a:lstStyle/>
        <a:p>
          <a:endParaRPr lang="en-US"/>
        </a:p>
      </dgm:t>
    </dgm:pt>
    <dgm:pt modelId="{C79D07BD-8EF4-48A7-BA78-058C4DF3EF11}">
      <dgm:prSet phldrT="[Text]" custT="1"/>
      <dgm:spPr>
        <a:ln w="19050"/>
      </dgm:spPr>
      <dgm:t>
        <a:bodyPr/>
        <a:lstStyle/>
        <a:p>
          <a:r>
            <a:rPr lang="en-US" sz="1200" b="0">
              <a:latin typeface="Times New Roman" panose="02020603050405020304" pitchFamily="18" charset="0"/>
              <a:cs typeface="Times New Roman" panose="02020603050405020304" pitchFamily="18" charset="0"/>
            </a:rPr>
            <a:t>Caffeine for all infants &lt;1250 gram birth weight and/or per attending discretion</a:t>
          </a:r>
        </a:p>
      </dgm:t>
    </dgm:pt>
    <dgm:pt modelId="{BCB8711C-F92A-4AA9-A18C-D60D0EC362E4}" type="parTrans" cxnId="{2992696F-AEAF-40E9-80B3-20B8A9AFA4D1}">
      <dgm:prSet/>
      <dgm:spPr/>
      <dgm:t>
        <a:bodyPr/>
        <a:lstStyle/>
        <a:p>
          <a:endParaRPr lang="en-US"/>
        </a:p>
      </dgm:t>
    </dgm:pt>
    <dgm:pt modelId="{EC3B44FA-A62A-4828-A3EB-07ED2DFA0BE8}" type="sibTrans" cxnId="{2992696F-AEAF-40E9-80B3-20B8A9AFA4D1}">
      <dgm:prSet/>
      <dgm:spPr/>
      <dgm:t>
        <a:bodyPr/>
        <a:lstStyle/>
        <a:p>
          <a:endParaRPr lang="en-US"/>
        </a:p>
      </dgm:t>
    </dgm:pt>
    <dgm:pt modelId="{EFC8FE19-F895-42B0-98C8-5FA537962E9A}">
      <dgm:prSet phldrT="[Text]" custT="1"/>
      <dgm:spPr>
        <a:ln w="19050"/>
      </dgm:spPr>
      <dgm:t>
        <a:bodyPr/>
        <a:lstStyle/>
        <a:p>
          <a:r>
            <a:rPr lang="en-US" sz="1200">
              <a:latin typeface="Times New Roman" panose="02020603050405020304" pitchFamily="18" charset="0"/>
              <a:cs typeface="Times New Roman" panose="02020603050405020304" pitchFamily="18" charset="0"/>
            </a:rPr>
            <a:t>Intubation/Re-intubation Criteria</a:t>
          </a:r>
        </a:p>
      </dgm:t>
    </dgm:pt>
    <dgm:pt modelId="{E65A2683-D0DB-4D62-9A3D-5D7FAD730BFD}" type="sibTrans" cxnId="{26C510CD-BE65-4F4D-9508-181B0FC5253E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2058A3E-750D-4401-A0CB-48EABCAFA215}" type="parTrans" cxnId="{26C510CD-BE65-4F4D-9508-181B0FC5253E}">
      <dgm:prSet/>
      <dgm:spPr/>
      <dgm:t>
        <a:bodyPr/>
        <a:lstStyle/>
        <a:p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1A25620-7E13-46FB-B3D0-5E0975B795E1}" type="pres">
      <dgm:prSet presAssocID="{D6A87FD5-7E66-41D8-92DD-003C93D45C7C}" presName="Name0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F6A1B179-34A2-4460-968F-5B34B4E9F5DF}" type="pres">
      <dgm:prSet presAssocID="{EFC8FE19-F895-42B0-98C8-5FA537962E9A}" presName="composite" presStyleCnt="0"/>
      <dgm:spPr/>
    </dgm:pt>
    <dgm:pt modelId="{60E7015A-8005-4379-89EA-F8421038CCB3}" type="pres">
      <dgm:prSet presAssocID="{EFC8FE19-F895-42B0-98C8-5FA537962E9A}" presName="parTx" presStyleLbl="alignNode1" presStyleIdx="0" presStyleCnt="3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304EC1B-8DC0-434D-AD14-1652F99002D4}" type="pres">
      <dgm:prSet presAssocID="{EFC8FE19-F895-42B0-98C8-5FA537962E9A}" presName="desTx" presStyleLbl="alignAccFollowNode1" presStyleIdx="0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556F00D-3ACE-4930-9FD5-E81C20D1D5BA}" type="pres">
      <dgm:prSet presAssocID="{E65A2683-D0DB-4D62-9A3D-5D7FAD730BFD}" presName="space" presStyleCnt="0"/>
      <dgm:spPr/>
    </dgm:pt>
    <dgm:pt modelId="{23675ACD-1FBD-4C01-B78C-3837E220DF94}" type="pres">
      <dgm:prSet presAssocID="{F6BFFCF1-8AEB-462A-8E69-74F80BC2885B}" presName="composite" presStyleCnt="0"/>
      <dgm:spPr/>
    </dgm:pt>
    <dgm:pt modelId="{7C9C0131-9964-4AF9-A7B6-9BDB59F14E5E}" type="pres">
      <dgm:prSet presAssocID="{F6BFFCF1-8AEB-462A-8E69-74F80BC2885B}" presName="parTx" presStyleLbl="alignNode1" presStyleIdx="1" presStyleCnt="3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9466AE1-9A34-4D4E-86FE-C2008CE7AB3B}" type="pres">
      <dgm:prSet presAssocID="{F6BFFCF1-8AEB-462A-8E69-74F80BC2885B}" presName="desTx" presStyleLbl="alignAccFollowNode1" presStyleIdx="1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3DA372B-A428-4EF2-88F9-4D9763068712}" type="pres">
      <dgm:prSet presAssocID="{9E6AE5A2-00BE-42A2-8C7A-E15DEB5858E3}" presName="space" presStyleCnt="0"/>
      <dgm:spPr/>
    </dgm:pt>
    <dgm:pt modelId="{D0DB70DD-D703-4617-AD21-237911F2A039}" type="pres">
      <dgm:prSet presAssocID="{6E4E923E-95B1-4D5E-B280-CD273E2F2B84}" presName="composite" presStyleCnt="0"/>
      <dgm:spPr/>
    </dgm:pt>
    <dgm:pt modelId="{9EB8A9FC-6EC7-4500-902C-BBBA51763018}" type="pres">
      <dgm:prSet presAssocID="{6E4E923E-95B1-4D5E-B280-CD273E2F2B84}" presName="parTx" presStyleLbl="alignNode1" presStyleIdx="2" presStyleCnt="3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46A9C74-F8BF-488C-B7F2-336935415384}" type="pres">
      <dgm:prSet presAssocID="{6E4E923E-95B1-4D5E-B280-CD273E2F2B84}" presName="desTx" presStyleLbl="alignAccFollowNode1" presStyleIdx="2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62A73694-20F5-4637-BA75-2EE8EB7FDED2}" type="presOf" srcId="{3B246152-0D6E-4F6F-A41D-4B45591DA12A}" destId="{E46A9C74-F8BF-488C-B7F2-336935415384}" srcOrd="0" destOrd="2" presId="urn:microsoft.com/office/officeart/2005/8/layout/hList1"/>
    <dgm:cxn modelId="{3E9C0E85-EE69-4BD7-94D5-4AFCEDA1061B}" type="presOf" srcId="{D6A87FD5-7E66-41D8-92DD-003C93D45C7C}" destId="{E1A25620-7E13-46FB-B3D0-5E0975B795E1}" srcOrd="0" destOrd="0" presId="urn:microsoft.com/office/officeart/2005/8/layout/hList1"/>
    <dgm:cxn modelId="{6FBE20A3-0C84-4F7D-9381-CEA4A200B7F7}" type="presOf" srcId="{6A1490E9-7C84-4B68-B08E-82844E7658D1}" destId="{7304EC1B-8DC0-434D-AD14-1652F99002D4}" srcOrd="0" destOrd="4" presId="urn:microsoft.com/office/officeart/2005/8/layout/hList1"/>
    <dgm:cxn modelId="{E541DA4F-2F2B-4522-B5C0-ED41992A2D84}" srcId="{EFC8FE19-F895-42B0-98C8-5FA537962E9A}" destId="{3561F7C6-5033-4778-8F48-4C9A15C1BBD7}" srcOrd="1" destOrd="0" parTransId="{3310358C-3E7E-4613-A58E-7998E34A796D}" sibTransId="{959EC8D8-5200-4C64-9BD3-F3D680AC68D0}"/>
    <dgm:cxn modelId="{2992696F-AEAF-40E9-80B3-20B8A9AFA4D1}" srcId="{F6BFFCF1-8AEB-462A-8E69-74F80BC2885B}" destId="{C79D07BD-8EF4-48A7-BA78-058C4DF3EF11}" srcOrd="6" destOrd="0" parTransId="{BCB8711C-F92A-4AA9-A18C-D60D0EC362E4}" sibTransId="{EC3B44FA-A62A-4828-A3EB-07ED2DFA0BE8}"/>
    <dgm:cxn modelId="{41218C27-FB1E-413E-99F5-F328B384C849}" srcId="{EFC8FE19-F895-42B0-98C8-5FA537962E9A}" destId="{B4EDE82B-3E45-44F5-B7FE-C87CA0B27024}" srcOrd="6" destOrd="0" parTransId="{FCC157DA-1F8A-4C00-8A0F-582F2F2D3C41}" sibTransId="{97865EBD-2F9F-4B04-B9DA-FD69A5404895}"/>
    <dgm:cxn modelId="{5E133455-B2F0-41F5-9C12-81A5842C9AB7}" type="presOf" srcId="{B4EDE82B-3E45-44F5-B7FE-C87CA0B27024}" destId="{7304EC1B-8DC0-434D-AD14-1652F99002D4}" srcOrd="0" destOrd="6" presId="urn:microsoft.com/office/officeart/2005/8/layout/hList1"/>
    <dgm:cxn modelId="{DE2C6629-56EB-42CF-8941-F4216B050ED3}" type="presOf" srcId="{21B8DAE8-3129-4F92-BBD8-A51923FB82AD}" destId="{E46A9C74-F8BF-488C-B7F2-336935415384}" srcOrd="0" destOrd="3" presId="urn:microsoft.com/office/officeart/2005/8/layout/hList1"/>
    <dgm:cxn modelId="{6D1E04E5-B031-49EB-9969-3B940BD1769C}" srcId="{F6BFFCF1-8AEB-462A-8E69-74F80BC2885B}" destId="{B93994D2-DADD-427F-9D64-A48BB3102579}" srcOrd="3" destOrd="0" parTransId="{D3AD7A55-5FB7-4CCE-B2CF-0CBE6E9576C9}" sibTransId="{865B05A4-45BF-4D20-B4A0-87E76A04BA20}"/>
    <dgm:cxn modelId="{7F39493D-D5E3-4320-B4F0-080F4C2F1D84}" srcId="{F6BFFCF1-8AEB-462A-8E69-74F80BC2885B}" destId="{42B71F9F-F3BB-42F4-B5EE-E830CDB12CBC}" srcOrd="5" destOrd="0" parTransId="{3DA71D5E-2842-4FDF-9C9F-49C11B6EC640}" sibTransId="{FC458FE8-73D7-45BA-931C-16CE62E5BCA0}"/>
    <dgm:cxn modelId="{DEDB1FF6-2735-4967-A0A6-2B32FCDFE9FB}" type="presOf" srcId="{4AB941CB-D15E-4185-A7C2-0A1BEA250598}" destId="{E46A9C74-F8BF-488C-B7F2-336935415384}" srcOrd="0" destOrd="6" presId="urn:microsoft.com/office/officeart/2005/8/layout/hList1"/>
    <dgm:cxn modelId="{65F57C64-4C2A-4E4C-9289-5E44C4015276}" srcId="{6E4E923E-95B1-4D5E-B280-CD273E2F2B84}" destId="{3B246152-0D6E-4F6F-A41D-4B45591DA12A}" srcOrd="2" destOrd="0" parTransId="{DD985BBD-4420-4500-BBEB-CD3429389C9E}" sibTransId="{28EF4241-FFF1-4616-B08F-65FC08ACD400}"/>
    <dgm:cxn modelId="{A5329B83-8F3F-47B5-B4F7-BD6777B758CE}" type="presOf" srcId="{B7BE3714-E71E-4F78-87D4-72E44C252396}" destId="{E46A9C74-F8BF-488C-B7F2-336935415384}" srcOrd="0" destOrd="0" presId="urn:microsoft.com/office/officeart/2005/8/layout/hList1"/>
    <dgm:cxn modelId="{6AD486D8-EBCC-4B58-9BF8-1BEFF0451A02}" type="presOf" srcId="{A08E933D-9F87-47D1-90AE-C57BB0DFD514}" destId="{D9466AE1-9A34-4D4E-86FE-C2008CE7AB3B}" srcOrd="0" destOrd="2" presId="urn:microsoft.com/office/officeart/2005/8/layout/hList1"/>
    <dgm:cxn modelId="{FA4908C6-1159-4062-B739-553D72AAD972}" srcId="{D6A87FD5-7E66-41D8-92DD-003C93D45C7C}" destId="{F6BFFCF1-8AEB-462A-8E69-74F80BC2885B}" srcOrd="1" destOrd="0" parTransId="{9927D082-2926-487F-AAF9-287E2E548E4F}" sibTransId="{9E6AE5A2-00BE-42A2-8C7A-E15DEB5858E3}"/>
    <dgm:cxn modelId="{1BB83E98-F094-4B88-BF70-E5D80BF372ED}" srcId="{6E4E923E-95B1-4D5E-B280-CD273E2F2B84}" destId="{D33CEC8C-7C47-4195-B824-ED025C6A6D1C}" srcOrd="1" destOrd="0" parTransId="{4B624C2E-684A-40E2-A0DC-52245911CA5E}" sibTransId="{3EC57AAD-58BD-47B3-9873-76E4C402A0D1}"/>
    <dgm:cxn modelId="{AF5DBF7D-2FDF-4A3A-9B57-52EF9D014208}" type="presOf" srcId="{6E4E923E-95B1-4D5E-B280-CD273E2F2B84}" destId="{9EB8A9FC-6EC7-4500-902C-BBBA51763018}" srcOrd="0" destOrd="0" presId="urn:microsoft.com/office/officeart/2005/8/layout/hList1"/>
    <dgm:cxn modelId="{8A061168-E7B0-4C3C-A5E2-F6ED2ACD4DAB}" srcId="{6E4E923E-95B1-4D5E-B280-CD273E2F2B84}" destId="{21B8DAE8-3129-4F92-BBD8-A51923FB82AD}" srcOrd="3" destOrd="0" parTransId="{9C20CBC4-DFDC-470D-AEA7-C17EF8D07D49}" sibTransId="{86452F44-AFB6-4982-9C6F-5E75DDA53F27}"/>
    <dgm:cxn modelId="{DFF011F7-583A-4C60-8129-DC78E32091A3}" type="presOf" srcId="{1430505E-B5EE-4BE6-9CEC-DB412E487E8E}" destId="{7304EC1B-8DC0-434D-AD14-1652F99002D4}" srcOrd="0" destOrd="3" presId="urn:microsoft.com/office/officeart/2005/8/layout/hList1"/>
    <dgm:cxn modelId="{8DBD80F4-285C-483B-9B8D-CAFC7816F88D}" type="presOf" srcId="{3FF1839F-8C7F-4C5C-A956-F0DCF7ED2A9E}" destId="{D9466AE1-9A34-4D4E-86FE-C2008CE7AB3B}" srcOrd="0" destOrd="0" presId="urn:microsoft.com/office/officeart/2005/8/layout/hList1"/>
    <dgm:cxn modelId="{A74E4FBD-5793-42E1-8F66-4AF763BDC83A}" srcId="{F6BFFCF1-8AEB-462A-8E69-74F80BC2885B}" destId="{A08E933D-9F87-47D1-90AE-C57BB0DFD514}" srcOrd="2" destOrd="0" parTransId="{C5FA192F-3547-493C-A060-66B036F8DFD2}" sibTransId="{FB65E6EC-69A1-4593-AE97-669BC4FB75AA}"/>
    <dgm:cxn modelId="{B184774D-CF36-4BD9-88C1-4758508E83D4}" srcId="{EFC8FE19-F895-42B0-98C8-5FA537962E9A}" destId="{3B67E9C0-D1EE-4DF0-8758-62D21496D1C4}" srcOrd="7" destOrd="0" parTransId="{8CBE6196-8282-419C-962E-2EE09A3264FB}" sibTransId="{A0886DE7-68CB-4803-8095-E725EC0E0B9C}"/>
    <dgm:cxn modelId="{4B18CF45-88B6-4369-AB0C-D4BA3759212E}" srcId="{EFC8FE19-F895-42B0-98C8-5FA537962E9A}" destId="{E690629F-D74A-45D5-83FF-185E78E42124}" srcOrd="5" destOrd="0" parTransId="{32F8D09D-9242-495F-A146-0535D6716A4A}" sibTransId="{C9DFC69A-078A-4C13-AE23-63C4F6D406A8}"/>
    <dgm:cxn modelId="{6AF0BBC2-B1A9-4370-8148-B55C572985D4}" srcId="{6E4E923E-95B1-4D5E-B280-CD273E2F2B84}" destId="{893CE747-DF46-4E9A-92C2-C048B6A1E0FE}" srcOrd="7" destOrd="0" parTransId="{3EAEE867-6446-4918-B7AD-DCF199A5FD7E}" sibTransId="{220EDB6E-5147-45AA-9311-B3AB53763427}"/>
    <dgm:cxn modelId="{B180732C-2110-48C2-875F-EFF3B40E0170}" type="presOf" srcId="{EFC8FE19-F895-42B0-98C8-5FA537962E9A}" destId="{60E7015A-8005-4379-89EA-F8421038CCB3}" srcOrd="0" destOrd="0" presId="urn:microsoft.com/office/officeart/2005/8/layout/hList1"/>
    <dgm:cxn modelId="{8E406A30-2BAC-41AA-B321-4F222FD4DFC0}" srcId="{EFC8FE19-F895-42B0-98C8-5FA537962E9A}" destId="{2DD53B9B-FF17-4442-978B-6EEDFA253E9A}" srcOrd="0" destOrd="0" parTransId="{474061A2-A3B2-475D-8279-C669D6274D5A}" sibTransId="{3B0B29DA-7936-41DE-BA93-310DD6D36484}"/>
    <dgm:cxn modelId="{26C510CD-BE65-4F4D-9508-181B0FC5253E}" srcId="{D6A87FD5-7E66-41D8-92DD-003C93D45C7C}" destId="{EFC8FE19-F895-42B0-98C8-5FA537962E9A}" srcOrd="0" destOrd="0" parTransId="{D2058A3E-750D-4401-A0CB-48EABCAFA215}" sibTransId="{E65A2683-D0DB-4D62-9A3D-5D7FAD730BFD}"/>
    <dgm:cxn modelId="{DF331A5F-4FB1-4059-898C-D7E95A5A84A6}" type="presOf" srcId="{F2318388-5E31-4C40-9F37-E458C8E529C0}" destId="{E46A9C74-F8BF-488C-B7F2-336935415384}" srcOrd="0" destOrd="4" presId="urn:microsoft.com/office/officeart/2005/8/layout/hList1"/>
    <dgm:cxn modelId="{CD7F1810-3613-42AD-BE04-2DE24CF33821}" type="presOf" srcId="{3B67E9C0-D1EE-4DF0-8758-62D21496D1C4}" destId="{7304EC1B-8DC0-434D-AD14-1652F99002D4}" srcOrd="0" destOrd="7" presId="urn:microsoft.com/office/officeart/2005/8/layout/hList1"/>
    <dgm:cxn modelId="{6D98E1AD-6744-426E-B25F-5727CC7DC172}" type="presOf" srcId="{42B71F9F-F3BB-42F4-B5EE-E830CDB12CBC}" destId="{D9466AE1-9A34-4D4E-86FE-C2008CE7AB3B}" srcOrd="0" destOrd="5" presId="urn:microsoft.com/office/officeart/2005/8/layout/hList1"/>
    <dgm:cxn modelId="{2D6B6388-11E8-4E0E-A035-8DB1FA2662C0}" type="presOf" srcId="{3561F7C6-5033-4778-8F48-4C9A15C1BBD7}" destId="{7304EC1B-8DC0-434D-AD14-1652F99002D4}" srcOrd="0" destOrd="1" presId="urn:microsoft.com/office/officeart/2005/8/layout/hList1"/>
    <dgm:cxn modelId="{D7114634-0D64-46F9-87D3-22BF7EB0EA9E}" type="presOf" srcId="{0906AA42-BF0D-42A2-A238-D1CEA11A3206}" destId="{7304EC1B-8DC0-434D-AD14-1652F99002D4}" srcOrd="0" destOrd="2" presId="urn:microsoft.com/office/officeart/2005/8/layout/hList1"/>
    <dgm:cxn modelId="{906DBCB2-3C9A-4466-B809-062344808C83}" type="presOf" srcId="{2DD53B9B-FF17-4442-978B-6EEDFA253E9A}" destId="{7304EC1B-8DC0-434D-AD14-1652F99002D4}" srcOrd="0" destOrd="0" presId="urn:microsoft.com/office/officeart/2005/8/layout/hList1"/>
    <dgm:cxn modelId="{D01ADDBA-C69D-4C9B-AAD4-26BA6B079670}" srcId="{6E4E923E-95B1-4D5E-B280-CD273E2F2B84}" destId="{4AB941CB-D15E-4185-A7C2-0A1BEA250598}" srcOrd="6" destOrd="0" parTransId="{EC86AA25-5FD4-4C3E-9337-194B1C82E73F}" sibTransId="{7B9BC0D7-4C2A-42A5-8B60-720E76E9D10C}"/>
    <dgm:cxn modelId="{DD9B186F-A70D-46D9-AF93-CCC6E8D54324}" type="presOf" srcId="{F7289522-547B-4228-99B4-0A6BEFEF313B}" destId="{D9466AE1-9A34-4D4E-86FE-C2008CE7AB3B}" srcOrd="0" destOrd="4" presId="urn:microsoft.com/office/officeart/2005/8/layout/hList1"/>
    <dgm:cxn modelId="{34F15FCD-EBA9-424E-BF04-338D453327C9}" srcId="{EFC8FE19-F895-42B0-98C8-5FA537962E9A}" destId="{1430505E-B5EE-4BE6-9CEC-DB412E487E8E}" srcOrd="3" destOrd="0" parTransId="{B0C95210-5FBA-4763-811D-01E090AA8212}" sibTransId="{0559AF13-5570-4A34-A700-6EA5D793C62A}"/>
    <dgm:cxn modelId="{5C31CB94-1FDF-4E1E-BAE0-444F70A9141A}" type="presOf" srcId="{F6BFFCF1-8AEB-462A-8E69-74F80BC2885B}" destId="{7C9C0131-9964-4AF9-A7B6-9BDB59F14E5E}" srcOrd="0" destOrd="0" presId="urn:microsoft.com/office/officeart/2005/8/layout/hList1"/>
    <dgm:cxn modelId="{B895DB48-F258-4D0E-A2E9-5226D9EC3C15}" srcId="{EFC8FE19-F895-42B0-98C8-5FA537962E9A}" destId="{6A1490E9-7C84-4B68-B08E-82844E7658D1}" srcOrd="4" destOrd="0" parTransId="{CDAAC3F1-9F56-4EED-8CB7-B65FDA5B2DCC}" sibTransId="{C596DED8-B571-4BA6-B6C5-7C877F67E874}"/>
    <dgm:cxn modelId="{233400DC-E1D8-4459-889C-57FE606DB351}" type="presOf" srcId="{6F1752B2-09C6-45C3-B16D-C17268CD4EBF}" destId="{E46A9C74-F8BF-488C-B7F2-336935415384}" srcOrd="0" destOrd="5" presId="urn:microsoft.com/office/officeart/2005/8/layout/hList1"/>
    <dgm:cxn modelId="{870E9276-CBDA-447A-B5F8-BEA37BD56A5F}" srcId="{EFC8FE19-F895-42B0-98C8-5FA537962E9A}" destId="{0906AA42-BF0D-42A2-A238-D1CEA11A3206}" srcOrd="2" destOrd="0" parTransId="{2CA5873C-64FD-45BC-BC72-B5E7C8BBBAF0}" sibTransId="{CBDD4BE8-B233-4DEE-91C5-A300986F6F58}"/>
    <dgm:cxn modelId="{D7BFAF59-FBE7-4B0C-B0EE-D0240CB2EF15}" srcId="{6E4E923E-95B1-4D5E-B280-CD273E2F2B84}" destId="{6F1752B2-09C6-45C3-B16D-C17268CD4EBF}" srcOrd="5" destOrd="0" parTransId="{946DDB78-345B-4BB0-A135-C89FD12CE886}" sibTransId="{2AA495B9-22AF-4099-8365-FDF6918E583D}"/>
    <dgm:cxn modelId="{1106BD4A-AA0A-463B-AEE3-B5049D9FC30A}" type="presOf" srcId="{E690629F-D74A-45D5-83FF-185E78E42124}" destId="{7304EC1B-8DC0-434D-AD14-1652F99002D4}" srcOrd="0" destOrd="5" presId="urn:microsoft.com/office/officeart/2005/8/layout/hList1"/>
    <dgm:cxn modelId="{20E97DFB-9111-4E5C-A338-C8E988178959}" srcId="{D6A87FD5-7E66-41D8-92DD-003C93D45C7C}" destId="{6E4E923E-95B1-4D5E-B280-CD273E2F2B84}" srcOrd="2" destOrd="0" parTransId="{D93EB422-902A-4EAF-B0FA-88D8AF04FE8E}" sibTransId="{55CA7460-ADC9-42F9-B9C9-311C158426A8}"/>
    <dgm:cxn modelId="{76BF13D6-89A2-4A5E-82E6-C42BD05BFB91}" type="presOf" srcId="{D33CEC8C-7C47-4195-B824-ED025C6A6D1C}" destId="{E46A9C74-F8BF-488C-B7F2-336935415384}" srcOrd="0" destOrd="1" presId="urn:microsoft.com/office/officeart/2005/8/layout/hList1"/>
    <dgm:cxn modelId="{4B7D8B46-A979-4272-8777-564AB3047C27}" srcId="{F6BFFCF1-8AEB-462A-8E69-74F80BC2885B}" destId="{87568B15-5CC6-46E5-9527-EA38C5D4A05C}" srcOrd="1" destOrd="0" parTransId="{95CAE194-7648-4718-AB8C-FC02ECCDC569}" sibTransId="{C01D04FA-DBCA-4151-B79D-1BF9D5616AEE}"/>
    <dgm:cxn modelId="{F4F25A3B-605A-48B8-9BD0-B293ECCCFDF0}" type="presOf" srcId="{C79D07BD-8EF4-48A7-BA78-058C4DF3EF11}" destId="{D9466AE1-9A34-4D4E-86FE-C2008CE7AB3B}" srcOrd="0" destOrd="6" presId="urn:microsoft.com/office/officeart/2005/8/layout/hList1"/>
    <dgm:cxn modelId="{9C50C74A-3468-4790-8A37-1972FC6C1EC4}" srcId="{6E4E923E-95B1-4D5E-B280-CD273E2F2B84}" destId="{B7BE3714-E71E-4F78-87D4-72E44C252396}" srcOrd="0" destOrd="0" parTransId="{6DC8358C-E385-4B0D-AD45-56884BA4F314}" sibTransId="{C37691B7-E8C2-4D08-8F56-3D63DDA97914}"/>
    <dgm:cxn modelId="{C9DE073B-36C8-4239-9DCD-A6A8BA33F0FF}" type="presOf" srcId="{893CE747-DF46-4E9A-92C2-C048B6A1E0FE}" destId="{E46A9C74-F8BF-488C-B7F2-336935415384}" srcOrd="0" destOrd="7" presId="urn:microsoft.com/office/officeart/2005/8/layout/hList1"/>
    <dgm:cxn modelId="{61E00729-47C3-4A77-8ED6-9ABE29CE2BD4}" srcId="{F6BFFCF1-8AEB-462A-8E69-74F80BC2885B}" destId="{F7289522-547B-4228-99B4-0A6BEFEF313B}" srcOrd="4" destOrd="0" parTransId="{7EC39DB5-3B90-497D-B853-A835CB1D5CDF}" sibTransId="{2F24F979-16EE-4E8A-B3D3-5AB41833B9AA}"/>
    <dgm:cxn modelId="{3AB01B63-265E-443C-9E2E-869F60E6647B}" srcId="{6E4E923E-95B1-4D5E-B280-CD273E2F2B84}" destId="{F2318388-5E31-4C40-9F37-E458C8E529C0}" srcOrd="4" destOrd="0" parTransId="{EF12B1AC-7C5D-4F4A-B208-EA186A340CAF}" sibTransId="{A12334B4-A2BF-4364-970F-C58ED60B94B7}"/>
    <dgm:cxn modelId="{95C2AE73-5112-4FCF-90A4-A627B7B696EF}" type="presOf" srcId="{87568B15-5CC6-46E5-9527-EA38C5D4A05C}" destId="{D9466AE1-9A34-4D4E-86FE-C2008CE7AB3B}" srcOrd="0" destOrd="1" presId="urn:microsoft.com/office/officeart/2005/8/layout/hList1"/>
    <dgm:cxn modelId="{9A228135-8E12-4001-9AC3-8ADE2CBD5652}" type="presOf" srcId="{B93994D2-DADD-427F-9D64-A48BB3102579}" destId="{D9466AE1-9A34-4D4E-86FE-C2008CE7AB3B}" srcOrd="0" destOrd="3" presId="urn:microsoft.com/office/officeart/2005/8/layout/hList1"/>
    <dgm:cxn modelId="{9BCE83B7-D322-4284-B53F-A0C0C1D2F74F}" srcId="{F6BFFCF1-8AEB-462A-8E69-74F80BC2885B}" destId="{3FF1839F-8C7F-4C5C-A956-F0DCF7ED2A9E}" srcOrd="0" destOrd="0" parTransId="{0A23AE63-1806-427C-951C-3F27EBA498A9}" sibTransId="{3C7C9628-636F-4916-9EF3-0B81F2380BC0}"/>
    <dgm:cxn modelId="{65EFB786-CAF5-45CF-8B79-24593B3A8917}" type="presParOf" srcId="{E1A25620-7E13-46FB-B3D0-5E0975B795E1}" destId="{F6A1B179-34A2-4460-968F-5B34B4E9F5DF}" srcOrd="0" destOrd="0" presId="urn:microsoft.com/office/officeart/2005/8/layout/hList1"/>
    <dgm:cxn modelId="{ECD9E421-A339-4253-B062-9D73B0F5A274}" type="presParOf" srcId="{F6A1B179-34A2-4460-968F-5B34B4E9F5DF}" destId="{60E7015A-8005-4379-89EA-F8421038CCB3}" srcOrd="0" destOrd="0" presId="urn:microsoft.com/office/officeart/2005/8/layout/hList1"/>
    <dgm:cxn modelId="{3B51553B-5600-4D94-B02A-ED0649E17C15}" type="presParOf" srcId="{F6A1B179-34A2-4460-968F-5B34B4E9F5DF}" destId="{7304EC1B-8DC0-434D-AD14-1652F99002D4}" srcOrd="1" destOrd="0" presId="urn:microsoft.com/office/officeart/2005/8/layout/hList1"/>
    <dgm:cxn modelId="{A9A6D8AD-36DA-4B56-9157-6ED546476800}" type="presParOf" srcId="{E1A25620-7E13-46FB-B3D0-5E0975B795E1}" destId="{B556F00D-3ACE-4930-9FD5-E81C20D1D5BA}" srcOrd="1" destOrd="0" presId="urn:microsoft.com/office/officeart/2005/8/layout/hList1"/>
    <dgm:cxn modelId="{291E62CE-6715-4DC2-A0FA-9B66BD738D12}" type="presParOf" srcId="{E1A25620-7E13-46FB-B3D0-5E0975B795E1}" destId="{23675ACD-1FBD-4C01-B78C-3837E220DF94}" srcOrd="2" destOrd="0" presId="urn:microsoft.com/office/officeart/2005/8/layout/hList1"/>
    <dgm:cxn modelId="{E90810CE-E0D1-40FA-A278-B3BF4C576279}" type="presParOf" srcId="{23675ACD-1FBD-4C01-B78C-3837E220DF94}" destId="{7C9C0131-9964-4AF9-A7B6-9BDB59F14E5E}" srcOrd="0" destOrd="0" presId="urn:microsoft.com/office/officeart/2005/8/layout/hList1"/>
    <dgm:cxn modelId="{63DC93BA-8EE4-4B5D-B177-89818E827FCB}" type="presParOf" srcId="{23675ACD-1FBD-4C01-B78C-3837E220DF94}" destId="{D9466AE1-9A34-4D4E-86FE-C2008CE7AB3B}" srcOrd="1" destOrd="0" presId="urn:microsoft.com/office/officeart/2005/8/layout/hList1"/>
    <dgm:cxn modelId="{B92493D6-3BA5-46DD-B7B6-5152E2140D5C}" type="presParOf" srcId="{E1A25620-7E13-46FB-B3D0-5E0975B795E1}" destId="{73DA372B-A428-4EF2-88F9-4D9763068712}" srcOrd="3" destOrd="0" presId="urn:microsoft.com/office/officeart/2005/8/layout/hList1"/>
    <dgm:cxn modelId="{68B15804-F143-4362-A07E-4E6670C97607}" type="presParOf" srcId="{E1A25620-7E13-46FB-B3D0-5E0975B795E1}" destId="{D0DB70DD-D703-4617-AD21-237911F2A039}" srcOrd="4" destOrd="0" presId="urn:microsoft.com/office/officeart/2005/8/layout/hList1"/>
    <dgm:cxn modelId="{5A47C8CB-63DC-468E-A20A-A6081A4A2D8E}" type="presParOf" srcId="{D0DB70DD-D703-4617-AD21-237911F2A039}" destId="{9EB8A9FC-6EC7-4500-902C-BBBA51763018}" srcOrd="0" destOrd="0" presId="urn:microsoft.com/office/officeart/2005/8/layout/hList1"/>
    <dgm:cxn modelId="{E384BD7B-F913-4E39-89BB-1B775E6BAF53}" type="presParOf" srcId="{D0DB70DD-D703-4617-AD21-237911F2A039}" destId="{E46A9C74-F8BF-488C-B7F2-336935415384}" srcOrd="1" destOrd="0" presId="urn:microsoft.com/office/officeart/2005/8/layout/hLis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BF831EA-AFE1-4409-9A43-97513AC38993}">
      <dsp:nvSpPr>
        <dsp:cNvPr id="0" name=""/>
        <dsp:cNvSpPr/>
      </dsp:nvSpPr>
      <dsp:spPr>
        <a:xfrm>
          <a:off x="5585455" y="3700013"/>
          <a:ext cx="237208" cy="164845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48452"/>
              </a:lnTo>
              <a:lnTo>
                <a:pt x="237208" y="1648452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DA89364-3858-468A-AAA2-805A72E62C8D}">
      <dsp:nvSpPr>
        <dsp:cNvPr id="0" name=""/>
        <dsp:cNvSpPr/>
      </dsp:nvSpPr>
      <dsp:spPr>
        <a:xfrm>
          <a:off x="4953750" y="2702336"/>
          <a:ext cx="1193776" cy="29508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7543"/>
              </a:lnTo>
              <a:lnTo>
                <a:pt x="1193776" y="147543"/>
              </a:lnTo>
              <a:lnTo>
                <a:pt x="1193776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E476DFA-B7F7-4B0C-AA45-60FDF6617330}">
      <dsp:nvSpPr>
        <dsp:cNvPr id="0" name=""/>
        <dsp:cNvSpPr/>
      </dsp:nvSpPr>
      <dsp:spPr>
        <a:xfrm>
          <a:off x="3541546" y="4697689"/>
          <a:ext cx="210776" cy="64638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646382"/>
              </a:lnTo>
              <a:lnTo>
                <a:pt x="210776" y="646382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B9BA3AB-EEA9-42C4-B1AC-3832A95639CA}">
      <dsp:nvSpPr>
        <dsp:cNvPr id="0" name=""/>
        <dsp:cNvSpPr/>
      </dsp:nvSpPr>
      <dsp:spPr>
        <a:xfrm>
          <a:off x="4057897" y="3700013"/>
          <a:ext cx="91440" cy="29508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3A97686-2ABE-4A2B-A347-3C0B0FDC45F4}">
      <dsp:nvSpPr>
        <dsp:cNvPr id="0" name=""/>
        <dsp:cNvSpPr/>
      </dsp:nvSpPr>
      <dsp:spPr>
        <a:xfrm>
          <a:off x="4103617" y="2702336"/>
          <a:ext cx="850133" cy="295087"/>
        </a:xfrm>
        <a:custGeom>
          <a:avLst/>
          <a:gdLst/>
          <a:ahLst/>
          <a:cxnLst/>
          <a:rect l="0" t="0" r="0" b="0"/>
          <a:pathLst>
            <a:path>
              <a:moveTo>
                <a:pt x="850133" y="0"/>
              </a:moveTo>
              <a:lnTo>
                <a:pt x="850133" y="147543"/>
              </a:lnTo>
              <a:lnTo>
                <a:pt x="0" y="147543"/>
              </a:lnTo>
              <a:lnTo>
                <a:pt x="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EEB0294-43D7-4DF2-809D-7287859C4A8B}">
      <dsp:nvSpPr>
        <dsp:cNvPr id="0" name=""/>
        <dsp:cNvSpPr/>
      </dsp:nvSpPr>
      <dsp:spPr>
        <a:xfrm>
          <a:off x="3506729" y="1704659"/>
          <a:ext cx="1447021" cy="29508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7543"/>
              </a:lnTo>
              <a:lnTo>
                <a:pt x="1447021" y="147543"/>
              </a:lnTo>
              <a:lnTo>
                <a:pt x="1447021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BC4920F-59C1-47AA-9D1E-00F085041438}">
      <dsp:nvSpPr>
        <dsp:cNvPr id="0" name=""/>
        <dsp:cNvSpPr/>
      </dsp:nvSpPr>
      <dsp:spPr>
        <a:xfrm>
          <a:off x="1497636" y="4697689"/>
          <a:ext cx="210776" cy="64638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646382"/>
              </a:lnTo>
              <a:lnTo>
                <a:pt x="210776" y="646382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932B976-1306-409D-A15E-523C7A699DB3}">
      <dsp:nvSpPr>
        <dsp:cNvPr id="0" name=""/>
        <dsp:cNvSpPr/>
      </dsp:nvSpPr>
      <dsp:spPr>
        <a:xfrm>
          <a:off x="2013988" y="3700013"/>
          <a:ext cx="91440" cy="29508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1C87CDF-86FC-43F2-A129-62EAC6215B0C}">
      <dsp:nvSpPr>
        <dsp:cNvPr id="0" name=""/>
        <dsp:cNvSpPr/>
      </dsp:nvSpPr>
      <dsp:spPr>
        <a:xfrm>
          <a:off x="2013988" y="2702336"/>
          <a:ext cx="91440" cy="29508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76CA4B5-53D5-4A19-882B-CA93D30E2B54}">
      <dsp:nvSpPr>
        <dsp:cNvPr id="0" name=""/>
        <dsp:cNvSpPr/>
      </dsp:nvSpPr>
      <dsp:spPr>
        <a:xfrm>
          <a:off x="2059708" y="1704659"/>
          <a:ext cx="1447021" cy="295087"/>
        </a:xfrm>
        <a:custGeom>
          <a:avLst/>
          <a:gdLst/>
          <a:ahLst/>
          <a:cxnLst/>
          <a:rect l="0" t="0" r="0" b="0"/>
          <a:pathLst>
            <a:path>
              <a:moveTo>
                <a:pt x="1447021" y="0"/>
              </a:moveTo>
              <a:lnTo>
                <a:pt x="1447021" y="147543"/>
              </a:lnTo>
              <a:lnTo>
                <a:pt x="0" y="147543"/>
              </a:lnTo>
              <a:lnTo>
                <a:pt x="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DC54BB8-D923-405C-A452-A0897CF2B5BD}">
      <dsp:nvSpPr>
        <dsp:cNvPr id="0" name=""/>
        <dsp:cNvSpPr/>
      </dsp:nvSpPr>
      <dsp:spPr>
        <a:xfrm>
          <a:off x="3461009" y="706982"/>
          <a:ext cx="91440" cy="29508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9508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90AA2EC-F0AB-440F-A9A0-09AA76F5468A}">
      <dsp:nvSpPr>
        <dsp:cNvPr id="0" name=""/>
        <dsp:cNvSpPr/>
      </dsp:nvSpPr>
      <dsp:spPr>
        <a:xfrm>
          <a:off x="2804140" y="4393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&lt;33 wks</a:t>
          </a:r>
        </a:p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Apneic/bradycardic in DR</a:t>
          </a:r>
        </a:p>
      </dsp:txBody>
      <dsp:txXfrm>
        <a:off x="2804140" y="4393"/>
        <a:ext cx="1405178" cy="702589"/>
      </dsp:txXfrm>
    </dsp:sp>
    <dsp:sp modelId="{C7002D31-D535-4545-AB27-DC7B00C0CF02}">
      <dsp:nvSpPr>
        <dsp:cNvPr id="0" name=""/>
        <dsp:cNvSpPr/>
      </dsp:nvSpPr>
      <dsp:spPr>
        <a:xfrm>
          <a:off x="2804140" y="1002070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Resuscitate per NRP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a</a:t>
          </a:r>
        </a:p>
      </dsp:txBody>
      <dsp:txXfrm>
        <a:off x="2804140" y="1002070"/>
        <a:ext cx="1405178" cy="702589"/>
      </dsp:txXfrm>
    </dsp:sp>
    <dsp:sp modelId="{B9FBD0DF-1994-4756-9C31-863763F81800}">
      <dsp:nvSpPr>
        <dsp:cNvPr id="0" name=""/>
        <dsp:cNvSpPr/>
      </dsp:nvSpPr>
      <dsp:spPr>
        <a:xfrm>
          <a:off x="1357118" y="1999746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tubate if necessary for resuscitation and give surfactant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</a:t>
          </a:r>
        </a:p>
      </dsp:txBody>
      <dsp:txXfrm>
        <a:off x="1357118" y="1999746"/>
        <a:ext cx="1405178" cy="702589"/>
      </dsp:txXfrm>
    </dsp:sp>
    <dsp:sp modelId="{EB2B9AAD-5B70-4168-B7B8-2B6B1B4EBF89}">
      <dsp:nvSpPr>
        <dsp:cNvPr id="0" name=""/>
        <dsp:cNvSpPr/>
      </dsp:nvSpPr>
      <dsp:spPr>
        <a:xfrm>
          <a:off x="1357118" y="2997423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on SIMV/VG, HFOV or Jet as needed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</a:t>
          </a:r>
        </a:p>
      </dsp:txBody>
      <dsp:txXfrm>
        <a:off x="1357118" y="2997423"/>
        <a:ext cx="1405178" cy="702589"/>
      </dsp:txXfrm>
    </dsp:sp>
    <dsp:sp modelId="{982014A9-B66D-4A91-9A94-B34D021A57D6}">
      <dsp:nvSpPr>
        <dsp:cNvPr id="0" name=""/>
        <dsp:cNvSpPr/>
      </dsp:nvSpPr>
      <dsp:spPr>
        <a:xfrm>
          <a:off x="1357118" y="3995100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xtubate to bCPAP when meets criteria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</a:t>
          </a:r>
        </a:p>
      </dsp:txBody>
      <dsp:txXfrm>
        <a:off x="1357118" y="3995100"/>
        <a:ext cx="1405178" cy="702589"/>
      </dsp:txXfrm>
    </dsp:sp>
    <dsp:sp modelId="{B1529871-218B-4228-96AF-5E87ED27CF35}">
      <dsp:nvSpPr>
        <dsp:cNvPr id="0" name=""/>
        <dsp:cNvSpPr/>
      </dsp:nvSpPr>
      <dsp:spPr>
        <a:xfrm>
          <a:off x="1708413" y="4992777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sp:txBody>
      <dsp:txXfrm>
        <a:off x="1708413" y="4992777"/>
        <a:ext cx="1405178" cy="702589"/>
      </dsp:txXfrm>
    </dsp:sp>
    <dsp:sp modelId="{F09554AF-D713-43F4-96BF-9D1E57E606EF}">
      <dsp:nvSpPr>
        <dsp:cNvPr id="0" name=""/>
        <dsp:cNvSpPr/>
      </dsp:nvSpPr>
      <dsp:spPr>
        <a:xfrm>
          <a:off x="4251161" y="1999746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f recovers, start bCPAP if &lt;30 wks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</a:t>
          </a: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or any respiratory distress</a:t>
          </a:r>
        </a:p>
      </dsp:txBody>
      <dsp:txXfrm>
        <a:off x="4251161" y="1999746"/>
        <a:ext cx="1405178" cy="702589"/>
      </dsp:txXfrm>
    </dsp:sp>
    <dsp:sp modelId="{41D212A3-AA7A-4E51-8C61-853FFBDE9862}">
      <dsp:nvSpPr>
        <dsp:cNvPr id="0" name=""/>
        <dsp:cNvSpPr/>
      </dsp:nvSpPr>
      <dsp:spPr>
        <a:xfrm>
          <a:off x="3057384" y="2997423"/>
          <a:ext cx="2092465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tubate if subsequently meets criteria and give surfactant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</a:t>
          </a:r>
          <a:r>
            <a:rPr lang="en-US" sz="1200" kern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;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 </a:t>
          </a:r>
          <a:r>
            <a:rPr lang="en-US" sz="1200" kern="1200" baseline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on SIMV/VG, HFOV or Jet as needed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</a:t>
          </a:r>
        </a:p>
      </dsp:txBody>
      <dsp:txXfrm>
        <a:off x="3057384" y="2997423"/>
        <a:ext cx="2092465" cy="702589"/>
      </dsp:txXfrm>
    </dsp:sp>
    <dsp:sp modelId="{DC03FCA1-2108-44CC-B393-29149704164B}">
      <dsp:nvSpPr>
        <dsp:cNvPr id="0" name=""/>
        <dsp:cNvSpPr/>
      </dsp:nvSpPr>
      <dsp:spPr>
        <a:xfrm>
          <a:off x="3401028" y="3995100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xtubate to bCPAP when meets criteria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</a:t>
          </a:r>
        </a:p>
      </dsp:txBody>
      <dsp:txXfrm>
        <a:off x="3401028" y="3995100"/>
        <a:ext cx="1405178" cy="702589"/>
      </dsp:txXfrm>
    </dsp:sp>
    <dsp:sp modelId="{FA7B853B-736E-4B1D-B69F-0D470A71E34E}">
      <dsp:nvSpPr>
        <dsp:cNvPr id="0" name=""/>
        <dsp:cNvSpPr/>
      </dsp:nvSpPr>
      <dsp:spPr>
        <a:xfrm>
          <a:off x="3752323" y="4992777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ysClr val="windowText" lastClr="000000">
              <a:shade val="80000"/>
              <a:hueOff val="0"/>
              <a:satOff val="0"/>
              <a:lum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sp:txBody>
      <dsp:txXfrm>
        <a:off x="3752323" y="4992777"/>
        <a:ext cx="1405178" cy="702589"/>
      </dsp:txXfrm>
    </dsp:sp>
    <dsp:sp modelId="{E03A8F3E-0B6B-42A6-96D6-74098ED27472}">
      <dsp:nvSpPr>
        <dsp:cNvPr id="0" name=""/>
        <dsp:cNvSpPr/>
      </dsp:nvSpPr>
      <dsp:spPr>
        <a:xfrm>
          <a:off x="5444937" y="2997423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ntinue bCPAP</a:t>
          </a:r>
        </a:p>
      </dsp:txBody>
      <dsp:txXfrm>
        <a:off x="5444937" y="2997423"/>
        <a:ext cx="1405178" cy="702589"/>
      </dsp:txXfrm>
    </dsp:sp>
    <dsp:sp modelId="{52617DA3-E456-449C-B04D-8FC6AF54F07C}">
      <dsp:nvSpPr>
        <dsp:cNvPr id="0" name=""/>
        <dsp:cNvSpPr/>
      </dsp:nvSpPr>
      <dsp:spPr>
        <a:xfrm>
          <a:off x="5822663" y="4997170"/>
          <a:ext cx="1405178" cy="702589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sp:txBody>
      <dsp:txXfrm>
        <a:off x="5822663" y="4997170"/>
        <a:ext cx="1405178" cy="702589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63EA82D-BEFE-463A-BC48-457D1AEDD6FF}">
      <dsp:nvSpPr>
        <dsp:cNvPr id="0" name=""/>
        <dsp:cNvSpPr/>
      </dsp:nvSpPr>
      <dsp:spPr>
        <a:xfrm>
          <a:off x="6223115" y="3886841"/>
          <a:ext cx="183666" cy="128233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82331"/>
              </a:lnTo>
              <a:lnTo>
                <a:pt x="183666" y="1282331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D3CA998-6F46-449C-BAE8-437D88BA755F}">
      <dsp:nvSpPr>
        <dsp:cNvPr id="0" name=""/>
        <dsp:cNvSpPr/>
      </dsp:nvSpPr>
      <dsp:spPr>
        <a:xfrm>
          <a:off x="5365403" y="3060982"/>
          <a:ext cx="1322984" cy="244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2133"/>
              </a:lnTo>
              <a:lnTo>
                <a:pt x="1322984" y="122133"/>
              </a:lnTo>
              <a:lnTo>
                <a:pt x="1322984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D9931AB-5D63-4E48-95CD-8ECFF39ABB92}">
      <dsp:nvSpPr>
        <dsp:cNvPr id="0" name=""/>
        <dsp:cNvSpPr/>
      </dsp:nvSpPr>
      <dsp:spPr>
        <a:xfrm>
          <a:off x="4196407" y="4712699"/>
          <a:ext cx="159716" cy="45112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451128"/>
              </a:lnTo>
              <a:lnTo>
                <a:pt x="159716" y="451128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31372C7-EBAD-4D65-9912-8B18643DCC8F}">
      <dsp:nvSpPr>
        <dsp:cNvPr id="0" name=""/>
        <dsp:cNvSpPr/>
      </dsp:nvSpPr>
      <dsp:spPr>
        <a:xfrm>
          <a:off x="4615959" y="3886841"/>
          <a:ext cx="91440" cy="24426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E46DB7E-DFA6-4EE7-B928-53A393BD8D10}">
      <dsp:nvSpPr>
        <dsp:cNvPr id="0" name=""/>
        <dsp:cNvSpPr/>
      </dsp:nvSpPr>
      <dsp:spPr>
        <a:xfrm>
          <a:off x="4661679" y="3060982"/>
          <a:ext cx="703724" cy="244267"/>
        </a:xfrm>
        <a:custGeom>
          <a:avLst/>
          <a:gdLst/>
          <a:ahLst/>
          <a:cxnLst/>
          <a:rect l="0" t="0" r="0" b="0"/>
          <a:pathLst>
            <a:path>
              <a:moveTo>
                <a:pt x="703724" y="0"/>
              </a:moveTo>
              <a:lnTo>
                <a:pt x="703724" y="122133"/>
              </a:lnTo>
              <a:lnTo>
                <a:pt x="0" y="122133"/>
              </a:lnTo>
              <a:lnTo>
                <a:pt x="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23256B6-A72F-481C-B391-067AF3F0A50C}">
      <dsp:nvSpPr>
        <dsp:cNvPr id="0" name=""/>
        <dsp:cNvSpPr/>
      </dsp:nvSpPr>
      <dsp:spPr>
        <a:xfrm>
          <a:off x="5319683" y="2235124"/>
          <a:ext cx="91440" cy="24426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C62BEED-2FF8-45C3-B01B-6BB0A0FA8AAC}">
      <dsp:nvSpPr>
        <dsp:cNvPr id="0" name=""/>
        <dsp:cNvSpPr/>
      </dsp:nvSpPr>
      <dsp:spPr>
        <a:xfrm>
          <a:off x="4516281" y="1409266"/>
          <a:ext cx="849121" cy="244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2133"/>
              </a:lnTo>
              <a:lnTo>
                <a:pt x="849121" y="122133"/>
              </a:lnTo>
              <a:lnTo>
                <a:pt x="849121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BCCC868-4018-4775-9E5C-F114D979F4A5}">
      <dsp:nvSpPr>
        <dsp:cNvPr id="0" name=""/>
        <dsp:cNvSpPr/>
      </dsp:nvSpPr>
      <dsp:spPr>
        <a:xfrm>
          <a:off x="3201887" y="2235124"/>
          <a:ext cx="174477" cy="53506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35063"/>
              </a:lnTo>
              <a:lnTo>
                <a:pt x="174477" y="535063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78914A4-EA34-47AF-8CBA-E2B8E236BAC2}">
      <dsp:nvSpPr>
        <dsp:cNvPr id="0" name=""/>
        <dsp:cNvSpPr/>
      </dsp:nvSpPr>
      <dsp:spPr>
        <a:xfrm>
          <a:off x="3667159" y="1409266"/>
          <a:ext cx="849121" cy="244267"/>
        </a:xfrm>
        <a:custGeom>
          <a:avLst/>
          <a:gdLst/>
          <a:ahLst/>
          <a:cxnLst/>
          <a:rect l="0" t="0" r="0" b="0"/>
          <a:pathLst>
            <a:path>
              <a:moveTo>
                <a:pt x="849121" y="0"/>
              </a:moveTo>
              <a:lnTo>
                <a:pt x="849121" y="122133"/>
              </a:lnTo>
              <a:lnTo>
                <a:pt x="0" y="122133"/>
              </a:lnTo>
              <a:lnTo>
                <a:pt x="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19BAF5B-EC7A-424B-986A-B1E37CCDAFA5}">
      <dsp:nvSpPr>
        <dsp:cNvPr id="0" name=""/>
        <dsp:cNvSpPr/>
      </dsp:nvSpPr>
      <dsp:spPr>
        <a:xfrm>
          <a:off x="3078366" y="583407"/>
          <a:ext cx="1437915" cy="244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2133"/>
              </a:lnTo>
              <a:lnTo>
                <a:pt x="1437915" y="122133"/>
              </a:lnTo>
              <a:lnTo>
                <a:pt x="1437915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E0C8F46-ECE4-4D8B-9B56-1DBCA13D674E}">
      <dsp:nvSpPr>
        <dsp:cNvPr id="0" name=""/>
        <dsp:cNvSpPr/>
      </dsp:nvSpPr>
      <dsp:spPr>
        <a:xfrm>
          <a:off x="1878903" y="3060982"/>
          <a:ext cx="148410" cy="209877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098773"/>
              </a:lnTo>
              <a:lnTo>
                <a:pt x="148410" y="2098773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2193677-9331-46DE-8ABB-3178A8E28ECC}">
      <dsp:nvSpPr>
        <dsp:cNvPr id="0" name=""/>
        <dsp:cNvSpPr/>
      </dsp:nvSpPr>
      <dsp:spPr>
        <a:xfrm>
          <a:off x="1640451" y="2235124"/>
          <a:ext cx="703724" cy="244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2133"/>
              </a:lnTo>
              <a:lnTo>
                <a:pt x="703724" y="122133"/>
              </a:lnTo>
              <a:lnTo>
                <a:pt x="703724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1ECBBA8-5795-4D4C-BF31-0C8EC1A75860}">
      <dsp:nvSpPr>
        <dsp:cNvPr id="0" name=""/>
        <dsp:cNvSpPr/>
      </dsp:nvSpPr>
      <dsp:spPr>
        <a:xfrm>
          <a:off x="471454" y="4712699"/>
          <a:ext cx="159716" cy="45112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451128"/>
              </a:lnTo>
              <a:lnTo>
                <a:pt x="159716" y="451128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A455279-91E0-4465-8CD0-8A0BA40AF2F3}">
      <dsp:nvSpPr>
        <dsp:cNvPr id="0" name=""/>
        <dsp:cNvSpPr/>
      </dsp:nvSpPr>
      <dsp:spPr>
        <a:xfrm>
          <a:off x="888354" y="3880141"/>
          <a:ext cx="91440" cy="25096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128833"/>
              </a:lnTo>
              <a:lnTo>
                <a:pt x="48372" y="128833"/>
              </a:lnTo>
              <a:lnTo>
                <a:pt x="48372" y="2509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A154D89-DEA1-42C2-87BD-7D9536AA01AB}">
      <dsp:nvSpPr>
        <dsp:cNvPr id="0" name=""/>
        <dsp:cNvSpPr/>
      </dsp:nvSpPr>
      <dsp:spPr>
        <a:xfrm>
          <a:off x="888354" y="3060982"/>
          <a:ext cx="91440" cy="237568"/>
        </a:xfrm>
        <a:custGeom>
          <a:avLst/>
          <a:gdLst/>
          <a:ahLst/>
          <a:cxnLst/>
          <a:rect l="0" t="0" r="0" b="0"/>
          <a:pathLst>
            <a:path>
              <a:moveTo>
                <a:pt x="48372" y="0"/>
              </a:moveTo>
              <a:lnTo>
                <a:pt x="48372" y="115434"/>
              </a:lnTo>
              <a:lnTo>
                <a:pt x="45720" y="115434"/>
              </a:lnTo>
              <a:lnTo>
                <a:pt x="45720" y="237568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C717FC1-4E3E-48F1-AA46-47DD2843595D}">
      <dsp:nvSpPr>
        <dsp:cNvPr id="0" name=""/>
        <dsp:cNvSpPr/>
      </dsp:nvSpPr>
      <dsp:spPr>
        <a:xfrm>
          <a:off x="936726" y="2235124"/>
          <a:ext cx="703724" cy="244267"/>
        </a:xfrm>
        <a:custGeom>
          <a:avLst/>
          <a:gdLst/>
          <a:ahLst/>
          <a:cxnLst/>
          <a:rect l="0" t="0" r="0" b="0"/>
          <a:pathLst>
            <a:path>
              <a:moveTo>
                <a:pt x="703724" y="0"/>
              </a:moveTo>
              <a:lnTo>
                <a:pt x="703724" y="122133"/>
              </a:lnTo>
              <a:lnTo>
                <a:pt x="0" y="122133"/>
              </a:lnTo>
              <a:lnTo>
                <a:pt x="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AF52C0B-CD12-4E72-818C-A64BD411952C}">
      <dsp:nvSpPr>
        <dsp:cNvPr id="0" name=""/>
        <dsp:cNvSpPr/>
      </dsp:nvSpPr>
      <dsp:spPr>
        <a:xfrm>
          <a:off x="1594731" y="1409266"/>
          <a:ext cx="91440" cy="24426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E25F900-08B2-46B1-B63F-BD507D7D18E6}">
      <dsp:nvSpPr>
        <dsp:cNvPr id="0" name=""/>
        <dsp:cNvSpPr/>
      </dsp:nvSpPr>
      <dsp:spPr>
        <a:xfrm>
          <a:off x="1640451" y="583407"/>
          <a:ext cx="1437915" cy="244267"/>
        </a:xfrm>
        <a:custGeom>
          <a:avLst/>
          <a:gdLst/>
          <a:ahLst/>
          <a:cxnLst/>
          <a:rect l="0" t="0" r="0" b="0"/>
          <a:pathLst>
            <a:path>
              <a:moveTo>
                <a:pt x="1437915" y="0"/>
              </a:moveTo>
              <a:lnTo>
                <a:pt x="1437915" y="122133"/>
              </a:lnTo>
              <a:lnTo>
                <a:pt x="0" y="122133"/>
              </a:lnTo>
              <a:lnTo>
                <a:pt x="0" y="244267"/>
              </a:lnTo>
            </a:path>
          </a:pathLst>
        </a:custGeom>
        <a:noFill/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16F7E75-2C53-44DA-9580-51F22722035A}">
      <dsp:nvSpPr>
        <dsp:cNvPr id="0" name=""/>
        <dsp:cNvSpPr/>
      </dsp:nvSpPr>
      <dsp:spPr>
        <a:xfrm>
          <a:off x="2496776" y="1817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&lt;33 wks and vigorous in DR</a:t>
          </a:r>
        </a:p>
      </dsp:txBody>
      <dsp:txXfrm>
        <a:off x="2496776" y="1817"/>
        <a:ext cx="1163180" cy="581590"/>
      </dsp:txXfrm>
    </dsp:sp>
    <dsp:sp modelId="{540EA148-831F-4B59-A5CA-0BC58D7BA3A2}">
      <dsp:nvSpPr>
        <dsp:cNvPr id="0" name=""/>
        <dsp:cNvSpPr/>
      </dsp:nvSpPr>
      <dsp:spPr>
        <a:xfrm>
          <a:off x="1058860" y="827675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&lt;30 wks</a:t>
          </a:r>
        </a:p>
      </dsp:txBody>
      <dsp:txXfrm>
        <a:off x="1058860" y="827675"/>
        <a:ext cx="1163180" cy="581590"/>
      </dsp:txXfrm>
    </dsp:sp>
    <dsp:sp modelId="{69AA0C71-1162-4F86-BDD7-A361804246B2}">
      <dsp:nvSpPr>
        <dsp:cNvPr id="0" name=""/>
        <dsp:cNvSpPr/>
      </dsp:nvSpPr>
      <dsp:spPr>
        <a:xfrm>
          <a:off x="1058860" y="1653533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bCPAP in DR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</a:t>
          </a:r>
        </a:p>
      </dsp:txBody>
      <dsp:txXfrm>
        <a:off x="1058860" y="1653533"/>
        <a:ext cx="1163180" cy="581590"/>
      </dsp:txXfrm>
    </dsp:sp>
    <dsp:sp modelId="{2D0B4369-25A7-4CC0-A231-FD6C16C23C1F}">
      <dsp:nvSpPr>
        <dsp:cNvPr id="0" name=""/>
        <dsp:cNvSpPr/>
      </dsp:nvSpPr>
      <dsp:spPr>
        <a:xfrm>
          <a:off x="355136" y="247939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tubate if meets criteria and give surfactant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</a:t>
          </a:r>
        </a:p>
      </dsp:txBody>
      <dsp:txXfrm>
        <a:off x="355136" y="2479392"/>
        <a:ext cx="1163180" cy="581590"/>
      </dsp:txXfrm>
    </dsp:sp>
    <dsp:sp modelId="{9A32E1B7-5DCB-4DBA-9DC3-26E913BD054E}">
      <dsp:nvSpPr>
        <dsp:cNvPr id="0" name=""/>
        <dsp:cNvSpPr/>
      </dsp:nvSpPr>
      <dsp:spPr>
        <a:xfrm>
          <a:off x="352484" y="3298550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on SIMV/VG, HFOV or Jet if needed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</a:t>
          </a:r>
        </a:p>
      </dsp:txBody>
      <dsp:txXfrm>
        <a:off x="352484" y="3298550"/>
        <a:ext cx="1163180" cy="581590"/>
      </dsp:txXfrm>
    </dsp:sp>
    <dsp:sp modelId="{2BA45C4B-EB5D-4ECB-A1DD-1E21ACDE15B8}">
      <dsp:nvSpPr>
        <dsp:cNvPr id="0" name=""/>
        <dsp:cNvSpPr/>
      </dsp:nvSpPr>
      <dsp:spPr>
        <a:xfrm>
          <a:off x="355136" y="4131108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ysClr val="windowText" lastClr="000000">
              <a:shade val="80000"/>
              <a:hueOff val="0"/>
              <a:satOff val="0"/>
              <a:lum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xtubate to bCPAP when meets criteria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</a:t>
          </a:r>
        </a:p>
      </dsp:txBody>
      <dsp:txXfrm>
        <a:off x="355136" y="4131108"/>
        <a:ext cx="1163180" cy="581590"/>
      </dsp:txXfrm>
    </dsp:sp>
    <dsp:sp modelId="{9D6375D5-4A12-4E0F-A54C-3318F6594B0A}">
      <dsp:nvSpPr>
        <dsp:cNvPr id="0" name=""/>
        <dsp:cNvSpPr/>
      </dsp:nvSpPr>
      <dsp:spPr>
        <a:xfrm>
          <a:off x="631170" y="487303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sp:txBody>
      <dsp:txXfrm>
        <a:off x="631170" y="4873032"/>
        <a:ext cx="1163180" cy="581590"/>
      </dsp:txXfrm>
    </dsp:sp>
    <dsp:sp modelId="{5DE326EE-9851-434C-8EDC-05276E75C0B8}">
      <dsp:nvSpPr>
        <dsp:cNvPr id="0" name=""/>
        <dsp:cNvSpPr/>
      </dsp:nvSpPr>
      <dsp:spPr>
        <a:xfrm>
          <a:off x="1762585" y="247939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ntinue bCPAP</a:t>
          </a:r>
        </a:p>
      </dsp:txBody>
      <dsp:txXfrm>
        <a:off x="1762585" y="2479392"/>
        <a:ext cx="1163180" cy="581590"/>
      </dsp:txXfrm>
    </dsp:sp>
    <dsp:sp modelId="{735D910B-E050-4E92-8E02-BFAD2F2AD77A}">
      <dsp:nvSpPr>
        <dsp:cNvPr id="0" name=""/>
        <dsp:cNvSpPr/>
      </dsp:nvSpPr>
      <dsp:spPr>
        <a:xfrm>
          <a:off x="2027313" y="4868961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sp:txBody>
      <dsp:txXfrm>
        <a:off x="2027313" y="4868961"/>
        <a:ext cx="1163180" cy="581590"/>
      </dsp:txXfrm>
    </dsp:sp>
    <dsp:sp modelId="{4B3901EF-3305-45FA-9275-1CFECD108D4D}">
      <dsp:nvSpPr>
        <dsp:cNvPr id="0" name=""/>
        <dsp:cNvSpPr/>
      </dsp:nvSpPr>
      <dsp:spPr>
        <a:xfrm>
          <a:off x="3934691" y="827675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30+0 - 32+6 wks</a:t>
          </a:r>
        </a:p>
      </dsp:txBody>
      <dsp:txXfrm>
        <a:off x="3934691" y="827675"/>
        <a:ext cx="1163180" cy="581590"/>
      </dsp:txXfrm>
    </dsp:sp>
    <dsp:sp modelId="{537CABBE-B7C2-40B7-A99D-BC27D1511C09}">
      <dsp:nvSpPr>
        <dsp:cNvPr id="0" name=""/>
        <dsp:cNvSpPr/>
      </dsp:nvSpPr>
      <dsp:spPr>
        <a:xfrm>
          <a:off x="3085569" y="1653533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No respiratory distress</a:t>
          </a:r>
        </a:p>
      </dsp:txBody>
      <dsp:txXfrm>
        <a:off x="3085569" y="1653533"/>
        <a:ext cx="1163180" cy="581590"/>
      </dsp:txXfrm>
    </dsp:sp>
    <dsp:sp modelId="{CED15ED1-BE3F-4AB6-93AB-8C698EE46D06}">
      <dsp:nvSpPr>
        <dsp:cNvPr id="0" name=""/>
        <dsp:cNvSpPr/>
      </dsp:nvSpPr>
      <dsp:spPr>
        <a:xfrm>
          <a:off x="3376364" y="247939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ntinue RA</a:t>
          </a:r>
        </a:p>
      </dsp:txBody>
      <dsp:txXfrm>
        <a:off x="3376364" y="2479392"/>
        <a:ext cx="1163180" cy="581590"/>
      </dsp:txXfrm>
    </dsp:sp>
    <dsp:sp modelId="{75159275-F1FF-4249-B1FB-B4E2948EED4B}">
      <dsp:nvSpPr>
        <dsp:cNvPr id="0" name=""/>
        <dsp:cNvSpPr/>
      </dsp:nvSpPr>
      <dsp:spPr>
        <a:xfrm>
          <a:off x="4783813" y="1653533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Any respiratory distress</a:t>
          </a:r>
        </a:p>
      </dsp:txBody>
      <dsp:txXfrm>
        <a:off x="4783813" y="1653533"/>
        <a:ext cx="1163180" cy="581590"/>
      </dsp:txXfrm>
    </dsp:sp>
    <dsp:sp modelId="{62731CA0-C3BB-47B6-A1AC-45EF69306C69}">
      <dsp:nvSpPr>
        <dsp:cNvPr id="0" name=""/>
        <dsp:cNvSpPr/>
      </dsp:nvSpPr>
      <dsp:spPr>
        <a:xfrm>
          <a:off x="4783813" y="247939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tart bCPAP as soon as distress begins</a:t>
          </a:r>
        </a:p>
      </dsp:txBody>
      <dsp:txXfrm>
        <a:off x="4783813" y="2479392"/>
        <a:ext cx="1163180" cy="581590"/>
      </dsp:txXfrm>
    </dsp:sp>
    <dsp:sp modelId="{D1BC1C52-63A7-4755-B5F2-3483E2890746}">
      <dsp:nvSpPr>
        <dsp:cNvPr id="0" name=""/>
        <dsp:cNvSpPr/>
      </dsp:nvSpPr>
      <dsp:spPr>
        <a:xfrm>
          <a:off x="3460828" y="3305250"/>
          <a:ext cx="240170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tubate if subsequently criteria and give surfactant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</a:t>
          </a: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; start on SIMV/VG, HFOV or Jet as needed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</a:t>
          </a:r>
        </a:p>
      </dsp:txBody>
      <dsp:txXfrm>
        <a:off x="3460828" y="3305250"/>
        <a:ext cx="2401700" cy="581590"/>
      </dsp:txXfrm>
    </dsp:sp>
    <dsp:sp modelId="{AF715ACC-4D12-4228-B645-24C45F97D853}">
      <dsp:nvSpPr>
        <dsp:cNvPr id="0" name=""/>
        <dsp:cNvSpPr/>
      </dsp:nvSpPr>
      <dsp:spPr>
        <a:xfrm>
          <a:off x="4080088" y="4131108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xtubate to bCPAP when meets criteria</a:t>
          </a:r>
          <a:r>
            <a:rPr lang="en-US" sz="1200" kern="1200" baseline="300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</a:t>
          </a:r>
        </a:p>
      </dsp:txBody>
      <dsp:txXfrm>
        <a:off x="4080088" y="4131108"/>
        <a:ext cx="1163180" cy="581590"/>
      </dsp:txXfrm>
    </dsp:sp>
    <dsp:sp modelId="{096C6924-E277-4E36-BE1E-21B979E93C0A}">
      <dsp:nvSpPr>
        <dsp:cNvPr id="0" name=""/>
        <dsp:cNvSpPr/>
      </dsp:nvSpPr>
      <dsp:spPr>
        <a:xfrm>
          <a:off x="4356123" y="4873032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sp:txBody>
      <dsp:txXfrm>
        <a:off x="4356123" y="4873032"/>
        <a:ext cx="1163180" cy="581590"/>
      </dsp:txXfrm>
    </dsp:sp>
    <dsp:sp modelId="{78AF51FD-FFC5-44E5-9765-9E2F883ECD56}">
      <dsp:nvSpPr>
        <dsp:cNvPr id="0" name=""/>
        <dsp:cNvSpPr/>
      </dsp:nvSpPr>
      <dsp:spPr>
        <a:xfrm>
          <a:off x="6106797" y="3305250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ntinue bCPAP</a:t>
          </a:r>
        </a:p>
      </dsp:txBody>
      <dsp:txXfrm>
        <a:off x="6106797" y="3305250"/>
        <a:ext cx="1163180" cy="581590"/>
      </dsp:txXfrm>
    </dsp:sp>
    <dsp:sp modelId="{AB299217-BEB7-4637-8492-B505E68ABD2C}">
      <dsp:nvSpPr>
        <dsp:cNvPr id="0" name=""/>
        <dsp:cNvSpPr/>
      </dsp:nvSpPr>
      <dsp:spPr>
        <a:xfrm>
          <a:off x="6406781" y="4878376"/>
          <a:ext cx="1163180" cy="581590"/>
        </a:xfrm>
        <a:prstGeom prst="rect">
          <a:avLst/>
        </a:prstGeom>
        <a:solidFill>
          <a:sysClr val="window" lastClr="FFFFFF">
            <a:hueOff val="0"/>
            <a:satOff val="0"/>
            <a:lumOff val="0"/>
            <a:alphaOff val="0"/>
          </a:sys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rial off bCPAP when meets criteria</a:t>
          </a:r>
        </a:p>
      </dsp:txBody>
      <dsp:txXfrm>
        <a:off x="6406781" y="4878376"/>
        <a:ext cx="1163180" cy="581590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0E7015A-8005-4379-89EA-F8421038CCB3}">
      <dsp:nvSpPr>
        <dsp:cNvPr id="0" name=""/>
        <dsp:cNvSpPr/>
      </dsp:nvSpPr>
      <dsp:spPr>
        <a:xfrm>
          <a:off x="2445" y="5158"/>
          <a:ext cx="2384405" cy="662400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5344" tIns="48768" rIns="85344" bIns="48768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Intubation/Re-intubation Criteria</a:t>
          </a:r>
        </a:p>
      </dsp:txBody>
      <dsp:txXfrm>
        <a:off x="2445" y="5158"/>
        <a:ext cx="2384405" cy="662400"/>
      </dsp:txXfrm>
    </dsp:sp>
    <dsp:sp modelId="{7304EC1B-8DC0-434D-AD14-1652F99002D4}">
      <dsp:nvSpPr>
        <dsp:cNvPr id="0" name=""/>
        <dsp:cNvSpPr/>
      </dsp:nvSpPr>
      <dsp:spPr>
        <a:xfrm>
          <a:off x="2445" y="667558"/>
          <a:ext cx="2384405" cy="3421127"/>
        </a:xfrm>
        <a:prstGeom prst="rect">
          <a:avLst/>
        </a:prstGeom>
        <a:solidFill>
          <a:schemeClr val="lt1">
            <a:alpha val="90000"/>
            <a:tint val="4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008" tIns="64008" rIns="85344" bIns="96012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FiO</a:t>
          </a:r>
          <a:r>
            <a:rPr lang="en-US" sz="1200" kern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≥0.40</a:t>
          </a:r>
          <a:r>
            <a:rPr lang="en-US" sz="1200" kern="1200" baseline="3000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Significant WOB/retractions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Frequent apneic episodes (&gt;6/6 hrs requiring vigorous     stimulation or more than 1 requiring PPV)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Arterial pH &lt;7.20 and PaCO</a:t>
          </a:r>
          <a:r>
            <a:rPr lang="en-US" sz="1200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&gt;65 mmHg on 2 gasses &gt;30 minutes apart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Capillary pH &lt;7.19 and PcCO</a:t>
          </a:r>
          <a:r>
            <a:rPr lang="en-US" sz="1200" kern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&gt;68 mmHg on 2 gasses &gt;30 minutes apart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Venous pH &lt;7.17 and PvCO</a:t>
          </a:r>
          <a:r>
            <a:rPr lang="en-US" sz="1200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2 </a:t>
          </a:r>
          <a:r>
            <a:rPr lang="en-US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&gt;71 mmHg on 2 gasses &gt;30 minutes apart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Refractory metabolic acidosis     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Need for anesthetic or intervention requiring intubation    </a:t>
          </a:r>
        </a:p>
      </dsp:txBody>
      <dsp:txXfrm>
        <a:off x="2445" y="667558"/>
        <a:ext cx="2384405" cy="3421127"/>
      </dsp:txXfrm>
    </dsp:sp>
    <dsp:sp modelId="{7C9C0131-9964-4AF9-A7B6-9BDB59F14E5E}">
      <dsp:nvSpPr>
        <dsp:cNvPr id="0" name=""/>
        <dsp:cNvSpPr/>
      </dsp:nvSpPr>
      <dsp:spPr>
        <a:xfrm>
          <a:off x="2720667" y="5158"/>
          <a:ext cx="2384405" cy="662400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5344" tIns="48768" rIns="85344" bIns="48768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Extubation Criteria</a:t>
          </a:r>
        </a:p>
      </dsp:txBody>
      <dsp:txXfrm>
        <a:off x="2720667" y="5158"/>
        <a:ext cx="2384405" cy="662400"/>
      </dsp:txXfrm>
    </dsp:sp>
    <dsp:sp modelId="{D9466AE1-9A34-4D4E-86FE-C2008CE7AB3B}">
      <dsp:nvSpPr>
        <dsp:cNvPr id="0" name=""/>
        <dsp:cNvSpPr/>
      </dsp:nvSpPr>
      <dsp:spPr>
        <a:xfrm>
          <a:off x="2720667" y="667558"/>
          <a:ext cx="2384405" cy="3421127"/>
        </a:xfrm>
        <a:prstGeom prst="rect">
          <a:avLst/>
        </a:prstGeom>
        <a:solidFill>
          <a:schemeClr val="lt1">
            <a:alpha val="90000"/>
            <a:tint val="4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008" tIns="64008" rIns="85344" bIns="96012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FiO</a:t>
          </a:r>
          <a:r>
            <a:rPr lang="en-US" sz="1200" kern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 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&lt;0.3</a:t>
          </a:r>
          <a:r>
            <a:rPr lang="en-US" sz="1200" kern="1200" baseline="3000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PaCO2 &lt;60 mmHg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Peak inspiratory pressure &lt;20 cmH</a:t>
          </a:r>
          <a:r>
            <a:rPr lang="en-US" sz="1200" kern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O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Ventilator rate &lt;20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Spontaneous breathing over the ventilator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b="0" kern="1200">
              <a:latin typeface="Times New Roman" panose="02020603050405020304" pitchFamily="18" charset="0"/>
              <a:cs typeface="Times New Roman" panose="02020603050405020304" pitchFamily="18" charset="0"/>
            </a:rPr>
            <a:t>Consider extubating to bCPAP 7-9 cmH</a:t>
          </a:r>
          <a:r>
            <a:rPr lang="en-US" sz="1200" b="0" kern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 b="0" kern="1200">
              <a:latin typeface="Times New Roman" panose="02020603050405020304" pitchFamily="18" charset="0"/>
              <a:cs typeface="Times New Roman" panose="02020603050405020304" pitchFamily="18" charset="0"/>
            </a:rPr>
            <a:t>O if prolonged MV, evidence of lung disease, and/or FiO2 ≥0.25</a:t>
          </a:r>
          <a:r>
            <a:rPr lang="en-US" sz="1200" b="0" kern="1200" baseline="3000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r>
            <a:rPr lang="en-US" sz="1200" b="0" kern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b="0" kern="1200">
              <a:latin typeface="Times New Roman" panose="02020603050405020304" pitchFamily="18" charset="0"/>
              <a:cs typeface="Times New Roman" panose="02020603050405020304" pitchFamily="18" charset="0"/>
            </a:rPr>
            <a:t>Caffeine for all infants &lt;1250 gram birth weight and/or per attending discretion</a:t>
          </a:r>
        </a:p>
      </dsp:txBody>
      <dsp:txXfrm>
        <a:off x="2720667" y="667558"/>
        <a:ext cx="2384405" cy="3421127"/>
      </dsp:txXfrm>
    </dsp:sp>
    <dsp:sp modelId="{9EB8A9FC-6EC7-4500-902C-BBBA51763018}">
      <dsp:nvSpPr>
        <dsp:cNvPr id="0" name=""/>
        <dsp:cNvSpPr/>
      </dsp:nvSpPr>
      <dsp:spPr>
        <a:xfrm>
          <a:off x="5438889" y="5158"/>
          <a:ext cx="2384405" cy="662400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5344" tIns="48768" rIns="85344" bIns="48768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Trial off bCPAP Criteria</a:t>
          </a:r>
        </a:p>
      </dsp:txBody>
      <dsp:txXfrm>
        <a:off x="5438889" y="5158"/>
        <a:ext cx="2384405" cy="662400"/>
      </dsp:txXfrm>
    </dsp:sp>
    <dsp:sp modelId="{E46A9C74-F8BF-488C-B7F2-336935415384}">
      <dsp:nvSpPr>
        <dsp:cNvPr id="0" name=""/>
        <dsp:cNvSpPr/>
      </dsp:nvSpPr>
      <dsp:spPr>
        <a:xfrm>
          <a:off x="5438889" y="667558"/>
          <a:ext cx="2384405" cy="3421127"/>
        </a:xfrm>
        <a:prstGeom prst="rect">
          <a:avLst/>
        </a:prstGeom>
        <a:solidFill>
          <a:schemeClr val="lt1">
            <a:alpha val="90000"/>
            <a:tint val="4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008" tIns="64008" rIns="85344" bIns="96012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bCPAP 5 x RA for ≥48 hrs</a:t>
          </a:r>
          <a:r>
            <a:rPr lang="en-US" sz="1200" kern="1200" baseline="3000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No significant retractions/WOB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Infrequent spells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RR &lt;60 for past 24 hours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b="0" kern="1200">
              <a:latin typeface="Times New Roman" panose="02020603050405020304" pitchFamily="18" charset="0"/>
              <a:cs typeface="Times New Roman" panose="02020603050405020304" pitchFamily="18" charset="0"/>
            </a:rPr>
            <a:t>Restart bCPAP 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if RR &gt;70, requires supplemental O</a:t>
          </a:r>
          <a:r>
            <a:rPr lang="en-US" sz="1200" kern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, 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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WOB or 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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spells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Generally should wait 2-5 days between trials off bCPAP.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b="0" kern="1200">
              <a:latin typeface="Times New Roman" panose="02020603050405020304" pitchFamily="18" charset="0"/>
              <a:cs typeface="Times New Roman" panose="02020603050405020304" pitchFamily="18" charset="0"/>
            </a:rPr>
            <a:t>If unable to wean off bCPAP to RA 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and &gt;34 weeks PMA, may consider </a:t>
          </a:r>
          <a:r>
            <a:rPr lang="en-US" sz="1200" u="sng" kern="1200">
              <a:latin typeface="Times New Roman" panose="02020603050405020304" pitchFamily="18" charset="0"/>
              <a:cs typeface="Times New Roman" panose="02020603050405020304" pitchFamily="18" charset="0"/>
            </a:rPr>
            <a:t>continuing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bCPAP (nasal mask or prong or RAM cannula) </a:t>
          </a:r>
          <a:r>
            <a:rPr lang="en-US" sz="1200" i="1" kern="1200">
              <a:latin typeface="Times New Roman" panose="02020603050405020304" pitchFamily="18" charset="0"/>
              <a:cs typeface="Times New Roman" panose="02020603050405020304" pitchFamily="18" charset="0"/>
            </a:rPr>
            <a:t>OR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1200" u="sng" kern="1200">
              <a:latin typeface="Times New Roman" panose="02020603050405020304" pitchFamily="18" charset="0"/>
              <a:cs typeface="Times New Roman" panose="02020603050405020304" pitchFamily="18" charset="0"/>
            </a:rPr>
            <a:t>sprinting 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off bCPAP on either RA or HFNC </a:t>
          </a:r>
          <a:r>
            <a:rPr lang="en-US" sz="1200" i="1" kern="1200">
              <a:latin typeface="Times New Roman" panose="02020603050405020304" pitchFamily="18" charset="0"/>
              <a:cs typeface="Times New Roman" panose="02020603050405020304" pitchFamily="18" charset="0"/>
            </a:rPr>
            <a:t>OR </a:t>
          </a:r>
          <a:r>
            <a:rPr lang="en-US" sz="1200" u="sng" kern="1200">
              <a:latin typeface="Times New Roman" panose="02020603050405020304" pitchFamily="18" charset="0"/>
              <a:cs typeface="Times New Roman" panose="02020603050405020304" pitchFamily="18" charset="0"/>
            </a:rPr>
            <a:t>weaning </a:t>
          </a: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to HFNC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>
              <a:latin typeface="Times New Roman" panose="02020603050405020304" pitchFamily="18" charset="0"/>
              <a:cs typeface="Times New Roman" panose="02020603050405020304" pitchFamily="18" charset="0"/>
            </a:rPr>
            <a:t>bCPAP may be used to re-recruit lung volumes in infants on RA or NC, as needed.</a:t>
          </a:r>
        </a:p>
      </dsp:txBody>
      <dsp:txXfrm>
        <a:off x="5438889" y="667558"/>
        <a:ext cx="2384405" cy="342112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hList1">
  <dgm:title val=""/>
  <dgm:desc val=""/>
  <dgm:catLst>
    <dgm:cat type="list" pri="5000"/>
    <dgm:cat type="convert" pri="5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>
          <dgm:prSet phldr="1"/>
        </dgm:pt>
        <dgm:pt modelId="2">
          <dgm:prSet phldr="1"/>
        </dgm:pt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w" for="des" forName="parTx"/>
      <dgm:constr type="h" for="des" forName="parTx" op="equ"/>
      <dgm:constr type="w" for="des" forName="desTx"/>
      <dgm:constr type="h" for="des" forName="desTx" op="equ"/>
      <dgm:constr type="primFontSz" for="des" forName="parTx" val="65"/>
      <dgm:constr type="secFontSz" for="des" forName="desTx" refType="primFontSz" refFor="des" refForName="parTx" op="equ"/>
      <dgm:constr type="h" for="des" forName="parTx" refType="primFontSz" refFor="des" refForName="parTx" fact="0.8"/>
      <dgm:constr type="h" for="des" forName="desTx" refType="primFontSz" refFor="des" refForName="parTx" fact="1.22"/>
      <dgm:constr type="w" for="ch" forName="space" refType="w" refFor="ch" refForName="composite" op="equ" fact="0.14"/>
    </dgm:constrLst>
    <dgm:ruleLst>
      <dgm:rule type="w" for="ch" forName="composite" val="0" fact="NaN" max="NaN"/>
      <dgm:rule type="primFontSz" for="des" forName="parTx" val="5" fact="NaN" max="NaN"/>
    </dgm:ruleLst>
    <dgm:forEach name="Name4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onstrLst>
          <dgm:constr type="l" for="ch" forName="parTx"/>
          <dgm:constr type="w" for="ch" forName="parTx" refType="w"/>
          <dgm:constr type="t" for="ch" forName="parTx"/>
          <dgm:constr type="l" for="ch" forName="desTx"/>
          <dgm:constr type="w" for="ch" forName="desTx" refType="w" refFor="ch" refForName="parTx"/>
          <dgm:constr type="t" for="ch" forName="desTx" refType="h" refFor="ch" refForName="parTx"/>
        </dgm:constrLst>
        <dgm:ruleLst>
          <dgm:rule type="h" val="INF" fact="NaN" max="NaN"/>
        </dgm:ruleLst>
        <dgm:layoutNode name="parTx" styleLbl="alignNode1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>
            <dgm:adjLst/>
          </dgm:shape>
          <dgm:presOf axis="self" ptType="node"/>
          <dgm:constrLst>
            <dgm:constr type="h" refType="w" op="lte" fact="0.4"/>
            <dgm:constr type="h"/>
            <dgm:constr type="tMarg" refType="primFontSz" fact="0.32"/>
            <dgm:constr type="bMarg" refType="primFontSz" fact="0.32"/>
          </dgm:constrLst>
          <dgm:ruleLst>
            <dgm:rule type="h" val="INF" fact="NaN" max="NaN"/>
          </dgm:ruleLst>
        </dgm:layoutNode>
        <dgm:layoutNode name="desTx" styleLbl="alignAccFollowNode1">
          <dgm:varLst>
            <dgm:bulletEnabled val="1"/>
          </dgm:varLst>
          <dgm:alg type="tx">
            <dgm:param type="stBulletLvl" val="1"/>
          </dgm:alg>
          <dgm:shape xmlns:r="http://schemas.openxmlformats.org/officeDocument/2006/relationships" type="rect" r:blip="">
            <dgm:adjLst/>
          </dgm:shape>
          <dgm:presOf axis="des" ptType="node"/>
          <dgm:constrLst>
            <dgm:constr type="secFontSz" val="65"/>
            <dgm:constr type="primFontSz" refType="secFontSz"/>
            <dgm:constr type="h"/>
            <dgm:constr type="lMarg" refType="primFontSz" fact="0.42"/>
            <dgm:constr type="tMarg" refType="primFontSz" fact="0.42"/>
            <dgm:constr type="bMarg" refType="primFontSz" fact="0.63"/>
          </dgm:constrLst>
          <dgm:ruleLst>
            <dgm:rule type="h" val="INF" fact="NaN" max="NaN"/>
          </dgm:ruleLst>
        </dgm:layoutNode>
      </dgm:layoutNode>
      <dgm:forEach name="Name5" axis="followSib" ptType="sibTrans" cnt="1">
        <dgm:layoutNode name="space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053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595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102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911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858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624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769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676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341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069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55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EE9E0-847C-43AB-8EAD-B9E2973EAAEB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1AC338-34FF-4EB3-A8E0-826A4250B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334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3.xml"/><Relationship Id="rId2" Type="http://schemas.openxmlformats.org/officeDocument/2006/relationships/diagramData" Target="../diagrams/data3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3.xml"/><Relationship Id="rId5" Type="http://schemas.openxmlformats.org/officeDocument/2006/relationships/diagramColors" Target="../diagrams/colors3.xml"/><Relationship Id="rId4" Type="http://schemas.openxmlformats.org/officeDocument/2006/relationships/diagramQuickStyle" Target="../diagrams/quickStyl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/>
          <p:nvPr/>
        </p:nvGraphicFramePr>
        <p:xfrm>
          <a:off x="1816735" y="579120"/>
          <a:ext cx="8558530" cy="569976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75503" y="181232"/>
            <a:ext cx="5585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1A, SDC: Management of infants requiring resuscitation in delivery room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74798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75503" y="181232"/>
            <a:ext cx="5585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1B, SDC: Management of vigorous infants in delivery room </a:t>
            </a:r>
            <a:endParaRPr lang="en-US" sz="1200" dirty="0"/>
          </a:p>
        </p:txBody>
      </p:sp>
      <p:graphicFrame>
        <p:nvGraphicFramePr>
          <p:cNvPr id="9" name="Diagram 8"/>
          <p:cNvGraphicFramePr/>
          <p:nvPr/>
        </p:nvGraphicFramePr>
        <p:xfrm>
          <a:off x="2138045" y="658813"/>
          <a:ext cx="7915910" cy="554037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735855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Diagram 8"/>
          <p:cNvGraphicFramePr/>
          <p:nvPr>
            <p:extLst>
              <p:ext uri="{D42A27DB-BD31-4B8C-83A1-F6EECF244321}">
                <p14:modId xmlns:p14="http://schemas.microsoft.com/office/powerpoint/2010/main" val="654230506"/>
              </p:ext>
            </p:extLst>
          </p:nvPr>
        </p:nvGraphicFramePr>
        <p:xfrm>
          <a:off x="1985319" y="1631092"/>
          <a:ext cx="7825740" cy="409384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0" name="Rectangle 3"/>
          <p:cNvSpPr>
            <a:spLocks noChangeArrowheads="1"/>
          </p:cNvSpPr>
          <p:nvPr/>
        </p:nvSpPr>
        <p:spPr bwMode="auto">
          <a:xfrm>
            <a:off x="0" y="45624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675503" y="181232"/>
            <a:ext cx="5585254" cy="280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C, SDC: Criteria for intubation, </a:t>
            </a:r>
            <a:r>
              <a:rPr lang="en-US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tubation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trial off CPAP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0549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81</Words>
  <Application>Microsoft Office PowerPoint</Application>
  <PresentationFormat>Widescreen</PresentationFormat>
  <Paragraphs>6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</vt:vector>
  </TitlesOfParts>
  <Company>Boston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 SDC</dc:title>
  <dc:creator>Levesque, Bernadette</dc:creator>
  <cp:lastModifiedBy>Levesque, Bernadette</cp:lastModifiedBy>
  <cp:revision>2</cp:revision>
  <dcterms:created xsi:type="dcterms:W3CDTF">2019-05-07T19:47:40Z</dcterms:created>
  <dcterms:modified xsi:type="dcterms:W3CDTF">2019-05-20T18:43:24Z</dcterms:modified>
</cp:coreProperties>
</file>